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en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2BC4D2E-3AF4-4D40-BAC4-33ECAC74BCBD}" v="116" dt="2025-09-24T12:31:09.9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90" autoAdjust="0"/>
    <p:restoredTop sz="94643"/>
  </p:normalViewPr>
  <p:slideViewPr>
    <p:cSldViewPr snapToGrid="0">
      <p:cViewPr varScale="1">
        <p:scale>
          <a:sx n="110" d="100"/>
          <a:sy n="110" d="100"/>
        </p:scale>
        <p:origin x="56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olmberg Schiavone, Lovisa" userId="bbe6b084-409e-4123-bcbd-da2be00cbc6b" providerId="ADAL" clId="{F2BC4D2E-3AF4-4D40-BAC4-33ECAC74BCBD}"/>
    <pc:docChg chg="custSel addSld modSld">
      <pc:chgData name="Holmberg Schiavone, Lovisa" userId="bbe6b084-409e-4123-bcbd-da2be00cbc6b" providerId="ADAL" clId="{F2BC4D2E-3AF4-4D40-BAC4-33ECAC74BCBD}" dt="2025-09-24T12:40:31.225" v="284" actId="478"/>
      <pc:docMkLst>
        <pc:docMk/>
      </pc:docMkLst>
      <pc:sldChg chg="addSp delSp modSp mod">
        <pc:chgData name="Holmberg Schiavone, Lovisa" userId="bbe6b084-409e-4123-bcbd-da2be00cbc6b" providerId="ADAL" clId="{F2BC4D2E-3AF4-4D40-BAC4-33ECAC74BCBD}" dt="2025-09-24T12:31:23.985" v="282" actId="1076"/>
        <pc:sldMkLst>
          <pc:docMk/>
          <pc:sldMk cId="441283792" sldId="256"/>
        </pc:sldMkLst>
        <pc:spChg chg="del">
          <ac:chgData name="Holmberg Schiavone, Lovisa" userId="bbe6b084-409e-4123-bcbd-da2be00cbc6b" providerId="ADAL" clId="{F2BC4D2E-3AF4-4D40-BAC4-33ECAC74BCBD}" dt="2025-09-24T09:35:19.546" v="0" actId="478"/>
          <ac:spMkLst>
            <pc:docMk/>
            <pc:sldMk cId="441283792" sldId="256"/>
            <ac:spMk id="2" creationId="{08EFDC22-EB9A-3BD0-241A-DBC986A7AF90}"/>
          </ac:spMkLst>
        </pc:spChg>
        <pc:spChg chg="del">
          <ac:chgData name="Holmberg Schiavone, Lovisa" userId="bbe6b084-409e-4123-bcbd-da2be00cbc6b" providerId="ADAL" clId="{F2BC4D2E-3AF4-4D40-BAC4-33ECAC74BCBD}" dt="2025-09-24T09:35:21.090" v="1" actId="478"/>
          <ac:spMkLst>
            <pc:docMk/>
            <pc:sldMk cId="441283792" sldId="256"/>
            <ac:spMk id="3" creationId="{40A42E10-576F-085B-2644-DED618385EF8}"/>
          </ac:spMkLst>
        </pc:spChg>
        <pc:spChg chg="mod">
          <ac:chgData name="Holmberg Schiavone, Lovisa" userId="bbe6b084-409e-4123-bcbd-da2be00cbc6b" providerId="ADAL" clId="{F2BC4D2E-3AF4-4D40-BAC4-33ECAC74BCBD}" dt="2025-09-24T09:35:50.985" v="7"/>
          <ac:spMkLst>
            <pc:docMk/>
            <pc:sldMk cId="441283792" sldId="256"/>
            <ac:spMk id="9" creationId="{743D1229-BD26-08C6-A81B-230471137354}"/>
          </ac:spMkLst>
        </pc:spChg>
        <pc:spChg chg="mod">
          <ac:chgData name="Holmberg Schiavone, Lovisa" userId="bbe6b084-409e-4123-bcbd-da2be00cbc6b" providerId="ADAL" clId="{F2BC4D2E-3AF4-4D40-BAC4-33ECAC74BCBD}" dt="2025-09-24T09:35:50.985" v="7"/>
          <ac:spMkLst>
            <pc:docMk/>
            <pc:sldMk cId="441283792" sldId="256"/>
            <ac:spMk id="12" creationId="{14A72CB2-AEEF-BB34-82FC-1D3B6964167F}"/>
          </ac:spMkLst>
        </pc:spChg>
        <pc:spChg chg="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21" creationId="{B36BAC68-7D4A-1FC5-E775-079A74FC8698}"/>
          </ac:spMkLst>
        </pc:spChg>
        <pc:spChg chg="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24" creationId="{C466D743-2412-CB2C-0633-8D1B4993CD5C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58" creationId="{DA516128-457B-CEC0-6104-FD691E08CA15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60" creationId="{D6AC0E7D-C03F-905B-305C-A47A986D59F9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61" creationId="{6F01C05C-E0C3-5A79-4E8E-0472FDD6101C}"/>
          </ac:spMkLst>
        </pc:spChg>
        <pc:spChg chg="mod">
          <ac:chgData name="Holmberg Schiavone, Lovisa" userId="bbe6b084-409e-4123-bcbd-da2be00cbc6b" providerId="ADAL" clId="{F2BC4D2E-3AF4-4D40-BAC4-33ECAC74BCBD}" dt="2025-09-24T09:39:38.449" v="14" actId="1076"/>
          <ac:spMkLst>
            <pc:docMk/>
            <pc:sldMk cId="441283792" sldId="256"/>
            <ac:spMk id="62" creationId="{8936B581-B247-41B2-7618-A22A62679F6A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63" creationId="{9FF2F91E-7CE9-3BC1-F3E9-5CDFE893CBE9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64" creationId="{956BC19B-DA2F-6B56-8A9B-64388B806AD4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65" creationId="{3280F45F-7DB5-0CA3-3001-3B9E1A6F3F34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67" creationId="{1E316829-8DE3-3942-0E92-131BF5728010}"/>
          </ac:spMkLst>
        </pc:spChg>
        <pc:spChg chg="add mod">
          <ac:chgData name="Holmberg Schiavone, Lovisa" userId="bbe6b084-409e-4123-bcbd-da2be00cbc6b" providerId="ADAL" clId="{F2BC4D2E-3AF4-4D40-BAC4-33ECAC74BCBD}" dt="2025-09-24T09:37:09.680" v="9"/>
          <ac:spMkLst>
            <pc:docMk/>
            <pc:sldMk cId="441283792" sldId="256"/>
            <ac:spMk id="68" creationId="{8AE53682-D980-C23F-25C0-B33415A6E24B}"/>
          </ac:spMkLst>
        </pc:spChg>
        <pc:spChg chg="add mod">
          <ac:chgData name="Holmberg Schiavone, Lovisa" userId="bbe6b084-409e-4123-bcbd-da2be00cbc6b" providerId="ADAL" clId="{F2BC4D2E-3AF4-4D40-BAC4-33ECAC74BCBD}" dt="2025-09-24T09:41:32.691" v="61" actId="20577"/>
          <ac:spMkLst>
            <pc:docMk/>
            <pc:sldMk cId="441283792" sldId="256"/>
            <ac:spMk id="70" creationId="{D14495A8-CBF2-339B-68A8-972C52F100CE}"/>
          </ac:spMkLst>
        </pc:spChg>
        <pc:grpChg chg="del">
          <ac:chgData name="Holmberg Schiavone, Lovisa" userId="bbe6b084-409e-4123-bcbd-da2be00cbc6b" providerId="ADAL" clId="{F2BC4D2E-3AF4-4D40-BAC4-33ECAC74BCBD}" dt="2025-09-24T09:36:12.201" v="8" actId="478"/>
          <ac:grpSpMkLst>
            <pc:docMk/>
            <pc:sldMk cId="441283792" sldId="256"/>
            <ac:grpSpMk id="4" creationId="{E8586812-3A9B-D908-C572-D0EB38BC7EAD}"/>
          </ac:grpSpMkLst>
        </pc:grpChg>
        <pc:grpChg chg="del">
          <ac:chgData name="Holmberg Schiavone, Lovisa" userId="bbe6b084-409e-4123-bcbd-da2be00cbc6b" providerId="ADAL" clId="{F2BC4D2E-3AF4-4D40-BAC4-33ECAC74BCBD}" dt="2025-09-24T09:36:12.201" v="8" actId="478"/>
          <ac:grpSpMkLst>
            <pc:docMk/>
            <pc:sldMk cId="441283792" sldId="256"/>
            <ac:grpSpMk id="10" creationId="{23E7A63C-4425-0C5F-A349-77EB343C044B}"/>
          </ac:grpSpMkLst>
        </pc:grp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5" creationId="{F51E8AA2-E07C-5175-7651-3FB0AAA65BAE}"/>
          </ac:picMkLst>
        </pc:pic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6" creationId="{C7F037FD-08D6-7DE2-8019-BCF829EBB3D8}"/>
          </ac:picMkLst>
        </pc:pic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7" creationId="{7778F78C-E5B4-ADBD-8215-108283C1D1A6}"/>
          </ac:picMkLst>
        </pc:pic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8" creationId="{D784D1BF-E3A0-7204-363F-558D5E833B10}"/>
          </ac:picMkLst>
        </pc:pic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11" creationId="{302F6772-C51F-57B8-CF63-AB5FD4F19424}"/>
          </ac:picMkLst>
        </pc:pic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13" creationId="{DBE9E2B1-8CEA-4070-62F7-E4504997BDC7}"/>
          </ac:picMkLst>
        </pc:pic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14" creationId="{0D723DD2-FAF5-096E-266D-F7C050AB287D}"/>
          </ac:picMkLst>
        </pc:picChg>
        <pc:picChg chg="mod">
          <ac:chgData name="Holmberg Schiavone, Lovisa" userId="bbe6b084-409e-4123-bcbd-da2be00cbc6b" providerId="ADAL" clId="{F2BC4D2E-3AF4-4D40-BAC4-33ECAC74BCBD}" dt="2025-09-24T09:35:50.985" v="7"/>
          <ac:picMkLst>
            <pc:docMk/>
            <pc:sldMk cId="441283792" sldId="256"/>
            <ac:picMk id="15" creationId="{755F6445-EBF1-A16C-D83B-386368ED303A}"/>
          </ac:picMkLst>
        </pc:picChg>
        <pc:cxnChg chg="add mod">
          <ac:chgData name="Holmberg Schiavone, Lovisa" userId="bbe6b084-409e-4123-bcbd-da2be00cbc6b" providerId="ADAL" clId="{F2BC4D2E-3AF4-4D40-BAC4-33ECAC74BCBD}" dt="2025-09-24T09:42:20.994" v="72" actId="1076"/>
          <ac:cxnSpMkLst>
            <pc:docMk/>
            <pc:sldMk cId="441283792" sldId="256"/>
            <ac:cxnSpMk id="71" creationId="{1DFDC202-FDE9-FB3C-E1B3-B042DA667E5D}"/>
          </ac:cxnSpMkLst>
        </pc:cxnChg>
        <pc:cxnChg chg="add mod">
          <ac:chgData name="Holmberg Schiavone, Lovisa" userId="bbe6b084-409e-4123-bcbd-da2be00cbc6b" providerId="ADAL" clId="{F2BC4D2E-3AF4-4D40-BAC4-33ECAC74BCBD}" dt="2025-09-24T09:42:42.466" v="74" actId="1076"/>
          <ac:cxnSpMkLst>
            <pc:docMk/>
            <pc:sldMk cId="441283792" sldId="256"/>
            <ac:cxnSpMk id="72" creationId="{E1D6AE58-5A7A-3F89-B347-954ED292B201}"/>
          </ac:cxnSpMkLst>
        </pc:cxnChg>
        <pc:cxnChg chg="add mod">
          <ac:chgData name="Holmberg Schiavone, Lovisa" userId="bbe6b084-409e-4123-bcbd-da2be00cbc6b" providerId="ADAL" clId="{F2BC4D2E-3AF4-4D40-BAC4-33ECAC74BCBD}" dt="2025-09-24T09:42:54.065" v="76" actId="1076"/>
          <ac:cxnSpMkLst>
            <pc:docMk/>
            <pc:sldMk cId="441283792" sldId="256"/>
            <ac:cxnSpMk id="73" creationId="{EEBEF523-29DC-C306-21CD-16AC3F8670E8}"/>
          </ac:cxnSpMkLst>
        </pc:cxnChg>
        <pc:cxnChg chg="add mod">
          <ac:chgData name="Holmberg Schiavone, Lovisa" userId="bbe6b084-409e-4123-bcbd-da2be00cbc6b" providerId="ADAL" clId="{F2BC4D2E-3AF4-4D40-BAC4-33ECAC74BCBD}" dt="2025-09-24T09:43:08.052" v="78" actId="1076"/>
          <ac:cxnSpMkLst>
            <pc:docMk/>
            <pc:sldMk cId="441283792" sldId="256"/>
            <ac:cxnSpMk id="74" creationId="{F737484C-D982-620A-2CDC-01E377A93B90}"/>
          </ac:cxnSpMkLst>
        </pc:cxnChg>
        <pc:cxnChg chg="add mod">
          <ac:chgData name="Holmberg Schiavone, Lovisa" userId="bbe6b084-409e-4123-bcbd-da2be00cbc6b" providerId="ADAL" clId="{F2BC4D2E-3AF4-4D40-BAC4-33ECAC74BCBD}" dt="2025-09-24T09:43:26.618" v="80" actId="1076"/>
          <ac:cxnSpMkLst>
            <pc:docMk/>
            <pc:sldMk cId="441283792" sldId="256"/>
            <ac:cxnSpMk id="75" creationId="{1FA0F061-D910-09A6-DC87-8C588E981722}"/>
          </ac:cxnSpMkLst>
        </pc:cxnChg>
        <pc:cxnChg chg="add mod">
          <ac:chgData name="Holmberg Schiavone, Lovisa" userId="bbe6b084-409e-4123-bcbd-da2be00cbc6b" providerId="ADAL" clId="{F2BC4D2E-3AF4-4D40-BAC4-33ECAC74BCBD}" dt="2025-09-24T09:43:40.483" v="82" actId="1076"/>
          <ac:cxnSpMkLst>
            <pc:docMk/>
            <pc:sldMk cId="441283792" sldId="256"/>
            <ac:cxnSpMk id="76" creationId="{6F40F87C-ACD4-E632-255D-850E8F3C8803}"/>
          </ac:cxnSpMkLst>
        </pc:cxnChg>
        <pc:cxnChg chg="add mod">
          <ac:chgData name="Holmberg Schiavone, Lovisa" userId="bbe6b084-409e-4123-bcbd-da2be00cbc6b" providerId="ADAL" clId="{F2BC4D2E-3AF4-4D40-BAC4-33ECAC74BCBD}" dt="2025-09-24T09:43:52.508" v="84" actId="1076"/>
          <ac:cxnSpMkLst>
            <pc:docMk/>
            <pc:sldMk cId="441283792" sldId="256"/>
            <ac:cxnSpMk id="77" creationId="{23030628-0070-9941-63EF-195502AB239B}"/>
          </ac:cxnSpMkLst>
        </pc:cxnChg>
        <pc:cxnChg chg="add mod">
          <ac:chgData name="Holmberg Schiavone, Lovisa" userId="bbe6b084-409e-4123-bcbd-da2be00cbc6b" providerId="ADAL" clId="{F2BC4D2E-3AF4-4D40-BAC4-33ECAC74BCBD}" dt="2025-09-24T09:44:06.786" v="86" actId="1076"/>
          <ac:cxnSpMkLst>
            <pc:docMk/>
            <pc:sldMk cId="441283792" sldId="256"/>
            <ac:cxnSpMk id="78" creationId="{66D6CE52-0658-C28D-72A6-854C466BFAB0}"/>
          </ac:cxnSpMkLst>
        </pc:cxnChg>
        <pc:cxnChg chg="add mod">
          <ac:chgData name="Holmberg Schiavone, Lovisa" userId="bbe6b084-409e-4123-bcbd-da2be00cbc6b" providerId="ADAL" clId="{F2BC4D2E-3AF4-4D40-BAC4-33ECAC74BCBD}" dt="2025-09-24T09:44:23.170" v="88" actId="1076"/>
          <ac:cxnSpMkLst>
            <pc:docMk/>
            <pc:sldMk cId="441283792" sldId="256"/>
            <ac:cxnSpMk id="79" creationId="{BD9A741F-C438-1B73-25C4-4A1CA1509F76}"/>
          </ac:cxnSpMkLst>
        </pc:cxnChg>
        <pc:cxnChg chg="add mod">
          <ac:chgData name="Holmberg Schiavone, Lovisa" userId="bbe6b084-409e-4123-bcbd-da2be00cbc6b" providerId="ADAL" clId="{F2BC4D2E-3AF4-4D40-BAC4-33ECAC74BCBD}" dt="2025-09-24T09:44:44.642" v="91" actId="1076"/>
          <ac:cxnSpMkLst>
            <pc:docMk/>
            <pc:sldMk cId="441283792" sldId="256"/>
            <ac:cxnSpMk id="80" creationId="{1A474B8B-2E5E-5F1A-965C-FB0360972344}"/>
          </ac:cxnSpMkLst>
        </pc:cxnChg>
        <pc:cxnChg chg="add mod">
          <ac:chgData name="Holmberg Schiavone, Lovisa" userId="bbe6b084-409e-4123-bcbd-da2be00cbc6b" providerId="ADAL" clId="{F2BC4D2E-3AF4-4D40-BAC4-33ECAC74BCBD}" dt="2025-09-24T09:45:07.468" v="93" actId="1076"/>
          <ac:cxnSpMkLst>
            <pc:docMk/>
            <pc:sldMk cId="441283792" sldId="256"/>
            <ac:cxnSpMk id="81" creationId="{8BEF41EB-A311-DE89-35A3-10C373550FF2}"/>
          </ac:cxnSpMkLst>
        </pc:cxnChg>
        <pc:cxnChg chg="add mod">
          <ac:chgData name="Holmberg Schiavone, Lovisa" userId="bbe6b084-409e-4123-bcbd-da2be00cbc6b" providerId="ADAL" clId="{F2BC4D2E-3AF4-4D40-BAC4-33ECAC74BCBD}" dt="2025-09-24T09:45:22.362" v="95" actId="1076"/>
          <ac:cxnSpMkLst>
            <pc:docMk/>
            <pc:sldMk cId="441283792" sldId="256"/>
            <ac:cxnSpMk id="82" creationId="{5BA6C25D-56A3-D1ED-0189-B82F251A399D}"/>
          </ac:cxnSpMkLst>
        </pc:cxnChg>
        <pc:cxnChg chg="add mod">
          <ac:chgData name="Holmberg Schiavone, Lovisa" userId="bbe6b084-409e-4123-bcbd-da2be00cbc6b" providerId="ADAL" clId="{F2BC4D2E-3AF4-4D40-BAC4-33ECAC74BCBD}" dt="2025-09-24T09:45:44.315" v="97" actId="1076"/>
          <ac:cxnSpMkLst>
            <pc:docMk/>
            <pc:sldMk cId="441283792" sldId="256"/>
            <ac:cxnSpMk id="83" creationId="{071EAA8A-7A10-EC99-1BA4-54C113AC85A8}"/>
          </ac:cxnSpMkLst>
        </pc:cxnChg>
        <pc:cxnChg chg="add mod">
          <ac:chgData name="Holmberg Schiavone, Lovisa" userId="bbe6b084-409e-4123-bcbd-da2be00cbc6b" providerId="ADAL" clId="{F2BC4D2E-3AF4-4D40-BAC4-33ECAC74BCBD}" dt="2025-09-24T09:46:05.276" v="99" actId="1076"/>
          <ac:cxnSpMkLst>
            <pc:docMk/>
            <pc:sldMk cId="441283792" sldId="256"/>
            <ac:cxnSpMk id="84" creationId="{2939D161-DA04-B538-3609-B9960861FF40}"/>
          </ac:cxnSpMkLst>
        </pc:cxnChg>
        <pc:cxnChg chg="add mod">
          <ac:chgData name="Holmberg Schiavone, Lovisa" userId="bbe6b084-409e-4123-bcbd-da2be00cbc6b" providerId="ADAL" clId="{F2BC4D2E-3AF4-4D40-BAC4-33ECAC74BCBD}" dt="2025-09-24T09:46:47.058" v="104" actId="1076"/>
          <ac:cxnSpMkLst>
            <pc:docMk/>
            <pc:sldMk cId="441283792" sldId="256"/>
            <ac:cxnSpMk id="85" creationId="{E1D68762-9D01-1E37-2E8F-F295234A84F4}"/>
          </ac:cxnSpMkLst>
        </pc:cxnChg>
        <pc:cxnChg chg="add mod">
          <ac:chgData name="Holmberg Schiavone, Lovisa" userId="bbe6b084-409e-4123-bcbd-da2be00cbc6b" providerId="ADAL" clId="{F2BC4D2E-3AF4-4D40-BAC4-33ECAC74BCBD}" dt="2025-09-24T09:46:44.605" v="103" actId="1076"/>
          <ac:cxnSpMkLst>
            <pc:docMk/>
            <pc:sldMk cId="441283792" sldId="256"/>
            <ac:cxnSpMk id="86" creationId="{42AA6E7F-E0FD-C7DE-DCED-EBF8A332AAE2}"/>
          </ac:cxnSpMkLst>
        </pc:cxnChg>
        <pc:cxnChg chg="add mod">
          <ac:chgData name="Holmberg Schiavone, Lovisa" userId="bbe6b084-409e-4123-bcbd-da2be00cbc6b" providerId="ADAL" clId="{F2BC4D2E-3AF4-4D40-BAC4-33ECAC74BCBD}" dt="2025-09-24T09:47:00.172" v="106" actId="1076"/>
          <ac:cxnSpMkLst>
            <pc:docMk/>
            <pc:sldMk cId="441283792" sldId="256"/>
            <ac:cxnSpMk id="87" creationId="{16886ADB-2B61-7246-9231-094C11AB25E5}"/>
          </ac:cxnSpMkLst>
        </pc:cxnChg>
        <pc:cxnChg chg="add mod">
          <ac:chgData name="Holmberg Schiavone, Lovisa" userId="bbe6b084-409e-4123-bcbd-da2be00cbc6b" providerId="ADAL" clId="{F2BC4D2E-3AF4-4D40-BAC4-33ECAC74BCBD}" dt="2025-09-24T09:47:13.587" v="108" actId="1076"/>
          <ac:cxnSpMkLst>
            <pc:docMk/>
            <pc:sldMk cId="441283792" sldId="256"/>
            <ac:cxnSpMk id="88" creationId="{F8CE4D48-83B2-84B8-3E29-D9895C20D559}"/>
          </ac:cxnSpMkLst>
        </pc:cxnChg>
        <pc:cxnChg chg="add mod">
          <ac:chgData name="Holmberg Schiavone, Lovisa" userId="bbe6b084-409e-4123-bcbd-da2be00cbc6b" providerId="ADAL" clId="{F2BC4D2E-3AF4-4D40-BAC4-33ECAC74BCBD}" dt="2025-09-24T09:47:26.942" v="110" actId="1076"/>
          <ac:cxnSpMkLst>
            <pc:docMk/>
            <pc:sldMk cId="441283792" sldId="256"/>
            <ac:cxnSpMk id="89" creationId="{A7FF81D1-DC12-75C3-A183-1141D2C0EBE1}"/>
          </ac:cxnSpMkLst>
        </pc:cxnChg>
        <pc:cxnChg chg="add mod">
          <ac:chgData name="Holmberg Schiavone, Lovisa" userId="bbe6b084-409e-4123-bcbd-da2be00cbc6b" providerId="ADAL" clId="{F2BC4D2E-3AF4-4D40-BAC4-33ECAC74BCBD}" dt="2025-09-24T09:47:39.989" v="112" actId="1076"/>
          <ac:cxnSpMkLst>
            <pc:docMk/>
            <pc:sldMk cId="441283792" sldId="256"/>
            <ac:cxnSpMk id="90" creationId="{32B80390-BF90-6551-9D69-E37FE5AB1CA2}"/>
          </ac:cxnSpMkLst>
        </pc:cxnChg>
        <pc:cxnChg chg="add mod">
          <ac:chgData name="Holmberg Schiavone, Lovisa" userId="bbe6b084-409e-4123-bcbd-da2be00cbc6b" providerId="ADAL" clId="{F2BC4D2E-3AF4-4D40-BAC4-33ECAC74BCBD}" dt="2025-09-24T09:47:59.306" v="114" actId="1076"/>
          <ac:cxnSpMkLst>
            <pc:docMk/>
            <pc:sldMk cId="441283792" sldId="256"/>
            <ac:cxnSpMk id="91" creationId="{8C649278-9E7E-184D-BF60-1131CFA040A4}"/>
          </ac:cxnSpMkLst>
        </pc:cxnChg>
        <pc:cxnChg chg="add mod">
          <ac:chgData name="Holmberg Schiavone, Lovisa" userId="bbe6b084-409e-4123-bcbd-da2be00cbc6b" providerId="ADAL" clId="{F2BC4D2E-3AF4-4D40-BAC4-33ECAC74BCBD}" dt="2025-09-24T09:48:20.595" v="116" actId="1076"/>
          <ac:cxnSpMkLst>
            <pc:docMk/>
            <pc:sldMk cId="441283792" sldId="256"/>
            <ac:cxnSpMk id="92" creationId="{B7A371B5-94D2-902D-0EBE-FB604FDAC73E}"/>
          </ac:cxnSpMkLst>
        </pc:cxnChg>
        <pc:cxnChg chg="add mod">
          <ac:chgData name="Holmberg Schiavone, Lovisa" userId="bbe6b084-409e-4123-bcbd-da2be00cbc6b" providerId="ADAL" clId="{F2BC4D2E-3AF4-4D40-BAC4-33ECAC74BCBD}" dt="2025-09-24T09:48:32.778" v="118" actId="1076"/>
          <ac:cxnSpMkLst>
            <pc:docMk/>
            <pc:sldMk cId="441283792" sldId="256"/>
            <ac:cxnSpMk id="93" creationId="{BBCFB111-6465-7681-65B7-3B1BB03F2182}"/>
          </ac:cxnSpMkLst>
        </pc:cxnChg>
        <pc:cxnChg chg="add mod">
          <ac:chgData name="Holmberg Schiavone, Lovisa" userId="bbe6b084-409e-4123-bcbd-da2be00cbc6b" providerId="ADAL" clId="{F2BC4D2E-3AF4-4D40-BAC4-33ECAC74BCBD}" dt="2025-09-24T09:48:50.100" v="120" actId="1076"/>
          <ac:cxnSpMkLst>
            <pc:docMk/>
            <pc:sldMk cId="441283792" sldId="256"/>
            <ac:cxnSpMk id="94" creationId="{8B2C4240-C14A-C665-5856-1D268804EDC3}"/>
          </ac:cxnSpMkLst>
        </pc:cxnChg>
        <pc:cxnChg chg="add mod">
          <ac:chgData name="Holmberg Schiavone, Lovisa" userId="bbe6b084-409e-4123-bcbd-da2be00cbc6b" providerId="ADAL" clId="{F2BC4D2E-3AF4-4D40-BAC4-33ECAC74BCBD}" dt="2025-09-24T09:49:06.588" v="122" actId="1076"/>
          <ac:cxnSpMkLst>
            <pc:docMk/>
            <pc:sldMk cId="441283792" sldId="256"/>
            <ac:cxnSpMk id="95" creationId="{046BB470-8828-6776-AAC4-3FC0242F4117}"/>
          </ac:cxnSpMkLst>
        </pc:cxnChg>
        <pc:cxnChg chg="add mod">
          <ac:chgData name="Holmberg Schiavone, Lovisa" userId="bbe6b084-409e-4123-bcbd-da2be00cbc6b" providerId="ADAL" clId="{F2BC4D2E-3AF4-4D40-BAC4-33ECAC74BCBD}" dt="2025-09-24T09:49:26.942" v="124" actId="1076"/>
          <ac:cxnSpMkLst>
            <pc:docMk/>
            <pc:sldMk cId="441283792" sldId="256"/>
            <ac:cxnSpMk id="96" creationId="{814C7BA9-EBB0-8EF8-676A-5C63677A5411}"/>
          </ac:cxnSpMkLst>
        </pc:cxnChg>
        <pc:cxnChg chg="add mod">
          <ac:chgData name="Holmberg Schiavone, Lovisa" userId="bbe6b084-409e-4123-bcbd-da2be00cbc6b" providerId="ADAL" clId="{F2BC4D2E-3AF4-4D40-BAC4-33ECAC74BCBD}" dt="2025-09-24T09:49:43.661" v="126" actId="1076"/>
          <ac:cxnSpMkLst>
            <pc:docMk/>
            <pc:sldMk cId="441283792" sldId="256"/>
            <ac:cxnSpMk id="97" creationId="{740DD510-6779-2B33-DD13-7C77CC132270}"/>
          </ac:cxnSpMkLst>
        </pc:cxnChg>
        <pc:cxnChg chg="add mod">
          <ac:chgData name="Holmberg Schiavone, Lovisa" userId="bbe6b084-409e-4123-bcbd-da2be00cbc6b" providerId="ADAL" clId="{F2BC4D2E-3AF4-4D40-BAC4-33ECAC74BCBD}" dt="2025-09-24T09:50:00.396" v="128" actId="1076"/>
          <ac:cxnSpMkLst>
            <pc:docMk/>
            <pc:sldMk cId="441283792" sldId="256"/>
            <ac:cxnSpMk id="98" creationId="{6D041C75-9A18-F47D-F367-406EB01844B3}"/>
          </ac:cxnSpMkLst>
        </pc:cxnChg>
        <pc:cxnChg chg="add mod">
          <ac:chgData name="Holmberg Schiavone, Lovisa" userId="bbe6b084-409e-4123-bcbd-da2be00cbc6b" providerId="ADAL" clId="{F2BC4D2E-3AF4-4D40-BAC4-33ECAC74BCBD}" dt="2025-09-24T09:50:13.524" v="130" actId="1076"/>
          <ac:cxnSpMkLst>
            <pc:docMk/>
            <pc:sldMk cId="441283792" sldId="256"/>
            <ac:cxnSpMk id="99" creationId="{419F54F0-9AA9-335A-887A-8B78E9588C41}"/>
          </ac:cxnSpMkLst>
        </pc:cxnChg>
        <pc:cxnChg chg="add mod">
          <ac:chgData name="Holmberg Schiavone, Lovisa" userId="bbe6b084-409e-4123-bcbd-da2be00cbc6b" providerId="ADAL" clId="{F2BC4D2E-3AF4-4D40-BAC4-33ECAC74BCBD}" dt="2025-09-24T12:29:42.741" v="271" actId="1582"/>
          <ac:cxnSpMkLst>
            <pc:docMk/>
            <pc:sldMk cId="441283792" sldId="256"/>
            <ac:cxnSpMk id="100" creationId="{D29AC134-3C8D-854C-CD77-C1C402B52B1A}"/>
          </ac:cxnSpMkLst>
        </pc:cxnChg>
        <pc:cxnChg chg="add mod">
          <ac:chgData name="Holmberg Schiavone, Lovisa" userId="bbe6b084-409e-4123-bcbd-da2be00cbc6b" providerId="ADAL" clId="{F2BC4D2E-3AF4-4D40-BAC4-33ECAC74BCBD}" dt="2025-09-24T12:29:57.466" v="273" actId="1076"/>
          <ac:cxnSpMkLst>
            <pc:docMk/>
            <pc:sldMk cId="441283792" sldId="256"/>
            <ac:cxnSpMk id="102" creationId="{AF4054BF-59AC-A586-10EF-3D33A18E3D4B}"/>
          </ac:cxnSpMkLst>
        </pc:cxnChg>
        <pc:cxnChg chg="add mod">
          <ac:chgData name="Holmberg Schiavone, Lovisa" userId="bbe6b084-409e-4123-bcbd-da2be00cbc6b" providerId="ADAL" clId="{F2BC4D2E-3AF4-4D40-BAC4-33ECAC74BCBD}" dt="2025-09-24T12:30:19.424" v="275" actId="1076"/>
          <ac:cxnSpMkLst>
            <pc:docMk/>
            <pc:sldMk cId="441283792" sldId="256"/>
            <ac:cxnSpMk id="103" creationId="{9684D667-3AB5-F560-020B-4F4E7F541D2D}"/>
          </ac:cxnSpMkLst>
        </pc:cxnChg>
        <pc:cxnChg chg="add mod">
          <ac:chgData name="Holmberg Schiavone, Lovisa" userId="bbe6b084-409e-4123-bcbd-da2be00cbc6b" providerId="ADAL" clId="{F2BC4D2E-3AF4-4D40-BAC4-33ECAC74BCBD}" dt="2025-09-24T12:30:19.424" v="275" actId="1076"/>
          <ac:cxnSpMkLst>
            <pc:docMk/>
            <pc:sldMk cId="441283792" sldId="256"/>
            <ac:cxnSpMk id="104" creationId="{BB408F44-FAE0-F86A-06D1-E28120CECB50}"/>
          </ac:cxnSpMkLst>
        </pc:cxnChg>
        <pc:cxnChg chg="add mod">
          <ac:chgData name="Holmberg Schiavone, Lovisa" userId="bbe6b084-409e-4123-bcbd-da2be00cbc6b" providerId="ADAL" clId="{F2BC4D2E-3AF4-4D40-BAC4-33ECAC74BCBD}" dt="2025-09-24T12:30:53.241" v="278" actId="1076"/>
          <ac:cxnSpMkLst>
            <pc:docMk/>
            <pc:sldMk cId="441283792" sldId="256"/>
            <ac:cxnSpMk id="105" creationId="{C6C5B866-7EF2-C69D-5ED8-BFD7BE7F63B0}"/>
          </ac:cxnSpMkLst>
        </pc:cxnChg>
        <pc:cxnChg chg="add mod">
          <ac:chgData name="Holmberg Schiavone, Lovisa" userId="bbe6b084-409e-4123-bcbd-da2be00cbc6b" providerId="ADAL" clId="{F2BC4D2E-3AF4-4D40-BAC4-33ECAC74BCBD}" dt="2025-09-24T12:31:23.985" v="282" actId="1076"/>
          <ac:cxnSpMkLst>
            <pc:docMk/>
            <pc:sldMk cId="441283792" sldId="256"/>
            <ac:cxnSpMk id="107" creationId="{E6A5A642-52B3-C54E-4C7C-114DB7E8E0CF}"/>
          </ac:cxnSpMkLst>
        </pc:cxnChg>
      </pc:sldChg>
      <pc:sldChg chg="addSp delSp modSp add mod">
        <pc:chgData name="Holmberg Schiavone, Lovisa" userId="bbe6b084-409e-4123-bcbd-da2be00cbc6b" providerId="ADAL" clId="{F2BC4D2E-3AF4-4D40-BAC4-33ECAC74BCBD}" dt="2025-09-24T12:40:31.225" v="284" actId="478"/>
        <pc:sldMkLst>
          <pc:docMk/>
          <pc:sldMk cId="2769655212" sldId="257"/>
        </pc:sldMkLst>
        <pc:spChg chg="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6" creationId="{7A332D8B-DA10-9206-5136-2ED0C36103BA}"/>
          </ac:spMkLst>
        </pc:spChg>
        <pc:spChg chg="add del mod">
          <ac:chgData name="Holmberg Schiavone, Lovisa" userId="bbe6b084-409e-4123-bcbd-da2be00cbc6b" providerId="ADAL" clId="{F2BC4D2E-3AF4-4D40-BAC4-33ECAC74BCBD}" dt="2025-09-24T12:40:31.225" v="284" actId="478"/>
          <ac:spMkLst>
            <pc:docMk/>
            <pc:sldMk cId="2769655212" sldId="257"/>
            <ac:spMk id="28" creationId="{B9ED1D8A-A49B-08E6-FAD5-FA762CD774F3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29" creationId="{A4725383-91C9-2806-DD3C-C729B99790B5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30" creationId="{DF324298-9F19-9B94-FC02-9E55381C9FBD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31" creationId="{A93EEA82-3810-B696-BA96-7A10DE6F28D5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32" creationId="{B371F778-5048-6EA2-7B87-813026ADEC9A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33" creationId="{D43DD39B-27E8-34C5-2FF4-D23B14FC8240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34" creationId="{08185053-9EA2-38D3-8D64-644C4791DEB1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35" creationId="{A67562A8-D5D2-F4F1-ABF5-B15D9714E6BD}"/>
          </ac:spMkLst>
        </pc:spChg>
        <pc:spChg chg="add mod">
          <ac:chgData name="Holmberg Schiavone, Lovisa" userId="bbe6b084-409e-4123-bcbd-da2be00cbc6b" providerId="ADAL" clId="{F2BC4D2E-3AF4-4D40-BAC4-33ECAC74BCBD}" dt="2025-09-24T09:37:35.249" v="10"/>
          <ac:spMkLst>
            <pc:docMk/>
            <pc:sldMk cId="2769655212" sldId="257"/>
            <ac:spMk id="36" creationId="{6AA842A6-5D85-64A2-30D6-48869B1A74D1}"/>
          </ac:spMkLst>
        </pc:spChg>
        <pc:spChg chg="add mod">
          <ac:chgData name="Holmberg Schiavone, Lovisa" userId="bbe6b084-409e-4123-bcbd-da2be00cbc6b" providerId="ADAL" clId="{F2BC4D2E-3AF4-4D40-BAC4-33ECAC74BCBD}" dt="2025-09-24T09:41:37.995" v="63" actId="20577"/>
          <ac:spMkLst>
            <pc:docMk/>
            <pc:sldMk cId="2769655212" sldId="257"/>
            <ac:spMk id="37" creationId="{307163ED-89BB-5BB2-3108-353968B91304}"/>
          </ac:spMkLst>
        </pc:spChg>
        <pc:cxnChg chg="add mod">
          <ac:chgData name="Holmberg Schiavone, Lovisa" userId="bbe6b084-409e-4123-bcbd-da2be00cbc6b" providerId="ADAL" clId="{F2BC4D2E-3AF4-4D40-BAC4-33ECAC74BCBD}" dt="2025-09-24T09:50:38.691" v="132" actId="1076"/>
          <ac:cxnSpMkLst>
            <pc:docMk/>
            <pc:sldMk cId="2769655212" sldId="257"/>
            <ac:cxnSpMk id="38" creationId="{B1815C44-8E82-CAAD-EBD2-D10D987635F0}"/>
          </ac:cxnSpMkLst>
        </pc:cxnChg>
        <pc:cxnChg chg="add mod">
          <ac:chgData name="Holmberg Schiavone, Lovisa" userId="bbe6b084-409e-4123-bcbd-da2be00cbc6b" providerId="ADAL" clId="{F2BC4D2E-3AF4-4D40-BAC4-33ECAC74BCBD}" dt="2025-09-24T09:50:54.899" v="134" actId="1076"/>
          <ac:cxnSpMkLst>
            <pc:docMk/>
            <pc:sldMk cId="2769655212" sldId="257"/>
            <ac:cxnSpMk id="39" creationId="{EE35020D-D02F-35A2-B1EE-E080431F8BBD}"/>
          </ac:cxnSpMkLst>
        </pc:cxnChg>
        <pc:cxnChg chg="add mod">
          <ac:chgData name="Holmberg Schiavone, Lovisa" userId="bbe6b084-409e-4123-bcbd-da2be00cbc6b" providerId="ADAL" clId="{F2BC4D2E-3AF4-4D40-BAC4-33ECAC74BCBD}" dt="2025-09-24T09:51:15.629" v="136" actId="1076"/>
          <ac:cxnSpMkLst>
            <pc:docMk/>
            <pc:sldMk cId="2769655212" sldId="257"/>
            <ac:cxnSpMk id="40" creationId="{86C85D93-C535-024A-967A-AA96B581FB86}"/>
          </ac:cxnSpMkLst>
        </pc:cxnChg>
        <pc:cxnChg chg="add mod">
          <ac:chgData name="Holmberg Schiavone, Lovisa" userId="bbe6b084-409e-4123-bcbd-da2be00cbc6b" providerId="ADAL" clId="{F2BC4D2E-3AF4-4D40-BAC4-33ECAC74BCBD}" dt="2025-09-24T09:51:31.134" v="138" actId="1076"/>
          <ac:cxnSpMkLst>
            <pc:docMk/>
            <pc:sldMk cId="2769655212" sldId="257"/>
            <ac:cxnSpMk id="41" creationId="{C5DF9E33-5366-DA88-326C-3784374A2331}"/>
          </ac:cxnSpMkLst>
        </pc:cxnChg>
        <pc:cxnChg chg="add mod">
          <ac:chgData name="Holmberg Schiavone, Lovisa" userId="bbe6b084-409e-4123-bcbd-da2be00cbc6b" providerId="ADAL" clId="{F2BC4D2E-3AF4-4D40-BAC4-33ECAC74BCBD}" dt="2025-09-24T09:51:45.908" v="140" actId="1076"/>
          <ac:cxnSpMkLst>
            <pc:docMk/>
            <pc:sldMk cId="2769655212" sldId="257"/>
            <ac:cxnSpMk id="42" creationId="{4B4481D9-83DC-EC29-4A13-3D55B1313B47}"/>
          </ac:cxnSpMkLst>
        </pc:cxnChg>
        <pc:cxnChg chg="add mod">
          <ac:chgData name="Holmberg Schiavone, Lovisa" userId="bbe6b084-409e-4123-bcbd-da2be00cbc6b" providerId="ADAL" clId="{F2BC4D2E-3AF4-4D40-BAC4-33ECAC74BCBD}" dt="2025-09-24T12:14:59.217" v="142" actId="1076"/>
          <ac:cxnSpMkLst>
            <pc:docMk/>
            <pc:sldMk cId="2769655212" sldId="257"/>
            <ac:cxnSpMk id="43" creationId="{7A1BD669-5EED-4840-81AA-8790533EA2B5}"/>
          </ac:cxnSpMkLst>
        </pc:cxnChg>
        <pc:cxnChg chg="add mod">
          <ac:chgData name="Holmberg Schiavone, Lovisa" userId="bbe6b084-409e-4123-bcbd-da2be00cbc6b" providerId="ADAL" clId="{F2BC4D2E-3AF4-4D40-BAC4-33ECAC74BCBD}" dt="2025-09-24T12:15:11.339" v="144" actId="1076"/>
          <ac:cxnSpMkLst>
            <pc:docMk/>
            <pc:sldMk cId="2769655212" sldId="257"/>
            <ac:cxnSpMk id="44" creationId="{81D42857-03DB-0CF2-549F-1A4AADBB1CDA}"/>
          </ac:cxnSpMkLst>
        </pc:cxnChg>
        <pc:cxnChg chg="add mod">
          <ac:chgData name="Holmberg Schiavone, Lovisa" userId="bbe6b084-409e-4123-bcbd-da2be00cbc6b" providerId="ADAL" clId="{F2BC4D2E-3AF4-4D40-BAC4-33ECAC74BCBD}" dt="2025-09-24T12:15:20.298" v="146" actId="1076"/>
          <ac:cxnSpMkLst>
            <pc:docMk/>
            <pc:sldMk cId="2769655212" sldId="257"/>
            <ac:cxnSpMk id="45" creationId="{62C8D051-9A22-BB03-EE25-D180CB0687D6}"/>
          </ac:cxnSpMkLst>
        </pc:cxnChg>
        <pc:cxnChg chg="add mod">
          <ac:chgData name="Holmberg Schiavone, Lovisa" userId="bbe6b084-409e-4123-bcbd-da2be00cbc6b" providerId="ADAL" clId="{F2BC4D2E-3AF4-4D40-BAC4-33ECAC74BCBD}" dt="2025-09-24T12:15:28.845" v="148" actId="1076"/>
          <ac:cxnSpMkLst>
            <pc:docMk/>
            <pc:sldMk cId="2769655212" sldId="257"/>
            <ac:cxnSpMk id="46" creationId="{EB7C2893-1A0F-7777-33D7-0D7D68BFD205}"/>
          </ac:cxnSpMkLst>
        </pc:cxnChg>
        <pc:cxnChg chg="add mod">
          <ac:chgData name="Holmberg Schiavone, Lovisa" userId="bbe6b084-409e-4123-bcbd-da2be00cbc6b" providerId="ADAL" clId="{F2BC4D2E-3AF4-4D40-BAC4-33ECAC74BCBD}" dt="2025-09-24T12:15:41.170" v="150" actId="1076"/>
          <ac:cxnSpMkLst>
            <pc:docMk/>
            <pc:sldMk cId="2769655212" sldId="257"/>
            <ac:cxnSpMk id="47" creationId="{AC64596B-4852-9E19-1A22-B0096754DF77}"/>
          </ac:cxnSpMkLst>
        </pc:cxnChg>
        <pc:cxnChg chg="add mod">
          <ac:chgData name="Holmberg Schiavone, Lovisa" userId="bbe6b084-409e-4123-bcbd-da2be00cbc6b" providerId="ADAL" clId="{F2BC4D2E-3AF4-4D40-BAC4-33ECAC74BCBD}" dt="2025-09-24T12:15:54.813" v="152" actId="1076"/>
          <ac:cxnSpMkLst>
            <pc:docMk/>
            <pc:sldMk cId="2769655212" sldId="257"/>
            <ac:cxnSpMk id="48" creationId="{D2997615-9539-B121-D293-779BF0CC18DB}"/>
          </ac:cxnSpMkLst>
        </pc:cxnChg>
        <pc:cxnChg chg="add mod">
          <ac:chgData name="Holmberg Schiavone, Lovisa" userId="bbe6b084-409e-4123-bcbd-da2be00cbc6b" providerId="ADAL" clId="{F2BC4D2E-3AF4-4D40-BAC4-33ECAC74BCBD}" dt="2025-09-24T12:16:02.626" v="154" actId="1076"/>
          <ac:cxnSpMkLst>
            <pc:docMk/>
            <pc:sldMk cId="2769655212" sldId="257"/>
            <ac:cxnSpMk id="49" creationId="{0BA522CC-7169-E27C-EA41-DE3712B72B7B}"/>
          </ac:cxnSpMkLst>
        </pc:cxnChg>
        <pc:cxnChg chg="add mod">
          <ac:chgData name="Holmberg Schiavone, Lovisa" userId="bbe6b084-409e-4123-bcbd-da2be00cbc6b" providerId="ADAL" clId="{F2BC4D2E-3AF4-4D40-BAC4-33ECAC74BCBD}" dt="2025-09-24T12:16:10.155" v="156" actId="1076"/>
          <ac:cxnSpMkLst>
            <pc:docMk/>
            <pc:sldMk cId="2769655212" sldId="257"/>
            <ac:cxnSpMk id="50" creationId="{002B1879-D8B3-B8F7-113A-99AA2AFD37E6}"/>
          </ac:cxnSpMkLst>
        </pc:cxnChg>
        <pc:cxnChg chg="add mod">
          <ac:chgData name="Holmberg Schiavone, Lovisa" userId="bbe6b084-409e-4123-bcbd-da2be00cbc6b" providerId="ADAL" clId="{F2BC4D2E-3AF4-4D40-BAC4-33ECAC74BCBD}" dt="2025-09-24T12:16:21.162" v="158" actId="1076"/>
          <ac:cxnSpMkLst>
            <pc:docMk/>
            <pc:sldMk cId="2769655212" sldId="257"/>
            <ac:cxnSpMk id="51" creationId="{B067702D-97E9-E9B7-D11D-82C9C98D99DE}"/>
          </ac:cxnSpMkLst>
        </pc:cxnChg>
        <pc:cxnChg chg="add mod">
          <ac:chgData name="Holmberg Schiavone, Lovisa" userId="bbe6b084-409e-4123-bcbd-da2be00cbc6b" providerId="ADAL" clId="{F2BC4D2E-3AF4-4D40-BAC4-33ECAC74BCBD}" dt="2025-09-24T12:16:31.435" v="160" actId="1076"/>
          <ac:cxnSpMkLst>
            <pc:docMk/>
            <pc:sldMk cId="2769655212" sldId="257"/>
            <ac:cxnSpMk id="52" creationId="{B616A4ED-9C8A-3B27-301E-1C82E6424C77}"/>
          </ac:cxnSpMkLst>
        </pc:cxnChg>
        <pc:cxnChg chg="add mod">
          <ac:chgData name="Holmberg Schiavone, Lovisa" userId="bbe6b084-409e-4123-bcbd-da2be00cbc6b" providerId="ADAL" clId="{F2BC4D2E-3AF4-4D40-BAC4-33ECAC74BCBD}" dt="2025-09-24T12:16:41.665" v="162" actId="1076"/>
          <ac:cxnSpMkLst>
            <pc:docMk/>
            <pc:sldMk cId="2769655212" sldId="257"/>
            <ac:cxnSpMk id="53" creationId="{5F05C9E6-91BD-93DB-F31C-424DD553FA0E}"/>
          </ac:cxnSpMkLst>
        </pc:cxnChg>
        <pc:cxnChg chg="add mod">
          <ac:chgData name="Holmberg Schiavone, Lovisa" userId="bbe6b084-409e-4123-bcbd-da2be00cbc6b" providerId="ADAL" clId="{F2BC4D2E-3AF4-4D40-BAC4-33ECAC74BCBD}" dt="2025-09-24T12:16:49.660" v="164" actId="1076"/>
          <ac:cxnSpMkLst>
            <pc:docMk/>
            <pc:sldMk cId="2769655212" sldId="257"/>
            <ac:cxnSpMk id="54" creationId="{F44838C2-852B-73A4-5BBD-4BEF521E444C}"/>
          </ac:cxnSpMkLst>
        </pc:cxnChg>
        <pc:cxnChg chg="add mod">
          <ac:chgData name="Holmberg Schiavone, Lovisa" userId="bbe6b084-409e-4123-bcbd-da2be00cbc6b" providerId="ADAL" clId="{F2BC4D2E-3AF4-4D40-BAC4-33ECAC74BCBD}" dt="2025-09-24T12:17:08.811" v="166" actId="1076"/>
          <ac:cxnSpMkLst>
            <pc:docMk/>
            <pc:sldMk cId="2769655212" sldId="257"/>
            <ac:cxnSpMk id="55" creationId="{4A9E43DA-84FD-586B-A04C-25F48CDBEB55}"/>
          </ac:cxnSpMkLst>
        </pc:cxnChg>
        <pc:cxnChg chg="add mod">
          <ac:chgData name="Holmberg Schiavone, Lovisa" userId="bbe6b084-409e-4123-bcbd-da2be00cbc6b" providerId="ADAL" clId="{F2BC4D2E-3AF4-4D40-BAC4-33ECAC74BCBD}" dt="2025-09-24T12:17:17.620" v="168" actId="1076"/>
          <ac:cxnSpMkLst>
            <pc:docMk/>
            <pc:sldMk cId="2769655212" sldId="257"/>
            <ac:cxnSpMk id="56" creationId="{B6ED77A5-B090-8BAA-D08D-8B4C96B711D7}"/>
          </ac:cxnSpMkLst>
        </pc:cxnChg>
        <pc:cxnChg chg="add mod">
          <ac:chgData name="Holmberg Schiavone, Lovisa" userId="bbe6b084-409e-4123-bcbd-da2be00cbc6b" providerId="ADAL" clId="{F2BC4D2E-3AF4-4D40-BAC4-33ECAC74BCBD}" dt="2025-09-24T12:18:08.291" v="170" actId="1076"/>
          <ac:cxnSpMkLst>
            <pc:docMk/>
            <pc:sldMk cId="2769655212" sldId="257"/>
            <ac:cxnSpMk id="57" creationId="{135621E1-3514-27A1-86D7-A90CD057ACC2}"/>
          </ac:cxnSpMkLst>
        </pc:cxnChg>
      </pc:sldChg>
      <pc:sldChg chg="addSp modSp add mod">
        <pc:chgData name="Holmberg Schiavone, Lovisa" userId="bbe6b084-409e-4123-bcbd-da2be00cbc6b" providerId="ADAL" clId="{F2BC4D2E-3AF4-4D40-BAC4-33ECAC74BCBD}" dt="2025-09-24T12:24:43.938" v="231" actId="1076"/>
        <pc:sldMkLst>
          <pc:docMk/>
          <pc:sldMk cId="2176433205" sldId="258"/>
        </pc:sldMkLst>
        <pc:spChg chg="add mod">
          <ac:chgData name="Holmberg Schiavone, Lovisa" userId="bbe6b084-409e-4123-bcbd-da2be00cbc6b" providerId="ADAL" clId="{F2BC4D2E-3AF4-4D40-BAC4-33ECAC74BCBD}" dt="2025-09-24T09:41:49.322" v="68" actId="20577"/>
          <ac:spMkLst>
            <pc:docMk/>
            <pc:sldMk cId="2176433205" sldId="258"/>
            <ac:spMk id="3" creationId="{B8A5DE02-A346-E48E-473B-59FDE9C56828}"/>
          </ac:spMkLst>
        </pc:spChg>
        <pc:spChg chg="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12" creationId="{F3291859-142F-8405-3832-62BFF7EECD53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48" creationId="{BC02575F-FA49-BA68-3361-79B3F180E418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50" creationId="{D5AA3E9D-0C29-7A9D-25F6-7E08AD5D5840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52" creationId="{E1B4CAF1-1148-765A-FC98-352691BC1058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53" creationId="{36EA676D-7F0A-3763-1D0D-593DDA9BF7C9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55" creationId="{A10B76EA-BFB9-40E0-4436-2D63A7083B97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57" creationId="{676B6D28-A11D-ABD4-CE85-85E443AC1448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58" creationId="{BC54BB05-7AEB-CFF5-4C80-057E4E4362C8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59" creationId="{D542A38D-BDFD-B195-EB3B-C7B55483FFE6}"/>
          </ac:spMkLst>
        </pc:spChg>
        <pc:spChg chg="add mod">
          <ac:chgData name="Holmberg Schiavone, Lovisa" userId="bbe6b084-409e-4123-bcbd-da2be00cbc6b" providerId="ADAL" clId="{F2BC4D2E-3AF4-4D40-BAC4-33ECAC74BCBD}" dt="2025-09-24T09:38:24.730" v="11"/>
          <ac:spMkLst>
            <pc:docMk/>
            <pc:sldMk cId="2176433205" sldId="258"/>
            <ac:spMk id="60" creationId="{4FAE062C-F5E7-4B59-8CE8-5FB717ABD3DC}"/>
          </ac:spMkLst>
        </pc:spChg>
        <pc:cxnChg chg="add mod">
          <ac:chgData name="Holmberg Schiavone, Lovisa" userId="bbe6b084-409e-4123-bcbd-da2be00cbc6b" providerId="ADAL" clId="{F2BC4D2E-3AF4-4D40-BAC4-33ECAC74BCBD}" dt="2025-09-24T12:18:27.251" v="172" actId="1076"/>
          <ac:cxnSpMkLst>
            <pc:docMk/>
            <pc:sldMk cId="2176433205" sldId="258"/>
            <ac:cxnSpMk id="4" creationId="{C23AE187-DABE-ADB4-19E2-013BE9E28134}"/>
          </ac:cxnSpMkLst>
        </pc:cxnChg>
        <pc:cxnChg chg="add mod">
          <ac:chgData name="Holmberg Schiavone, Lovisa" userId="bbe6b084-409e-4123-bcbd-da2be00cbc6b" providerId="ADAL" clId="{F2BC4D2E-3AF4-4D40-BAC4-33ECAC74BCBD}" dt="2025-09-24T12:18:39.886" v="174" actId="1076"/>
          <ac:cxnSpMkLst>
            <pc:docMk/>
            <pc:sldMk cId="2176433205" sldId="258"/>
            <ac:cxnSpMk id="5" creationId="{DBFA31D5-3282-0E1E-37C1-7BFFA51CB5A1}"/>
          </ac:cxnSpMkLst>
        </pc:cxnChg>
        <pc:cxnChg chg="add mod">
          <ac:chgData name="Holmberg Schiavone, Lovisa" userId="bbe6b084-409e-4123-bcbd-da2be00cbc6b" providerId="ADAL" clId="{F2BC4D2E-3AF4-4D40-BAC4-33ECAC74BCBD}" dt="2025-09-24T12:18:47.514" v="176" actId="1076"/>
          <ac:cxnSpMkLst>
            <pc:docMk/>
            <pc:sldMk cId="2176433205" sldId="258"/>
            <ac:cxnSpMk id="7" creationId="{F57D97EC-CA3C-B693-8558-B7B1E50CF082}"/>
          </ac:cxnSpMkLst>
        </pc:cxnChg>
        <pc:cxnChg chg="add mod">
          <ac:chgData name="Holmberg Schiavone, Lovisa" userId="bbe6b084-409e-4123-bcbd-da2be00cbc6b" providerId="ADAL" clId="{F2BC4D2E-3AF4-4D40-BAC4-33ECAC74BCBD}" dt="2025-09-24T12:18:57.827" v="178" actId="1076"/>
          <ac:cxnSpMkLst>
            <pc:docMk/>
            <pc:sldMk cId="2176433205" sldId="258"/>
            <ac:cxnSpMk id="49" creationId="{C406DAB3-83C6-4FA0-4470-E3A3B752E901}"/>
          </ac:cxnSpMkLst>
        </pc:cxnChg>
        <pc:cxnChg chg="add mod">
          <ac:chgData name="Holmberg Schiavone, Lovisa" userId="bbe6b084-409e-4123-bcbd-da2be00cbc6b" providerId="ADAL" clId="{F2BC4D2E-3AF4-4D40-BAC4-33ECAC74BCBD}" dt="2025-09-24T12:19:06.674" v="180" actId="1076"/>
          <ac:cxnSpMkLst>
            <pc:docMk/>
            <pc:sldMk cId="2176433205" sldId="258"/>
            <ac:cxnSpMk id="61" creationId="{FEF68BF7-5F6C-BB6B-C7B2-D28748222E6D}"/>
          </ac:cxnSpMkLst>
        </pc:cxnChg>
        <pc:cxnChg chg="add mod">
          <ac:chgData name="Holmberg Schiavone, Lovisa" userId="bbe6b084-409e-4123-bcbd-da2be00cbc6b" providerId="ADAL" clId="{F2BC4D2E-3AF4-4D40-BAC4-33ECAC74BCBD}" dt="2025-09-24T12:19:13.306" v="182" actId="1076"/>
          <ac:cxnSpMkLst>
            <pc:docMk/>
            <pc:sldMk cId="2176433205" sldId="258"/>
            <ac:cxnSpMk id="62" creationId="{D6931973-F5AE-6C6D-B00D-4813A1C47D64}"/>
          </ac:cxnSpMkLst>
        </pc:cxnChg>
        <pc:cxnChg chg="add mod">
          <ac:chgData name="Holmberg Schiavone, Lovisa" userId="bbe6b084-409e-4123-bcbd-da2be00cbc6b" providerId="ADAL" clId="{F2BC4D2E-3AF4-4D40-BAC4-33ECAC74BCBD}" dt="2025-09-24T12:19:20.443" v="184" actId="1076"/>
          <ac:cxnSpMkLst>
            <pc:docMk/>
            <pc:sldMk cId="2176433205" sldId="258"/>
            <ac:cxnSpMk id="63" creationId="{0C50CBA1-DBB2-1AA3-676C-B51D204610AC}"/>
          </ac:cxnSpMkLst>
        </pc:cxnChg>
        <pc:cxnChg chg="add mod">
          <ac:chgData name="Holmberg Schiavone, Lovisa" userId="bbe6b084-409e-4123-bcbd-da2be00cbc6b" providerId="ADAL" clId="{F2BC4D2E-3AF4-4D40-BAC4-33ECAC74BCBD}" dt="2025-09-24T12:19:29.757" v="186" actId="1076"/>
          <ac:cxnSpMkLst>
            <pc:docMk/>
            <pc:sldMk cId="2176433205" sldId="258"/>
            <ac:cxnSpMk id="64" creationId="{3C775E87-5331-761E-D3D1-2C097656C620}"/>
          </ac:cxnSpMkLst>
        </pc:cxnChg>
        <pc:cxnChg chg="add mod">
          <ac:chgData name="Holmberg Schiavone, Lovisa" userId="bbe6b084-409e-4123-bcbd-da2be00cbc6b" providerId="ADAL" clId="{F2BC4D2E-3AF4-4D40-BAC4-33ECAC74BCBD}" dt="2025-09-24T12:19:37.004" v="188" actId="1076"/>
          <ac:cxnSpMkLst>
            <pc:docMk/>
            <pc:sldMk cId="2176433205" sldId="258"/>
            <ac:cxnSpMk id="65" creationId="{3ABECC7B-60FD-8E33-2A88-B9745DA8FFCE}"/>
          </ac:cxnSpMkLst>
        </pc:cxnChg>
        <pc:cxnChg chg="add mod">
          <ac:chgData name="Holmberg Schiavone, Lovisa" userId="bbe6b084-409e-4123-bcbd-da2be00cbc6b" providerId="ADAL" clId="{F2BC4D2E-3AF4-4D40-BAC4-33ECAC74BCBD}" dt="2025-09-24T12:20:27.755" v="193" actId="1076"/>
          <ac:cxnSpMkLst>
            <pc:docMk/>
            <pc:sldMk cId="2176433205" sldId="258"/>
            <ac:cxnSpMk id="66" creationId="{66AAED11-6E90-0EF3-5419-D70E3BABC659}"/>
          </ac:cxnSpMkLst>
        </pc:cxnChg>
        <pc:cxnChg chg="add mod">
          <ac:chgData name="Holmberg Schiavone, Lovisa" userId="bbe6b084-409e-4123-bcbd-da2be00cbc6b" providerId="ADAL" clId="{F2BC4D2E-3AF4-4D40-BAC4-33ECAC74BCBD}" dt="2025-09-24T12:20:19.475" v="192" actId="1076"/>
          <ac:cxnSpMkLst>
            <pc:docMk/>
            <pc:sldMk cId="2176433205" sldId="258"/>
            <ac:cxnSpMk id="67" creationId="{CD9C7C1B-C661-6491-160C-4470398DFEAB}"/>
          </ac:cxnSpMkLst>
        </pc:cxnChg>
        <pc:cxnChg chg="add mod">
          <ac:chgData name="Holmberg Schiavone, Lovisa" userId="bbe6b084-409e-4123-bcbd-da2be00cbc6b" providerId="ADAL" clId="{F2BC4D2E-3AF4-4D40-BAC4-33ECAC74BCBD}" dt="2025-09-24T12:20:47.956" v="195" actId="1076"/>
          <ac:cxnSpMkLst>
            <pc:docMk/>
            <pc:sldMk cId="2176433205" sldId="258"/>
            <ac:cxnSpMk id="68" creationId="{C892898A-5575-E26F-0603-CBFD3C0F9B34}"/>
          </ac:cxnSpMkLst>
        </pc:cxnChg>
        <pc:cxnChg chg="add mod">
          <ac:chgData name="Holmberg Schiavone, Lovisa" userId="bbe6b084-409e-4123-bcbd-da2be00cbc6b" providerId="ADAL" clId="{F2BC4D2E-3AF4-4D40-BAC4-33ECAC74BCBD}" dt="2025-09-24T12:21:26.626" v="197" actId="1076"/>
          <ac:cxnSpMkLst>
            <pc:docMk/>
            <pc:sldMk cId="2176433205" sldId="258"/>
            <ac:cxnSpMk id="69" creationId="{8FA4288B-E4B4-39CA-D7DF-3C8B129922D0}"/>
          </ac:cxnSpMkLst>
        </pc:cxnChg>
        <pc:cxnChg chg="add mod">
          <ac:chgData name="Holmberg Schiavone, Lovisa" userId="bbe6b084-409e-4123-bcbd-da2be00cbc6b" providerId="ADAL" clId="{F2BC4D2E-3AF4-4D40-BAC4-33ECAC74BCBD}" dt="2025-09-24T12:21:39.035" v="199" actId="1076"/>
          <ac:cxnSpMkLst>
            <pc:docMk/>
            <pc:sldMk cId="2176433205" sldId="258"/>
            <ac:cxnSpMk id="70" creationId="{6BEDF749-6B58-0C12-C15F-35C17429C0C6}"/>
          </ac:cxnSpMkLst>
        </pc:cxnChg>
        <pc:cxnChg chg="add mod">
          <ac:chgData name="Holmberg Schiavone, Lovisa" userId="bbe6b084-409e-4123-bcbd-da2be00cbc6b" providerId="ADAL" clId="{F2BC4D2E-3AF4-4D40-BAC4-33ECAC74BCBD}" dt="2025-09-24T12:21:50.052" v="201" actId="1076"/>
          <ac:cxnSpMkLst>
            <pc:docMk/>
            <pc:sldMk cId="2176433205" sldId="258"/>
            <ac:cxnSpMk id="71" creationId="{BE33FF6F-E1BF-FC28-F628-714DAE179A87}"/>
          </ac:cxnSpMkLst>
        </pc:cxnChg>
        <pc:cxnChg chg="add mod">
          <ac:chgData name="Holmberg Schiavone, Lovisa" userId="bbe6b084-409e-4123-bcbd-da2be00cbc6b" providerId="ADAL" clId="{F2BC4D2E-3AF4-4D40-BAC4-33ECAC74BCBD}" dt="2025-09-24T12:21:58.004" v="203" actId="1076"/>
          <ac:cxnSpMkLst>
            <pc:docMk/>
            <pc:sldMk cId="2176433205" sldId="258"/>
            <ac:cxnSpMk id="72" creationId="{3BA08637-337B-3917-4771-B5F61F7D693E}"/>
          </ac:cxnSpMkLst>
        </pc:cxnChg>
        <pc:cxnChg chg="add mod">
          <ac:chgData name="Holmberg Schiavone, Lovisa" userId="bbe6b084-409e-4123-bcbd-da2be00cbc6b" providerId="ADAL" clId="{F2BC4D2E-3AF4-4D40-BAC4-33ECAC74BCBD}" dt="2025-09-24T12:22:08.115" v="205" actId="1076"/>
          <ac:cxnSpMkLst>
            <pc:docMk/>
            <pc:sldMk cId="2176433205" sldId="258"/>
            <ac:cxnSpMk id="73" creationId="{8A369BF5-05F1-37F6-0D05-B985FFC6A376}"/>
          </ac:cxnSpMkLst>
        </pc:cxnChg>
        <pc:cxnChg chg="add mod">
          <ac:chgData name="Holmberg Schiavone, Lovisa" userId="bbe6b084-409e-4123-bcbd-da2be00cbc6b" providerId="ADAL" clId="{F2BC4D2E-3AF4-4D40-BAC4-33ECAC74BCBD}" dt="2025-09-24T12:22:14.987" v="207" actId="1076"/>
          <ac:cxnSpMkLst>
            <pc:docMk/>
            <pc:sldMk cId="2176433205" sldId="258"/>
            <ac:cxnSpMk id="74" creationId="{08894F4C-9B88-8D2A-7EEF-F79A491F2807}"/>
          </ac:cxnSpMkLst>
        </pc:cxnChg>
        <pc:cxnChg chg="add mod">
          <ac:chgData name="Holmberg Schiavone, Lovisa" userId="bbe6b084-409e-4123-bcbd-da2be00cbc6b" providerId="ADAL" clId="{F2BC4D2E-3AF4-4D40-BAC4-33ECAC74BCBD}" dt="2025-09-24T12:22:22.596" v="209" actId="1076"/>
          <ac:cxnSpMkLst>
            <pc:docMk/>
            <pc:sldMk cId="2176433205" sldId="258"/>
            <ac:cxnSpMk id="75" creationId="{3780740A-81F1-38D4-CF9C-0439118AE3C8}"/>
          </ac:cxnSpMkLst>
        </pc:cxnChg>
        <pc:cxnChg chg="add mod">
          <ac:chgData name="Holmberg Schiavone, Lovisa" userId="bbe6b084-409e-4123-bcbd-da2be00cbc6b" providerId="ADAL" clId="{F2BC4D2E-3AF4-4D40-BAC4-33ECAC74BCBD}" dt="2025-09-24T12:22:48.164" v="211" actId="1076"/>
          <ac:cxnSpMkLst>
            <pc:docMk/>
            <pc:sldMk cId="2176433205" sldId="258"/>
            <ac:cxnSpMk id="76" creationId="{EBFE06B6-C6FB-E8C3-3E2D-2F3B255FC173}"/>
          </ac:cxnSpMkLst>
        </pc:cxnChg>
        <pc:cxnChg chg="add mod">
          <ac:chgData name="Holmberg Schiavone, Lovisa" userId="bbe6b084-409e-4123-bcbd-da2be00cbc6b" providerId="ADAL" clId="{F2BC4D2E-3AF4-4D40-BAC4-33ECAC74BCBD}" dt="2025-09-24T12:22:59.676" v="213" actId="1076"/>
          <ac:cxnSpMkLst>
            <pc:docMk/>
            <pc:sldMk cId="2176433205" sldId="258"/>
            <ac:cxnSpMk id="77" creationId="{30DBD22C-4466-E765-2610-04B400E6782C}"/>
          </ac:cxnSpMkLst>
        </pc:cxnChg>
        <pc:cxnChg chg="add mod">
          <ac:chgData name="Holmberg Schiavone, Lovisa" userId="bbe6b084-409e-4123-bcbd-da2be00cbc6b" providerId="ADAL" clId="{F2BC4D2E-3AF4-4D40-BAC4-33ECAC74BCBD}" dt="2025-09-24T12:23:09.890" v="215" actId="1076"/>
          <ac:cxnSpMkLst>
            <pc:docMk/>
            <pc:sldMk cId="2176433205" sldId="258"/>
            <ac:cxnSpMk id="78" creationId="{F26A999A-C930-D756-0952-CADBF38D577A}"/>
          </ac:cxnSpMkLst>
        </pc:cxnChg>
        <pc:cxnChg chg="add mod">
          <ac:chgData name="Holmberg Schiavone, Lovisa" userId="bbe6b084-409e-4123-bcbd-da2be00cbc6b" providerId="ADAL" clId="{F2BC4D2E-3AF4-4D40-BAC4-33ECAC74BCBD}" dt="2025-09-24T12:23:16.516" v="217" actId="1076"/>
          <ac:cxnSpMkLst>
            <pc:docMk/>
            <pc:sldMk cId="2176433205" sldId="258"/>
            <ac:cxnSpMk id="79" creationId="{FFAC582A-624E-D9F7-9AF4-A5D424EFEF6B}"/>
          </ac:cxnSpMkLst>
        </pc:cxnChg>
        <pc:cxnChg chg="add mod">
          <ac:chgData name="Holmberg Schiavone, Lovisa" userId="bbe6b084-409e-4123-bcbd-da2be00cbc6b" providerId="ADAL" clId="{F2BC4D2E-3AF4-4D40-BAC4-33ECAC74BCBD}" dt="2025-09-24T12:23:37.578" v="219" actId="1076"/>
          <ac:cxnSpMkLst>
            <pc:docMk/>
            <pc:sldMk cId="2176433205" sldId="258"/>
            <ac:cxnSpMk id="80" creationId="{324A6A44-5BCD-020C-716C-1C4C7AC506B5}"/>
          </ac:cxnSpMkLst>
        </pc:cxnChg>
        <pc:cxnChg chg="add mod">
          <ac:chgData name="Holmberg Schiavone, Lovisa" userId="bbe6b084-409e-4123-bcbd-da2be00cbc6b" providerId="ADAL" clId="{F2BC4D2E-3AF4-4D40-BAC4-33ECAC74BCBD}" dt="2025-09-24T12:23:44.995" v="221" actId="1076"/>
          <ac:cxnSpMkLst>
            <pc:docMk/>
            <pc:sldMk cId="2176433205" sldId="258"/>
            <ac:cxnSpMk id="81" creationId="{03ABC49E-7FD3-2123-403E-92ED4551406F}"/>
          </ac:cxnSpMkLst>
        </pc:cxnChg>
        <pc:cxnChg chg="add mod">
          <ac:chgData name="Holmberg Schiavone, Lovisa" userId="bbe6b084-409e-4123-bcbd-da2be00cbc6b" providerId="ADAL" clId="{F2BC4D2E-3AF4-4D40-BAC4-33ECAC74BCBD}" dt="2025-09-24T12:23:56.818" v="223" actId="1076"/>
          <ac:cxnSpMkLst>
            <pc:docMk/>
            <pc:sldMk cId="2176433205" sldId="258"/>
            <ac:cxnSpMk id="82" creationId="{DD798D08-3E98-2A04-CCE3-D9797D2B532F}"/>
          </ac:cxnSpMkLst>
        </pc:cxnChg>
        <pc:cxnChg chg="add mod">
          <ac:chgData name="Holmberg Schiavone, Lovisa" userId="bbe6b084-409e-4123-bcbd-da2be00cbc6b" providerId="ADAL" clId="{F2BC4D2E-3AF4-4D40-BAC4-33ECAC74BCBD}" dt="2025-09-24T12:24:03.507" v="225" actId="1076"/>
          <ac:cxnSpMkLst>
            <pc:docMk/>
            <pc:sldMk cId="2176433205" sldId="258"/>
            <ac:cxnSpMk id="83" creationId="{F9036E11-89B6-9536-C511-B2768A801580}"/>
          </ac:cxnSpMkLst>
        </pc:cxnChg>
        <pc:cxnChg chg="add mod">
          <ac:chgData name="Holmberg Schiavone, Lovisa" userId="bbe6b084-409e-4123-bcbd-da2be00cbc6b" providerId="ADAL" clId="{F2BC4D2E-3AF4-4D40-BAC4-33ECAC74BCBD}" dt="2025-09-24T12:24:30.475" v="227" actId="1076"/>
          <ac:cxnSpMkLst>
            <pc:docMk/>
            <pc:sldMk cId="2176433205" sldId="258"/>
            <ac:cxnSpMk id="84" creationId="{2A22E7C0-375C-9B8E-1BE7-5D942AA3FEC8}"/>
          </ac:cxnSpMkLst>
        </pc:cxnChg>
        <pc:cxnChg chg="add mod">
          <ac:chgData name="Holmberg Schiavone, Lovisa" userId="bbe6b084-409e-4123-bcbd-da2be00cbc6b" providerId="ADAL" clId="{F2BC4D2E-3AF4-4D40-BAC4-33ECAC74BCBD}" dt="2025-09-24T12:24:38.805" v="229" actId="1076"/>
          <ac:cxnSpMkLst>
            <pc:docMk/>
            <pc:sldMk cId="2176433205" sldId="258"/>
            <ac:cxnSpMk id="85" creationId="{9E637CCF-6DCC-E651-1655-DE535B20AA58}"/>
          </ac:cxnSpMkLst>
        </pc:cxnChg>
        <pc:cxnChg chg="add mod">
          <ac:chgData name="Holmberg Schiavone, Lovisa" userId="bbe6b084-409e-4123-bcbd-da2be00cbc6b" providerId="ADAL" clId="{F2BC4D2E-3AF4-4D40-BAC4-33ECAC74BCBD}" dt="2025-09-24T12:24:43.938" v="231" actId="1076"/>
          <ac:cxnSpMkLst>
            <pc:docMk/>
            <pc:sldMk cId="2176433205" sldId="258"/>
            <ac:cxnSpMk id="86" creationId="{BB4F7D5F-8A51-24A7-67D7-4AB8FAB39DEF}"/>
          </ac:cxnSpMkLst>
        </pc:cxnChg>
      </pc:sldChg>
      <pc:sldChg chg="addSp modSp add mod">
        <pc:chgData name="Holmberg Schiavone, Lovisa" userId="bbe6b084-409e-4123-bcbd-da2be00cbc6b" providerId="ADAL" clId="{F2BC4D2E-3AF4-4D40-BAC4-33ECAC74BCBD}" dt="2025-09-24T12:28:03.816" v="265" actId="1076"/>
        <pc:sldMkLst>
          <pc:docMk/>
          <pc:sldMk cId="2571125910" sldId="259"/>
        </pc:sldMkLst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5" creationId="{32DF8740-5BCA-3605-06CA-F6F08F1F560C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7" creationId="{D2DC99FE-EC9A-A798-3C5B-FFC2D23DE4EE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0" creationId="{5FA5A69D-B1D7-2FA5-99BF-2B6A32C8325E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1" creationId="{2C0E6E30-0ECB-05C8-956C-E474CE6F158B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2" creationId="{70AB3D72-EC3A-D06C-D0D4-09419D457DE7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3" creationId="{EF3A2DAA-E69F-E767-FD00-1382F0D3EABC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4" creationId="{E2B67DEA-8E73-C65E-78DB-39BA9D3C7C7A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5" creationId="{229EDD76-327B-F4C0-D53C-0B1D9522CC22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6" creationId="{5141C4E5-B86D-457C-76E1-29E43F3A1D57}"/>
          </ac:spMkLst>
        </pc:spChg>
        <pc:spChg chg="add mod">
          <ac:chgData name="Holmberg Schiavone, Lovisa" userId="bbe6b084-409e-4123-bcbd-da2be00cbc6b" providerId="ADAL" clId="{F2BC4D2E-3AF4-4D40-BAC4-33ECAC74BCBD}" dt="2025-09-24T09:39:09.394" v="12"/>
          <ac:spMkLst>
            <pc:docMk/>
            <pc:sldMk cId="2571125910" sldId="259"/>
            <ac:spMk id="37" creationId="{43A45F7E-D365-1B58-7693-AE3FB57E09D1}"/>
          </ac:spMkLst>
        </pc:spChg>
        <pc:spChg chg="add mod">
          <ac:chgData name="Holmberg Schiavone, Lovisa" userId="bbe6b084-409e-4123-bcbd-da2be00cbc6b" providerId="ADAL" clId="{F2BC4D2E-3AF4-4D40-BAC4-33ECAC74BCBD}" dt="2025-09-24T09:41:56.994" v="70" actId="20577"/>
          <ac:spMkLst>
            <pc:docMk/>
            <pc:sldMk cId="2571125910" sldId="259"/>
            <ac:spMk id="38" creationId="{ED4E30DB-4B06-F0D8-F874-52F8C05EC24E}"/>
          </ac:spMkLst>
        </pc:spChg>
        <pc:cxnChg chg="add mod">
          <ac:chgData name="Holmberg Schiavone, Lovisa" userId="bbe6b084-409e-4123-bcbd-da2be00cbc6b" providerId="ADAL" clId="{F2BC4D2E-3AF4-4D40-BAC4-33ECAC74BCBD}" dt="2025-09-24T12:25:18.116" v="233" actId="1076"/>
          <ac:cxnSpMkLst>
            <pc:docMk/>
            <pc:sldMk cId="2571125910" sldId="259"/>
            <ac:cxnSpMk id="39" creationId="{CCC1DD5F-E722-4955-8EBB-3B7655391CDD}"/>
          </ac:cxnSpMkLst>
        </pc:cxnChg>
        <pc:cxnChg chg="add mod">
          <ac:chgData name="Holmberg Schiavone, Lovisa" userId="bbe6b084-409e-4123-bcbd-da2be00cbc6b" providerId="ADAL" clId="{F2BC4D2E-3AF4-4D40-BAC4-33ECAC74BCBD}" dt="2025-09-24T12:25:37.747" v="235" actId="1076"/>
          <ac:cxnSpMkLst>
            <pc:docMk/>
            <pc:sldMk cId="2571125910" sldId="259"/>
            <ac:cxnSpMk id="40" creationId="{66E780A6-280C-EE23-36C6-FF52A49B155E}"/>
          </ac:cxnSpMkLst>
        </pc:cxnChg>
        <pc:cxnChg chg="add mod">
          <ac:chgData name="Holmberg Schiavone, Lovisa" userId="bbe6b084-409e-4123-bcbd-da2be00cbc6b" providerId="ADAL" clId="{F2BC4D2E-3AF4-4D40-BAC4-33ECAC74BCBD}" dt="2025-09-24T12:25:47.786" v="237" actId="1076"/>
          <ac:cxnSpMkLst>
            <pc:docMk/>
            <pc:sldMk cId="2571125910" sldId="259"/>
            <ac:cxnSpMk id="41" creationId="{03FEDEE1-5FC8-EBA7-0FE5-7F56DA152124}"/>
          </ac:cxnSpMkLst>
        </pc:cxnChg>
        <pc:cxnChg chg="add mod">
          <ac:chgData name="Holmberg Schiavone, Lovisa" userId="bbe6b084-409e-4123-bcbd-da2be00cbc6b" providerId="ADAL" clId="{F2BC4D2E-3AF4-4D40-BAC4-33ECAC74BCBD}" dt="2025-09-24T12:25:57.117" v="239" actId="1076"/>
          <ac:cxnSpMkLst>
            <pc:docMk/>
            <pc:sldMk cId="2571125910" sldId="259"/>
            <ac:cxnSpMk id="42" creationId="{6BF8145F-A042-8892-E128-DF7812BFF208}"/>
          </ac:cxnSpMkLst>
        </pc:cxnChg>
        <pc:cxnChg chg="add mod">
          <ac:chgData name="Holmberg Schiavone, Lovisa" userId="bbe6b084-409e-4123-bcbd-da2be00cbc6b" providerId="ADAL" clId="{F2BC4D2E-3AF4-4D40-BAC4-33ECAC74BCBD}" dt="2025-09-24T12:26:03.797" v="241" actId="1076"/>
          <ac:cxnSpMkLst>
            <pc:docMk/>
            <pc:sldMk cId="2571125910" sldId="259"/>
            <ac:cxnSpMk id="43" creationId="{7DD78D2A-A9CB-0970-42C3-59CE51596A23}"/>
          </ac:cxnSpMkLst>
        </pc:cxnChg>
        <pc:cxnChg chg="add mod">
          <ac:chgData name="Holmberg Schiavone, Lovisa" userId="bbe6b084-409e-4123-bcbd-da2be00cbc6b" providerId="ADAL" clId="{F2BC4D2E-3AF4-4D40-BAC4-33ECAC74BCBD}" dt="2025-09-24T12:26:18.356" v="243" actId="1076"/>
          <ac:cxnSpMkLst>
            <pc:docMk/>
            <pc:sldMk cId="2571125910" sldId="259"/>
            <ac:cxnSpMk id="44" creationId="{5D39A911-F4A5-B89B-CF6C-00E2FBAE784A}"/>
          </ac:cxnSpMkLst>
        </pc:cxnChg>
        <pc:cxnChg chg="add mod">
          <ac:chgData name="Holmberg Schiavone, Lovisa" userId="bbe6b084-409e-4123-bcbd-da2be00cbc6b" providerId="ADAL" clId="{F2BC4D2E-3AF4-4D40-BAC4-33ECAC74BCBD}" dt="2025-09-24T12:26:25.333" v="245" actId="1076"/>
          <ac:cxnSpMkLst>
            <pc:docMk/>
            <pc:sldMk cId="2571125910" sldId="259"/>
            <ac:cxnSpMk id="45" creationId="{15869859-BA16-F814-AE2D-2C7AB0D9FAB6}"/>
          </ac:cxnSpMkLst>
        </pc:cxnChg>
        <pc:cxnChg chg="add mod">
          <ac:chgData name="Holmberg Schiavone, Lovisa" userId="bbe6b084-409e-4123-bcbd-da2be00cbc6b" providerId="ADAL" clId="{F2BC4D2E-3AF4-4D40-BAC4-33ECAC74BCBD}" dt="2025-09-24T12:26:31.586" v="247" actId="1076"/>
          <ac:cxnSpMkLst>
            <pc:docMk/>
            <pc:sldMk cId="2571125910" sldId="259"/>
            <ac:cxnSpMk id="46" creationId="{C188B769-FD75-A990-02C0-4DECA6D7D19A}"/>
          </ac:cxnSpMkLst>
        </pc:cxnChg>
        <pc:cxnChg chg="add mod">
          <ac:chgData name="Holmberg Schiavone, Lovisa" userId="bbe6b084-409e-4123-bcbd-da2be00cbc6b" providerId="ADAL" clId="{F2BC4D2E-3AF4-4D40-BAC4-33ECAC74BCBD}" dt="2025-09-24T12:26:38.796" v="249" actId="1076"/>
          <ac:cxnSpMkLst>
            <pc:docMk/>
            <pc:sldMk cId="2571125910" sldId="259"/>
            <ac:cxnSpMk id="47" creationId="{5F98A461-57CB-4FDF-407D-5000768A1BA6}"/>
          </ac:cxnSpMkLst>
        </pc:cxnChg>
        <pc:cxnChg chg="add mod">
          <ac:chgData name="Holmberg Schiavone, Lovisa" userId="bbe6b084-409e-4123-bcbd-da2be00cbc6b" providerId="ADAL" clId="{F2BC4D2E-3AF4-4D40-BAC4-33ECAC74BCBD}" dt="2025-09-24T12:26:55.139" v="251" actId="1076"/>
          <ac:cxnSpMkLst>
            <pc:docMk/>
            <pc:sldMk cId="2571125910" sldId="259"/>
            <ac:cxnSpMk id="48" creationId="{37FDB0FA-067D-EBE5-D97E-AFDB37967826}"/>
          </ac:cxnSpMkLst>
        </pc:cxnChg>
        <pc:cxnChg chg="add mod">
          <ac:chgData name="Holmberg Schiavone, Lovisa" userId="bbe6b084-409e-4123-bcbd-da2be00cbc6b" providerId="ADAL" clId="{F2BC4D2E-3AF4-4D40-BAC4-33ECAC74BCBD}" dt="2025-09-24T12:27:04.139" v="253" actId="1076"/>
          <ac:cxnSpMkLst>
            <pc:docMk/>
            <pc:sldMk cId="2571125910" sldId="259"/>
            <ac:cxnSpMk id="49" creationId="{CCE2459C-5AB1-0EFC-F39F-425019F6E3A7}"/>
          </ac:cxnSpMkLst>
        </pc:cxnChg>
        <pc:cxnChg chg="add mod">
          <ac:chgData name="Holmberg Schiavone, Lovisa" userId="bbe6b084-409e-4123-bcbd-da2be00cbc6b" providerId="ADAL" clId="{F2BC4D2E-3AF4-4D40-BAC4-33ECAC74BCBD}" dt="2025-09-24T12:27:12.890" v="255" actId="1076"/>
          <ac:cxnSpMkLst>
            <pc:docMk/>
            <pc:sldMk cId="2571125910" sldId="259"/>
            <ac:cxnSpMk id="50" creationId="{B3D5D8C3-F6B4-61E4-D16D-A37483C8587D}"/>
          </ac:cxnSpMkLst>
        </pc:cxnChg>
        <pc:cxnChg chg="add mod">
          <ac:chgData name="Holmberg Schiavone, Lovisa" userId="bbe6b084-409e-4123-bcbd-da2be00cbc6b" providerId="ADAL" clId="{F2BC4D2E-3AF4-4D40-BAC4-33ECAC74BCBD}" dt="2025-09-24T12:27:21.475" v="257" actId="1076"/>
          <ac:cxnSpMkLst>
            <pc:docMk/>
            <pc:sldMk cId="2571125910" sldId="259"/>
            <ac:cxnSpMk id="51" creationId="{2E2F6752-7493-F29B-C971-5E6ED6D23391}"/>
          </ac:cxnSpMkLst>
        </pc:cxnChg>
        <pc:cxnChg chg="add mod">
          <ac:chgData name="Holmberg Schiavone, Lovisa" userId="bbe6b084-409e-4123-bcbd-da2be00cbc6b" providerId="ADAL" clId="{F2BC4D2E-3AF4-4D40-BAC4-33ECAC74BCBD}" dt="2025-09-24T12:27:35.155" v="259" actId="1076"/>
          <ac:cxnSpMkLst>
            <pc:docMk/>
            <pc:sldMk cId="2571125910" sldId="259"/>
            <ac:cxnSpMk id="52" creationId="{EC5BFDB2-1C1A-F56C-76E6-7E7773512F48}"/>
          </ac:cxnSpMkLst>
        </pc:cxnChg>
        <pc:cxnChg chg="add mod">
          <ac:chgData name="Holmberg Schiavone, Lovisa" userId="bbe6b084-409e-4123-bcbd-da2be00cbc6b" providerId="ADAL" clId="{F2BC4D2E-3AF4-4D40-BAC4-33ECAC74BCBD}" dt="2025-09-24T12:27:46.036" v="261" actId="1076"/>
          <ac:cxnSpMkLst>
            <pc:docMk/>
            <pc:sldMk cId="2571125910" sldId="259"/>
            <ac:cxnSpMk id="53" creationId="{56E94ED7-2A50-2794-5BDF-5E4A873A4C63}"/>
          </ac:cxnSpMkLst>
        </pc:cxnChg>
        <pc:cxnChg chg="add mod">
          <ac:chgData name="Holmberg Schiavone, Lovisa" userId="bbe6b084-409e-4123-bcbd-da2be00cbc6b" providerId="ADAL" clId="{F2BC4D2E-3AF4-4D40-BAC4-33ECAC74BCBD}" dt="2025-09-24T12:27:55.333" v="263" actId="1076"/>
          <ac:cxnSpMkLst>
            <pc:docMk/>
            <pc:sldMk cId="2571125910" sldId="259"/>
            <ac:cxnSpMk id="54" creationId="{F7A62C2B-EF80-CC53-760D-C935E85B05BC}"/>
          </ac:cxnSpMkLst>
        </pc:cxnChg>
        <pc:cxnChg chg="add mod">
          <ac:chgData name="Holmberg Schiavone, Lovisa" userId="bbe6b084-409e-4123-bcbd-da2be00cbc6b" providerId="ADAL" clId="{F2BC4D2E-3AF4-4D40-BAC4-33ECAC74BCBD}" dt="2025-09-24T12:28:03.816" v="265" actId="1076"/>
          <ac:cxnSpMkLst>
            <pc:docMk/>
            <pc:sldMk cId="2571125910" sldId="259"/>
            <ac:cxnSpMk id="55" creationId="{2F98A610-58E4-6B1D-A78B-3E06D20E2ABC}"/>
          </ac:cxnSpMkLst>
        </pc:cxnChg>
      </pc:sldChg>
      <pc:sldChg chg="addSp modSp add">
        <pc:chgData name="Holmberg Schiavone, Lovisa" userId="bbe6b084-409e-4123-bcbd-da2be00cbc6b" providerId="ADAL" clId="{F2BC4D2E-3AF4-4D40-BAC4-33ECAC74BCBD}" dt="2025-09-24T09:35:40.289" v="6"/>
        <pc:sldMkLst>
          <pc:docMk/>
          <pc:sldMk cId="625961511" sldId="260"/>
        </pc:sldMkLst>
        <pc:spChg chg="mod">
          <ac:chgData name="Holmberg Schiavone, Lovisa" userId="bbe6b084-409e-4123-bcbd-da2be00cbc6b" providerId="ADAL" clId="{F2BC4D2E-3AF4-4D40-BAC4-33ECAC74BCBD}" dt="2025-09-24T09:35:40.289" v="6"/>
          <ac:spMkLst>
            <pc:docMk/>
            <pc:sldMk cId="625961511" sldId="260"/>
            <ac:spMk id="7" creationId="{8C28CCF6-1BB4-126B-DD04-91317434C156}"/>
          </ac:spMkLst>
        </pc:spChg>
        <pc:spChg chg="mod">
          <ac:chgData name="Holmberg Schiavone, Lovisa" userId="bbe6b084-409e-4123-bcbd-da2be00cbc6b" providerId="ADAL" clId="{F2BC4D2E-3AF4-4D40-BAC4-33ECAC74BCBD}" dt="2025-09-24T09:35:40.289" v="6"/>
          <ac:spMkLst>
            <pc:docMk/>
            <pc:sldMk cId="625961511" sldId="260"/>
            <ac:spMk id="10" creationId="{2C050CE9-6ED8-0E10-EFDA-590296C0478E}"/>
          </ac:spMkLst>
        </pc:sp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3" creationId="{DCAA45A5-0437-722C-A1DA-866DE6C7791E}"/>
          </ac:picMkLst>
        </pc:pic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4" creationId="{1B253CAD-7EF3-D428-859D-6FAB0BEF9BCA}"/>
          </ac:picMkLst>
        </pc:pic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5" creationId="{DA11EB30-B3CE-6A4B-297C-144566E65632}"/>
          </ac:picMkLst>
        </pc:pic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6" creationId="{7BDDF24F-82E6-1CEE-7E12-1BF4D184EABA}"/>
          </ac:picMkLst>
        </pc:pic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9" creationId="{3F00F6EE-E652-693E-4064-20452244BCE1}"/>
          </ac:picMkLst>
        </pc:pic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11" creationId="{8019E42E-891D-425D-E2B5-1BA282357FCC}"/>
          </ac:picMkLst>
        </pc:pic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12" creationId="{D1659CC8-2243-A8F8-AF70-72DED20B6297}"/>
          </ac:picMkLst>
        </pc:picChg>
        <pc:picChg chg="mod">
          <ac:chgData name="Holmberg Schiavone, Lovisa" userId="bbe6b084-409e-4123-bcbd-da2be00cbc6b" providerId="ADAL" clId="{F2BC4D2E-3AF4-4D40-BAC4-33ECAC74BCBD}" dt="2025-09-24T09:35:40.289" v="6"/>
          <ac:picMkLst>
            <pc:docMk/>
            <pc:sldMk cId="625961511" sldId="260"/>
            <ac:picMk id="13" creationId="{82F00BE3-2767-2524-3EC6-F890241B02B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5D23267-8BED-F9B5-258E-E768458D586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24AEAA-D73E-5693-2B56-E8E63DE2ED6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68146FA-E258-6CA1-C114-FA73876091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2DD46E-B6B0-7CD5-3173-71547F170B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DFEB93-6A00-B467-4936-40AB0569F8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210846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C0DD582-7EC3-C3FE-A7D0-4107EF7C08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CEBAD0E-4F75-F7BE-8EED-F3FF10717E1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95DCFA-7C11-9583-FE20-71308DF486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49412EE-5E99-E62E-9297-342C02DEA9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B9C91EE-DDE4-AC9B-362F-A5AB48452C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834081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FC85D1-3D4E-25FD-C11D-A527909C6D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D0D5F03-0463-D530-9858-D1298F8C9EB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0777082-FF5F-E12C-AA78-0C8E53A3B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8963FB-544A-4083-01F7-B7CFE1CBC7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38B0AB-B3D3-5C9C-0B75-4C3AE29F79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952789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825551-090D-12A6-4B5D-CFE82451147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2C3F70-F74B-1B95-4985-258E817BAE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8F90E6C-21D5-2516-E008-89652673E5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79EAF7-520F-7610-CBBD-A7FC570EB0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AAA25C-CE4E-08F8-4296-3FE8BDA83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224525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DF066B-A877-5407-13D9-6E6CE2D8F7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A66CD9F-FEC1-0E4C-8BE3-67D9E01B12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30A76E-B35E-979D-558B-A95E6C8156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122F85-52A9-4B9A-38D7-E53AF30077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DFA5C19-978C-3962-28E8-E0B96F553C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6967245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37023-6940-005C-453F-855327948D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53F9A46-D3CE-65FD-C3A6-C55B999C614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03FE41-E860-54FE-9B23-85B7D43C3B0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E61748F-0738-761A-0426-7DBBB89CFC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D20A28-BB7C-1444-E70F-D5267AE4F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77DB510-040F-EE82-8767-9394D364B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232162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38ACA1-07E6-9E1E-4B28-2069C41870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C953C2-E42E-90D5-0ADF-9C9B3A2993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A6074B2-CF34-D566-D8A7-1EF6E6B6F4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E99CBE3-A7D9-739B-EB31-663DD8F89BA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195D38-E45C-1C5F-4F97-1D28354656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9F49A68-4BE4-DC68-3E91-CE3576D13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34B02A-FB74-7DAE-A0F0-D54F47A15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85A597-8371-726B-C67B-27FA841B27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41575739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5D66B4-AA09-636C-C506-F11FEF0372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B86EB97-1A9D-B656-BDB5-A23F2CE280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0768BB4-27A4-C1BA-3FB0-324F05AF0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AC59AEA-80D0-EF48-6E35-57EACBBBD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317341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9478569-2642-12CA-AD63-0104841FE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8E9C296-206B-774B-8A18-5EA3F083C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859293-0EB8-E367-0D4F-07FB87D438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433874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F0E670-92B6-1EE6-AC91-24D4F1DF91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803CE30-8B02-20C0-745A-7ADA9AEC6E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E199C6A-1695-878B-6E1F-AC73A33375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A213D11-C0E4-C48E-4E5D-E5F5610E90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C5C9FE-FAC5-07D3-68B9-93A90D29F7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EC326F2-E86D-1CEE-4C7B-05444B0D3F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14082243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BC5C2E-A5D4-1111-BF3D-8803A554DB5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331C32-6DA6-4E82-4CD0-AEA3B4CD853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D91ED2E-1261-F7D9-790A-9C0BA7D072D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5989DB-835F-2BF9-617F-026EBEF1B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972BE7F-6986-00E9-E856-24B9A8D888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38E794-7DC9-7906-9278-BD32D23342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3673430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75C6645-3FD2-BA18-5FD0-CFCF288391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2E106E-349F-B315-D02A-D8B487501A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B07588-88FC-BE64-3303-F0723A320F7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E9E10C1-41BA-4BED-B968-6C1F4A7EDD97}" type="datetimeFigureOut">
              <a:rPr lang="en-SE" smtClean="0"/>
              <a:t>9/29/25</a:t>
            </a:fld>
            <a:endParaRPr lang="en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16F4AB3-171B-52CA-90CB-37FC840524A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15C93C-6E5B-CEF7-D044-24EA4C6E55A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92D5596-787F-4C38-9D89-71D3B0C6D81B}" type="slidenum">
              <a:rPr lang="en-SE" smtClean="0"/>
              <a:t>‹#›</a:t>
            </a:fld>
            <a:endParaRPr lang="en-SE"/>
          </a:p>
        </p:txBody>
      </p:sp>
    </p:spTree>
    <p:extLst>
      <p:ext uri="{BB962C8B-B14F-4D97-AF65-F5344CB8AC3E}">
        <p14:creationId xmlns:p14="http://schemas.microsoft.com/office/powerpoint/2010/main" val="2179750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1.jpg"/><Relationship Id="rId5" Type="http://schemas.openxmlformats.org/officeDocument/2006/relationships/image" Target="../media/image10.jpg"/><Relationship Id="rId4" Type="http://schemas.openxmlformats.org/officeDocument/2006/relationships/image" Target="../media/image9.jp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jpg"/><Relationship Id="rId3" Type="http://schemas.openxmlformats.org/officeDocument/2006/relationships/image" Target="../media/image12.jpg"/><Relationship Id="rId7" Type="http://schemas.openxmlformats.org/officeDocument/2006/relationships/image" Target="../media/image1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5.jpg"/><Relationship Id="rId5" Type="http://schemas.openxmlformats.org/officeDocument/2006/relationships/image" Target="../media/image14.jpg"/><Relationship Id="rId4" Type="http://schemas.openxmlformats.org/officeDocument/2006/relationships/image" Target="../media/image13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1.jpg"/><Relationship Id="rId5" Type="http://schemas.openxmlformats.org/officeDocument/2006/relationships/image" Target="../media/image20.jpg"/><Relationship Id="rId4" Type="http://schemas.openxmlformats.org/officeDocument/2006/relationships/image" Target="../media/image19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6" name="Group 15">
            <a:extLst>
              <a:ext uri="{FF2B5EF4-FFF2-40B4-BE49-F238E27FC236}">
                <a16:creationId xmlns:a16="http://schemas.microsoft.com/office/drawing/2014/main" id="{491461F4-A9AD-7D99-C383-F89646E12C55}"/>
              </a:ext>
            </a:extLst>
          </p:cNvPr>
          <p:cNvGrpSpPr/>
          <p:nvPr/>
        </p:nvGrpSpPr>
        <p:grpSpPr>
          <a:xfrm>
            <a:off x="368313" y="774382"/>
            <a:ext cx="9291326" cy="2768918"/>
            <a:chOff x="368313" y="774382"/>
            <a:chExt cx="9291326" cy="2768918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CE47B156-26DB-BCC1-2324-BA1297D2A18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313" y="984965"/>
              <a:ext cx="514083" cy="2558335"/>
            </a:xfrm>
            <a:prstGeom prst="rect">
              <a:avLst/>
            </a:prstGeom>
          </p:spPr>
        </p:pic>
        <p:pic>
          <p:nvPicPr>
            <p:cNvPr id="18" name="Picture 17" descr="A close-up of a dna sequence&#10;&#10;Description automatically generated">
              <a:extLst>
                <a:ext uri="{FF2B5EF4-FFF2-40B4-BE49-F238E27FC236}">
                  <a16:creationId xmlns:a16="http://schemas.microsoft.com/office/drawing/2014/main" id="{397C2ABA-28CC-449B-8D3F-2CB1F3E8601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2396" y="1018785"/>
              <a:ext cx="2883408" cy="2462784"/>
            </a:xfrm>
            <a:prstGeom prst="rect">
              <a:avLst/>
            </a:prstGeom>
          </p:spPr>
        </p:pic>
        <p:pic>
          <p:nvPicPr>
            <p:cNvPr id="19" name="Picture 18" descr="A close-up of a dna test&#10;&#10;Description automatically generated">
              <a:extLst>
                <a:ext uri="{FF2B5EF4-FFF2-40B4-BE49-F238E27FC236}">
                  <a16:creationId xmlns:a16="http://schemas.microsoft.com/office/drawing/2014/main" id="{04F835A0-7516-234C-995F-FF1751BF505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65804" y="1015737"/>
              <a:ext cx="2877312" cy="2465832"/>
            </a:xfrm>
            <a:prstGeom prst="rect">
              <a:avLst/>
            </a:prstGeom>
          </p:spPr>
        </p:pic>
        <p:pic>
          <p:nvPicPr>
            <p:cNvPr id="20" name="Picture 19" descr="A close-up of a dna strand&#10;&#10;Description automatically generated">
              <a:extLst>
                <a:ext uri="{FF2B5EF4-FFF2-40B4-BE49-F238E27FC236}">
                  <a16:creationId xmlns:a16="http://schemas.microsoft.com/office/drawing/2014/main" id="{9C7361C7-ED46-7E37-5875-C4BA87B7890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643116" y="984965"/>
              <a:ext cx="2892552" cy="2496312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B36BAC68-7D4A-1FC5-E775-079A74FC8698}"/>
                </a:ext>
              </a:extLst>
            </p:cNvPr>
            <p:cNvSpPr txBox="1"/>
            <p:nvPr/>
          </p:nvSpPr>
          <p:spPr>
            <a:xfrm>
              <a:off x="1079405" y="774382"/>
              <a:ext cx="8580234" cy="2862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>
                <a:lnSpc>
                  <a:spcPct val="90000"/>
                </a:lnSpc>
                <a:spcAft>
                  <a:spcPts val="600"/>
                </a:spcAft>
              </a:pPr>
              <a:r>
                <a:rPr lang="en-US" sz="1400" dirty="0"/>
                <a:t> 1   2    3    4    5   6    7   8    9   10              11 12 13  14 15 16  17 18  19 20               21 22 23  24 25  26 27  28  29 30</a:t>
              </a:r>
              <a:endParaRPr lang="en-SE" sz="1400" dirty="0" err="1"/>
            </a:p>
          </p:txBody>
        </p:sp>
      </p:grpSp>
      <p:grpSp>
        <p:nvGrpSpPr>
          <p:cNvPr id="22" name="Group 21">
            <a:extLst>
              <a:ext uri="{FF2B5EF4-FFF2-40B4-BE49-F238E27FC236}">
                <a16:creationId xmlns:a16="http://schemas.microsoft.com/office/drawing/2014/main" id="{0A11ED40-6253-46AA-DF25-57DFFD4C7E0A}"/>
              </a:ext>
            </a:extLst>
          </p:cNvPr>
          <p:cNvGrpSpPr/>
          <p:nvPr/>
        </p:nvGrpSpPr>
        <p:grpSpPr>
          <a:xfrm>
            <a:off x="368312" y="3563765"/>
            <a:ext cx="9291327" cy="2677968"/>
            <a:chOff x="368312" y="3563765"/>
            <a:chExt cx="9291327" cy="2677968"/>
          </a:xfrm>
        </p:grpSpPr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C735D109-3147-89C9-2373-FABDFFDB501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312" y="3738793"/>
              <a:ext cx="514083" cy="2447545"/>
            </a:xfrm>
            <a:prstGeom prst="rect">
              <a:avLst/>
            </a:prstGeom>
          </p:spPr>
        </p:pic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C466D743-2412-CB2C-0633-8D1B4993CD5C}"/>
                </a:ext>
              </a:extLst>
            </p:cNvPr>
            <p:cNvSpPr txBox="1"/>
            <p:nvPr/>
          </p:nvSpPr>
          <p:spPr>
            <a:xfrm>
              <a:off x="1079405" y="3563765"/>
              <a:ext cx="8580234" cy="2862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>
                <a:lnSpc>
                  <a:spcPct val="90000"/>
                </a:lnSpc>
                <a:spcAft>
                  <a:spcPts val="600"/>
                </a:spcAft>
              </a:pPr>
              <a:r>
                <a:rPr lang="en-US" sz="1400" dirty="0"/>
                <a:t> 1   2    3    4    5   6    7   8    9   10            11 12 13  14 15 16  17 18  19 20              21 22 23  24 25  26 27  28  29 30</a:t>
              </a:r>
              <a:endParaRPr lang="en-SE" sz="1400" dirty="0" err="1"/>
            </a:p>
          </p:txBody>
        </p:sp>
        <p:pic>
          <p:nvPicPr>
            <p:cNvPr id="25" name="Picture 24" descr="A close-up of a dna&#10;&#10;AI-generated content may be incorrect.">
              <a:extLst>
                <a:ext uri="{FF2B5EF4-FFF2-40B4-BE49-F238E27FC236}">
                  <a16:creationId xmlns:a16="http://schemas.microsoft.com/office/drawing/2014/main" id="{40CFCAE9-C95B-72A1-3787-2DD848E8AB01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82395" y="3794189"/>
              <a:ext cx="2852928" cy="2447544"/>
            </a:xfrm>
            <a:prstGeom prst="rect">
              <a:avLst/>
            </a:prstGeom>
          </p:spPr>
        </p:pic>
        <p:pic>
          <p:nvPicPr>
            <p:cNvPr id="26" name="Picture 25" descr="A close-up of a dna test&#10;&#10;AI-generated content may be incorrect.">
              <a:extLst>
                <a:ext uri="{FF2B5EF4-FFF2-40B4-BE49-F238E27FC236}">
                  <a16:creationId xmlns:a16="http://schemas.microsoft.com/office/drawing/2014/main" id="{C35B8E03-37D4-2CD1-CAA8-F75FD79D90A3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5323" y="3785387"/>
              <a:ext cx="2834640" cy="2450592"/>
            </a:xfrm>
            <a:prstGeom prst="rect">
              <a:avLst/>
            </a:prstGeom>
          </p:spPr>
        </p:pic>
        <p:pic>
          <p:nvPicPr>
            <p:cNvPr id="27" name="Picture 26" descr="A close-up of a dna test&#10;&#10;AI-generated content may be incorrect.">
              <a:extLst>
                <a:ext uri="{FF2B5EF4-FFF2-40B4-BE49-F238E27FC236}">
                  <a16:creationId xmlns:a16="http://schemas.microsoft.com/office/drawing/2014/main" id="{C5F3BF7E-865F-7962-4103-0F972B6C4295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631"/>
            <a:stretch/>
          </p:blipFill>
          <p:spPr>
            <a:xfrm>
              <a:off x="6569963" y="3785386"/>
              <a:ext cx="2822448" cy="2400951"/>
            </a:xfrm>
            <a:prstGeom prst="rect">
              <a:avLst/>
            </a:prstGeom>
          </p:spPr>
        </p:pic>
      </p:grp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55C9544E-8DF3-4160-951B-7D0F5EE26B0D}"/>
              </a:ext>
            </a:extLst>
          </p:cNvPr>
          <p:cNvCxnSpPr>
            <a:cxnSpLocks/>
          </p:cNvCxnSpPr>
          <p:nvPr/>
        </p:nvCxnSpPr>
        <p:spPr>
          <a:xfrm>
            <a:off x="1079405" y="249882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D982CB84-1BDE-AED6-75C2-3A058A8F1474}"/>
              </a:ext>
            </a:extLst>
          </p:cNvPr>
          <p:cNvCxnSpPr>
            <a:cxnSpLocks/>
          </p:cNvCxnSpPr>
          <p:nvPr/>
        </p:nvCxnSpPr>
        <p:spPr>
          <a:xfrm>
            <a:off x="1344147" y="249882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1DB69D6B-61BA-06E9-E395-CEBBA8AF69A3}"/>
              </a:ext>
            </a:extLst>
          </p:cNvPr>
          <p:cNvCxnSpPr>
            <a:cxnSpLocks/>
          </p:cNvCxnSpPr>
          <p:nvPr/>
        </p:nvCxnSpPr>
        <p:spPr>
          <a:xfrm>
            <a:off x="1504226" y="240674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F77C4C16-A77C-3702-2C5F-462DA545B989}"/>
              </a:ext>
            </a:extLst>
          </p:cNvPr>
          <p:cNvCxnSpPr>
            <a:cxnSpLocks/>
          </p:cNvCxnSpPr>
          <p:nvPr/>
        </p:nvCxnSpPr>
        <p:spPr>
          <a:xfrm>
            <a:off x="1858230" y="265766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CE63A0B6-CE32-AEA5-379A-EF23734C8203}"/>
              </a:ext>
            </a:extLst>
          </p:cNvPr>
          <p:cNvCxnSpPr>
            <a:cxnSpLocks/>
          </p:cNvCxnSpPr>
          <p:nvPr/>
        </p:nvCxnSpPr>
        <p:spPr>
          <a:xfrm>
            <a:off x="2067780" y="276334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4F3C32DB-E257-2D1E-66E9-8545A31B8680}"/>
              </a:ext>
            </a:extLst>
          </p:cNvPr>
          <p:cNvCxnSpPr>
            <a:cxnSpLocks/>
          </p:cNvCxnSpPr>
          <p:nvPr/>
        </p:nvCxnSpPr>
        <p:spPr>
          <a:xfrm>
            <a:off x="2308859" y="240674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E9C5D77C-864D-AA01-AF11-A39F069734A7}"/>
              </a:ext>
            </a:extLst>
          </p:cNvPr>
          <p:cNvCxnSpPr>
            <a:cxnSpLocks/>
          </p:cNvCxnSpPr>
          <p:nvPr/>
        </p:nvCxnSpPr>
        <p:spPr>
          <a:xfrm>
            <a:off x="2582683" y="274676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6B5D61C4-39BF-B118-2621-AAF0B43DD47C}"/>
              </a:ext>
            </a:extLst>
          </p:cNvPr>
          <p:cNvCxnSpPr>
            <a:cxnSpLocks/>
          </p:cNvCxnSpPr>
          <p:nvPr/>
        </p:nvCxnSpPr>
        <p:spPr>
          <a:xfrm>
            <a:off x="2812017" y="280183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3D06C842-4E74-2C19-580C-B58361B0316A}"/>
              </a:ext>
            </a:extLst>
          </p:cNvPr>
          <p:cNvCxnSpPr>
            <a:cxnSpLocks/>
          </p:cNvCxnSpPr>
          <p:nvPr/>
        </p:nvCxnSpPr>
        <p:spPr>
          <a:xfrm>
            <a:off x="2985000" y="164160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B9DEE32F-44A9-AF90-A48F-FEA48B3AD49D}"/>
              </a:ext>
            </a:extLst>
          </p:cNvPr>
          <p:cNvCxnSpPr>
            <a:cxnSpLocks/>
          </p:cNvCxnSpPr>
          <p:nvPr/>
        </p:nvCxnSpPr>
        <p:spPr>
          <a:xfrm>
            <a:off x="3270739" y="158291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A9DA32C3-71DF-9AC8-5744-4D7AE7924C9A}"/>
              </a:ext>
            </a:extLst>
          </p:cNvPr>
          <p:cNvCxnSpPr>
            <a:cxnSpLocks/>
          </p:cNvCxnSpPr>
          <p:nvPr/>
        </p:nvCxnSpPr>
        <p:spPr>
          <a:xfrm>
            <a:off x="3958794" y="231467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3063EF3A-886A-DB79-4349-429F5D3B9815}"/>
              </a:ext>
            </a:extLst>
          </p:cNvPr>
          <p:cNvCxnSpPr>
            <a:cxnSpLocks/>
          </p:cNvCxnSpPr>
          <p:nvPr/>
        </p:nvCxnSpPr>
        <p:spPr>
          <a:xfrm>
            <a:off x="4227555" y="222011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9FCB3DF8-5E0F-CC76-1440-F8EDBCB14BAB}"/>
              </a:ext>
            </a:extLst>
          </p:cNvPr>
          <p:cNvCxnSpPr>
            <a:cxnSpLocks/>
          </p:cNvCxnSpPr>
          <p:nvPr/>
        </p:nvCxnSpPr>
        <p:spPr>
          <a:xfrm>
            <a:off x="4510265" y="165431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70C30B07-288C-AEE1-2069-E3269A768F5D}"/>
              </a:ext>
            </a:extLst>
          </p:cNvPr>
          <p:cNvCxnSpPr>
            <a:cxnSpLocks/>
          </p:cNvCxnSpPr>
          <p:nvPr/>
        </p:nvCxnSpPr>
        <p:spPr>
          <a:xfrm>
            <a:off x="4727566" y="164715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AA02AB78-3A1E-4F83-4FD6-C82411CF861E}"/>
              </a:ext>
            </a:extLst>
          </p:cNvPr>
          <p:cNvCxnSpPr>
            <a:cxnSpLocks/>
          </p:cNvCxnSpPr>
          <p:nvPr/>
        </p:nvCxnSpPr>
        <p:spPr>
          <a:xfrm>
            <a:off x="4952998" y="182272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2E738670-FC2F-7882-8F71-0195177A4CC6}"/>
              </a:ext>
            </a:extLst>
          </p:cNvPr>
          <p:cNvCxnSpPr>
            <a:cxnSpLocks/>
          </p:cNvCxnSpPr>
          <p:nvPr/>
        </p:nvCxnSpPr>
        <p:spPr>
          <a:xfrm>
            <a:off x="5205435" y="179982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B66CEA58-49DA-FC47-3A0C-21029C2C404B}"/>
              </a:ext>
            </a:extLst>
          </p:cNvPr>
          <p:cNvCxnSpPr>
            <a:cxnSpLocks/>
          </p:cNvCxnSpPr>
          <p:nvPr/>
        </p:nvCxnSpPr>
        <p:spPr>
          <a:xfrm>
            <a:off x="5437328" y="173923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CFBFC4C1-FCDD-54F0-C2BC-790E9CC36331}"/>
              </a:ext>
            </a:extLst>
          </p:cNvPr>
          <p:cNvCxnSpPr>
            <a:cxnSpLocks/>
          </p:cNvCxnSpPr>
          <p:nvPr/>
        </p:nvCxnSpPr>
        <p:spPr>
          <a:xfrm>
            <a:off x="5662760" y="185480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98FF4E89-7982-36F2-39E5-0F7C35F329EF}"/>
              </a:ext>
            </a:extLst>
          </p:cNvPr>
          <p:cNvCxnSpPr>
            <a:cxnSpLocks/>
          </p:cNvCxnSpPr>
          <p:nvPr/>
        </p:nvCxnSpPr>
        <p:spPr>
          <a:xfrm>
            <a:off x="5888192" y="182979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52839A73-0745-46E8-89F4-82015F4CF3C3}"/>
              </a:ext>
            </a:extLst>
          </p:cNvPr>
          <p:cNvCxnSpPr>
            <a:cxnSpLocks/>
          </p:cNvCxnSpPr>
          <p:nvPr/>
        </p:nvCxnSpPr>
        <p:spPr>
          <a:xfrm>
            <a:off x="6113469" y="166152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64BC563B-EDB7-4622-4490-447EC053A2B4}"/>
              </a:ext>
            </a:extLst>
          </p:cNvPr>
          <p:cNvCxnSpPr>
            <a:cxnSpLocks/>
          </p:cNvCxnSpPr>
          <p:nvPr/>
        </p:nvCxnSpPr>
        <p:spPr>
          <a:xfrm>
            <a:off x="6893334" y="164160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56375482-E45D-00B7-A61E-156C4CD41EF5}"/>
              </a:ext>
            </a:extLst>
          </p:cNvPr>
          <p:cNvCxnSpPr>
            <a:cxnSpLocks/>
          </p:cNvCxnSpPr>
          <p:nvPr/>
        </p:nvCxnSpPr>
        <p:spPr>
          <a:xfrm>
            <a:off x="7154722" y="183846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96B37037-8E51-FCDA-41E6-9D0D1EDE499E}"/>
              </a:ext>
            </a:extLst>
          </p:cNvPr>
          <p:cNvCxnSpPr>
            <a:cxnSpLocks/>
          </p:cNvCxnSpPr>
          <p:nvPr/>
        </p:nvCxnSpPr>
        <p:spPr>
          <a:xfrm>
            <a:off x="7368559" y="183358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431F2C48-5FB1-6EA1-E3E4-BE2755A5E75F}"/>
              </a:ext>
            </a:extLst>
          </p:cNvPr>
          <p:cNvCxnSpPr>
            <a:cxnSpLocks/>
          </p:cNvCxnSpPr>
          <p:nvPr/>
        </p:nvCxnSpPr>
        <p:spPr>
          <a:xfrm>
            <a:off x="7612047" y="172783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5C23BC6C-3AFC-4D90-D367-C122950234ED}"/>
              </a:ext>
            </a:extLst>
          </p:cNvPr>
          <p:cNvCxnSpPr>
            <a:cxnSpLocks/>
          </p:cNvCxnSpPr>
          <p:nvPr/>
        </p:nvCxnSpPr>
        <p:spPr>
          <a:xfrm>
            <a:off x="7852889" y="177084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FF336DD0-308C-ECE3-52F8-A948E0722BB3}"/>
              </a:ext>
            </a:extLst>
          </p:cNvPr>
          <p:cNvCxnSpPr>
            <a:cxnSpLocks/>
          </p:cNvCxnSpPr>
          <p:nvPr/>
        </p:nvCxnSpPr>
        <p:spPr>
          <a:xfrm>
            <a:off x="7977233" y="247351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E9CA6B72-3291-1848-4984-5509F8CAA2B8}"/>
              </a:ext>
            </a:extLst>
          </p:cNvPr>
          <p:cNvCxnSpPr>
            <a:cxnSpLocks/>
          </p:cNvCxnSpPr>
          <p:nvPr/>
        </p:nvCxnSpPr>
        <p:spPr>
          <a:xfrm>
            <a:off x="8253397" y="237522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B01686BE-D05E-F4B2-C83A-27A56CC7D03F}"/>
              </a:ext>
            </a:extLst>
          </p:cNvPr>
          <p:cNvCxnSpPr>
            <a:cxnSpLocks/>
          </p:cNvCxnSpPr>
          <p:nvPr/>
        </p:nvCxnSpPr>
        <p:spPr>
          <a:xfrm>
            <a:off x="8540072" y="193067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55B85619-B435-7BFB-3A92-E65D9CEF5EF2}"/>
              </a:ext>
            </a:extLst>
          </p:cNvPr>
          <p:cNvCxnSpPr>
            <a:cxnSpLocks/>
          </p:cNvCxnSpPr>
          <p:nvPr/>
        </p:nvCxnSpPr>
        <p:spPr>
          <a:xfrm>
            <a:off x="8807893" y="186292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EC7278BE-7928-9788-F14B-B66636B307B8}"/>
              </a:ext>
            </a:extLst>
          </p:cNvPr>
          <p:cNvCxnSpPr>
            <a:cxnSpLocks/>
          </p:cNvCxnSpPr>
          <p:nvPr/>
        </p:nvCxnSpPr>
        <p:spPr>
          <a:xfrm>
            <a:off x="9037870" y="183846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DA516128-457B-CEC0-6104-FD691E08CA15}"/>
              </a:ext>
            </a:extLst>
          </p:cNvPr>
          <p:cNvSpPr txBox="1"/>
          <p:nvPr/>
        </p:nvSpPr>
        <p:spPr>
          <a:xfrm>
            <a:off x="854757" y="781600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A1C6EB75-DFC5-9196-D9BB-DAE9FF8E5AF5}"/>
              </a:ext>
            </a:extLst>
          </p:cNvPr>
          <p:cNvSpPr txBox="1"/>
          <p:nvPr/>
        </p:nvSpPr>
        <p:spPr>
          <a:xfrm>
            <a:off x="3721636" y="779951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D6AC0E7D-C03F-905B-305C-A47A986D59F9}"/>
              </a:ext>
            </a:extLst>
          </p:cNvPr>
          <p:cNvSpPr txBox="1"/>
          <p:nvPr/>
        </p:nvSpPr>
        <p:spPr>
          <a:xfrm>
            <a:off x="6611251" y="779951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6F01C05C-E0C3-5A79-4E8E-0472FDD6101C}"/>
              </a:ext>
            </a:extLst>
          </p:cNvPr>
          <p:cNvSpPr txBox="1"/>
          <p:nvPr/>
        </p:nvSpPr>
        <p:spPr>
          <a:xfrm>
            <a:off x="846732" y="3563765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936B581-B247-41B2-7618-A22A62679F6A}"/>
              </a:ext>
            </a:extLst>
          </p:cNvPr>
          <p:cNvSpPr txBox="1"/>
          <p:nvPr/>
        </p:nvSpPr>
        <p:spPr>
          <a:xfrm>
            <a:off x="3651275" y="3574239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9FF2F91E-7CE9-3BC1-F3E9-5CDFE893CBE9}"/>
              </a:ext>
            </a:extLst>
          </p:cNvPr>
          <p:cNvSpPr txBox="1"/>
          <p:nvPr/>
        </p:nvSpPr>
        <p:spPr>
          <a:xfrm>
            <a:off x="6496506" y="3558011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956BC19B-DA2F-6B56-8A9B-64388B806AD4}"/>
              </a:ext>
            </a:extLst>
          </p:cNvPr>
          <p:cNvSpPr txBox="1"/>
          <p:nvPr/>
        </p:nvSpPr>
        <p:spPr>
          <a:xfrm>
            <a:off x="9228979" y="759945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3280F45F-7DB5-0CA3-3001-3B9E1A6F3F34}"/>
              </a:ext>
            </a:extLst>
          </p:cNvPr>
          <p:cNvSpPr txBox="1"/>
          <p:nvPr/>
        </p:nvSpPr>
        <p:spPr>
          <a:xfrm>
            <a:off x="9129445" y="3551011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CB93810B-82F7-AC1B-1078-8021DC2CE762}"/>
              </a:ext>
            </a:extLst>
          </p:cNvPr>
          <p:cNvSpPr txBox="1"/>
          <p:nvPr/>
        </p:nvSpPr>
        <p:spPr>
          <a:xfrm>
            <a:off x="3476581" y="772981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1E316829-8DE3-3942-0E92-131BF5728010}"/>
              </a:ext>
            </a:extLst>
          </p:cNvPr>
          <p:cNvSpPr txBox="1"/>
          <p:nvPr/>
        </p:nvSpPr>
        <p:spPr>
          <a:xfrm>
            <a:off x="3465449" y="3566813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8AE53682-D980-C23F-25C0-B33415A6E24B}"/>
              </a:ext>
            </a:extLst>
          </p:cNvPr>
          <p:cNvSpPr txBox="1"/>
          <p:nvPr/>
        </p:nvSpPr>
        <p:spPr>
          <a:xfrm>
            <a:off x="6281906" y="3551011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0D3F268C-C05D-9554-57E9-2C20032402B1}"/>
              </a:ext>
            </a:extLst>
          </p:cNvPr>
          <p:cNvSpPr txBox="1"/>
          <p:nvPr/>
        </p:nvSpPr>
        <p:spPr>
          <a:xfrm>
            <a:off x="6333430" y="779950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D14495A8-CBF2-339B-68A8-972C52F100CE}"/>
              </a:ext>
            </a:extLst>
          </p:cNvPr>
          <p:cNvSpPr txBox="1"/>
          <p:nvPr/>
        </p:nvSpPr>
        <p:spPr>
          <a:xfrm>
            <a:off x="49450" y="111956"/>
            <a:ext cx="4324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P3Net Supplementary figure 3 part 1 of 4</a:t>
            </a:r>
          </a:p>
        </p:txBody>
      </p: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1DFDC202-FDE9-FB3C-E1B3-B042DA667E5D}"/>
              </a:ext>
            </a:extLst>
          </p:cNvPr>
          <p:cNvCxnSpPr>
            <a:cxnSpLocks/>
          </p:cNvCxnSpPr>
          <p:nvPr/>
        </p:nvCxnSpPr>
        <p:spPr>
          <a:xfrm>
            <a:off x="1079404" y="518612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E1D6AE58-5A7A-3F89-B347-954ED292B201}"/>
              </a:ext>
            </a:extLst>
          </p:cNvPr>
          <p:cNvCxnSpPr>
            <a:cxnSpLocks/>
          </p:cNvCxnSpPr>
          <p:nvPr/>
        </p:nvCxnSpPr>
        <p:spPr>
          <a:xfrm>
            <a:off x="1328744" y="527819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EEBEF523-29DC-C306-21CD-16AC3F8670E8}"/>
              </a:ext>
            </a:extLst>
          </p:cNvPr>
          <p:cNvCxnSpPr>
            <a:cxnSpLocks/>
          </p:cNvCxnSpPr>
          <p:nvPr/>
        </p:nvCxnSpPr>
        <p:spPr>
          <a:xfrm>
            <a:off x="1473421" y="510376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F737484C-D982-620A-2CDC-01E377A93B90}"/>
              </a:ext>
            </a:extLst>
          </p:cNvPr>
          <p:cNvCxnSpPr>
            <a:cxnSpLocks/>
          </p:cNvCxnSpPr>
          <p:nvPr/>
        </p:nvCxnSpPr>
        <p:spPr>
          <a:xfrm>
            <a:off x="1805898" y="534497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1FA0F061-D910-09A6-DC87-8C588E981722}"/>
              </a:ext>
            </a:extLst>
          </p:cNvPr>
          <p:cNvCxnSpPr>
            <a:cxnSpLocks/>
          </p:cNvCxnSpPr>
          <p:nvPr/>
        </p:nvCxnSpPr>
        <p:spPr>
          <a:xfrm>
            <a:off x="2044657" y="552425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6F40F87C-ACD4-E632-255D-850E8F3C8803}"/>
              </a:ext>
            </a:extLst>
          </p:cNvPr>
          <p:cNvCxnSpPr>
            <a:cxnSpLocks/>
          </p:cNvCxnSpPr>
          <p:nvPr/>
        </p:nvCxnSpPr>
        <p:spPr>
          <a:xfrm>
            <a:off x="2282693" y="519584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23030628-0070-9941-63EF-195502AB239B}"/>
              </a:ext>
            </a:extLst>
          </p:cNvPr>
          <p:cNvCxnSpPr>
            <a:cxnSpLocks/>
          </p:cNvCxnSpPr>
          <p:nvPr/>
        </p:nvCxnSpPr>
        <p:spPr>
          <a:xfrm>
            <a:off x="2530351" y="542731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66D6CE52-0658-C28D-72A6-854C466BFAB0}"/>
              </a:ext>
            </a:extLst>
          </p:cNvPr>
          <p:cNvCxnSpPr>
            <a:cxnSpLocks/>
          </p:cNvCxnSpPr>
          <p:nvPr/>
        </p:nvCxnSpPr>
        <p:spPr>
          <a:xfrm>
            <a:off x="2787117" y="548764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BD9A741F-C438-1B73-25C4-4A1CA1509F76}"/>
              </a:ext>
            </a:extLst>
          </p:cNvPr>
          <p:cNvCxnSpPr>
            <a:cxnSpLocks/>
          </p:cNvCxnSpPr>
          <p:nvPr/>
        </p:nvCxnSpPr>
        <p:spPr>
          <a:xfrm>
            <a:off x="2985000" y="441090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1A474B8B-2E5E-5F1A-965C-FB0360972344}"/>
              </a:ext>
            </a:extLst>
          </p:cNvPr>
          <p:cNvCxnSpPr>
            <a:cxnSpLocks/>
          </p:cNvCxnSpPr>
          <p:nvPr/>
        </p:nvCxnSpPr>
        <p:spPr>
          <a:xfrm>
            <a:off x="3218407" y="435691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8BEF41EB-A311-DE89-35A3-10C373550FF2}"/>
              </a:ext>
            </a:extLst>
          </p:cNvPr>
          <p:cNvCxnSpPr>
            <a:cxnSpLocks/>
          </p:cNvCxnSpPr>
          <p:nvPr/>
        </p:nvCxnSpPr>
        <p:spPr>
          <a:xfrm>
            <a:off x="3958794" y="509404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5BA6C25D-56A3-D1ED-0189-B82F251A399D}"/>
              </a:ext>
            </a:extLst>
          </p:cNvPr>
          <p:cNvCxnSpPr>
            <a:cxnSpLocks/>
          </p:cNvCxnSpPr>
          <p:nvPr/>
        </p:nvCxnSpPr>
        <p:spPr>
          <a:xfrm>
            <a:off x="4197074" y="501169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071EAA8A-7A10-EC99-1BA4-54C113AC85A8}"/>
              </a:ext>
            </a:extLst>
          </p:cNvPr>
          <p:cNvCxnSpPr>
            <a:cxnSpLocks/>
          </p:cNvCxnSpPr>
          <p:nvPr/>
        </p:nvCxnSpPr>
        <p:spPr>
          <a:xfrm>
            <a:off x="4681962" y="444858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2939D161-DA04-B538-3609-B9960861FF40}"/>
              </a:ext>
            </a:extLst>
          </p:cNvPr>
          <p:cNvCxnSpPr>
            <a:cxnSpLocks/>
          </p:cNvCxnSpPr>
          <p:nvPr/>
        </p:nvCxnSpPr>
        <p:spPr>
          <a:xfrm>
            <a:off x="4900666" y="460200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E1D68762-9D01-1E37-2E8F-F295234A84F4}"/>
              </a:ext>
            </a:extLst>
          </p:cNvPr>
          <p:cNvCxnSpPr>
            <a:cxnSpLocks/>
          </p:cNvCxnSpPr>
          <p:nvPr/>
        </p:nvCxnSpPr>
        <p:spPr>
          <a:xfrm>
            <a:off x="5104913" y="455766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42AA6E7F-E0FD-C7DE-DCED-EBF8A332AAE2}"/>
              </a:ext>
            </a:extLst>
          </p:cNvPr>
          <p:cNvCxnSpPr>
            <a:cxnSpLocks/>
          </p:cNvCxnSpPr>
          <p:nvPr/>
        </p:nvCxnSpPr>
        <p:spPr>
          <a:xfrm>
            <a:off x="5357889" y="448467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>
            <a:extLst>
              <a:ext uri="{FF2B5EF4-FFF2-40B4-BE49-F238E27FC236}">
                <a16:creationId xmlns:a16="http://schemas.microsoft.com/office/drawing/2014/main" id="{16886ADB-2B61-7246-9231-094C11AB25E5}"/>
              </a:ext>
            </a:extLst>
          </p:cNvPr>
          <p:cNvCxnSpPr>
            <a:cxnSpLocks/>
          </p:cNvCxnSpPr>
          <p:nvPr/>
        </p:nvCxnSpPr>
        <p:spPr>
          <a:xfrm>
            <a:off x="5606287" y="463273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Straight Arrow Connector 87">
            <a:extLst>
              <a:ext uri="{FF2B5EF4-FFF2-40B4-BE49-F238E27FC236}">
                <a16:creationId xmlns:a16="http://schemas.microsoft.com/office/drawing/2014/main" id="{F8CE4D48-83B2-84B8-3E29-D9895C20D559}"/>
              </a:ext>
            </a:extLst>
          </p:cNvPr>
          <p:cNvCxnSpPr>
            <a:cxnSpLocks/>
          </p:cNvCxnSpPr>
          <p:nvPr/>
        </p:nvCxnSpPr>
        <p:spPr>
          <a:xfrm>
            <a:off x="5874805" y="462072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9" name="Straight Arrow Connector 88">
            <a:extLst>
              <a:ext uri="{FF2B5EF4-FFF2-40B4-BE49-F238E27FC236}">
                <a16:creationId xmlns:a16="http://schemas.microsoft.com/office/drawing/2014/main" id="{A7FF81D1-DC12-75C3-A183-1141D2C0EBE1}"/>
              </a:ext>
            </a:extLst>
          </p:cNvPr>
          <p:cNvCxnSpPr>
            <a:cxnSpLocks/>
          </p:cNvCxnSpPr>
          <p:nvPr/>
        </p:nvCxnSpPr>
        <p:spPr>
          <a:xfrm>
            <a:off x="6074577" y="443657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Straight Arrow Connector 89">
            <a:extLst>
              <a:ext uri="{FF2B5EF4-FFF2-40B4-BE49-F238E27FC236}">
                <a16:creationId xmlns:a16="http://schemas.microsoft.com/office/drawing/2014/main" id="{32B80390-BF90-6551-9D69-E37FE5AB1CA2}"/>
              </a:ext>
            </a:extLst>
          </p:cNvPr>
          <p:cNvCxnSpPr>
            <a:cxnSpLocks/>
          </p:cNvCxnSpPr>
          <p:nvPr/>
        </p:nvCxnSpPr>
        <p:spPr>
          <a:xfrm>
            <a:off x="6791265" y="442260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1" name="Straight Arrow Connector 90">
            <a:extLst>
              <a:ext uri="{FF2B5EF4-FFF2-40B4-BE49-F238E27FC236}">
                <a16:creationId xmlns:a16="http://schemas.microsoft.com/office/drawing/2014/main" id="{8C649278-9E7E-184D-BF60-1131CFA040A4}"/>
              </a:ext>
            </a:extLst>
          </p:cNvPr>
          <p:cNvCxnSpPr>
            <a:cxnSpLocks/>
          </p:cNvCxnSpPr>
          <p:nvPr/>
        </p:nvCxnSpPr>
        <p:spPr>
          <a:xfrm>
            <a:off x="7038253" y="460200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Arrow Connector 91">
            <a:extLst>
              <a:ext uri="{FF2B5EF4-FFF2-40B4-BE49-F238E27FC236}">
                <a16:creationId xmlns:a16="http://schemas.microsoft.com/office/drawing/2014/main" id="{B7A371B5-94D2-902D-0EBE-FB604FDAC73E}"/>
              </a:ext>
            </a:extLst>
          </p:cNvPr>
          <p:cNvCxnSpPr>
            <a:cxnSpLocks/>
          </p:cNvCxnSpPr>
          <p:nvPr/>
        </p:nvCxnSpPr>
        <p:spPr>
          <a:xfrm>
            <a:off x="7270487" y="457674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Arrow Connector 92">
            <a:extLst>
              <a:ext uri="{FF2B5EF4-FFF2-40B4-BE49-F238E27FC236}">
                <a16:creationId xmlns:a16="http://schemas.microsoft.com/office/drawing/2014/main" id="{BBCFB111-6465-7681-65B7-3B1BB03F2182}"/>
              </a:ext>
            </a:extLst>
          </p:cNvPr>
          <p:cNvCxnSpPr>
            <a:cxnSpLocks/>
          </p:cNvCxnSpPr>
          <p:nvPr/>
        </p:nvCxnSpPr>
        <p:spPr>
          <a:xfrm>
            <a:off x="7496498" y="447202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Arrow Connector 93">
            <a:extLst>
              <a:ext uri="{FF2B5EF4-FFF2-40B4-BE49-F238E27FC236}">
                <a16:creationId xmlns:a16="http://schemas.microsoft.com/office/drawing/2014/main" id="{8B2C4240-C14A-C665-5856-1D268804EDC3}"/>
              </a:ext>
            </a:extLst>
          </p:cNvPr>
          <p:cNvCxnSpPr>
            <a:cxnSpLocks/>
          </p:cNvCxnSpPr>
          <p:nvPr/>
        </p:nvCxnSpPr>
        <p:spPr>
          <a:xfrm>
            <a:off x="7722509" y="452607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5" name="Straight Arrow Connector 94">
            <a:extLst>
              <a:ext uri="{FF2B5EF4-FFF2-40B4-BE49-F238E27FC236}">
                <a16:creationId xmlns:a16="http://schemas.microsoft.com/office/drawing/2014/main" id="{046BB470-8828-6776-AAC4-3FC0242F4117}"/>
              </a:ext>
            </a:extLst>
          </p:cNvPr>
          <p:cNvCxnSpPr>
            <a:cxnSpLocks/>
          </p:cNvCxnSpPr>
          <p:nvPr/>
        </p:nvCxnSpPr>
        <p:spPr>
          <a:xfrm>
            <a:off x="7876523" y="517034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>
            <a:extLst>
              <a:ext uri="{FF2B5EF4-FFF2-40B4-BE49-F238E27FC236}">
                <a16:creationId xmlns:a16="http://schemas.microsoft.com/office/drawing/2014/main" id="{814C7BA9-EBB0-8EF8-676A-5C63677A5411}"/>
              </a:ext>
            </a:extLst>
          </p:cNvPr>
          <p:cNvCxnSpPr>
            <a:cxnSpLocks/>
          </p:cNvCxnSpPr>
          <p:nvPr/>
        </p:nvCxnSpPr>
        <p:spPr>
          <a:xfrm>
            <a:off x="8201065" y="514186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>
            <a:extLst>
              <a:ext uri="{FF2B5EF4-FFF2-40B4-BE49-F238E27FC236}">
                <a16:creationId xmlns:a16="http://schemas.microsoft.com/office/drawing/2014/main" id="{740DD510-6779-2B33-DD13-7C77CC132270}"/>
              </a:ext>
            </a:extLst>
          </p:cNvPr>
          <p:cNvCxnSpPr>
            <a:cxnSpLocks/>
          </p:cNvCxnSpPr>
          <p:nvPr/>
        </p:nvCxnSpPr>
        <p:spPr>
          <a:xfrm>
            <a:off x="8435409" y="465617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>
            <a:extLst>
              <a:ext uri="{FF2B5EF4-FFF2-40B4-BE49-F238E27FC236}">
                <a16:creationId xmlns:a16="http://schemas.microsoft.com/office/drawing/2014/main" id="{6D041C75-9A18-F47D-F367-406EB01844B3}"/>
              </a:ext>
            </a:extLst>
          </p:cNvPr>
          <p:cNvCxnSpPr>
            <a:cxnSpLocks/>
          </p:cNvCxnSpPr>
          <p:nvPr/>
        </p:nvCxnSpPr>
        <p:spPr>
          <a:xfrm>
            <a:off x="8682290" y="461039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>
            <a:extLst>
              <a:ext uri="{FF2B5EF4-FFF2-40B4-BE49-F238E27FC236}">
                <a16:creationId xmlns:a16="http://schemas.microsoft.com/office/drawing/2014/main" id="{419F54F0-9AA9-335A-887A-8B78E9588C41}"/>
              </a:ext>
            </a:extLst>
          </p:cNvPr>
          <p:cNvCxnSpPr>
            <a:cxnSpLocks/>
          </p:cNvCxnSpPr>
          <p:nvPr/>
        </p:nvCxnSpPr>
        <p:spPr>
          <a:xfrm>
            <a:off x="8887431" y="459505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>
            <a:extLst>
              <a:ext uri="{FF2B5EF4-FFF2-40B4-BE49-F238E27FC236}">
                <a16:creationId xmlns:a16="http://schemas.microsoft.com/office/drawing/2014/main" id="{D29AC134-3C8D-854C-CD77-C1C402B52B1A}"/>
              </a:ext>
            </a:extLst>
          </p:cNvPr>
          <p:cNvCxnSpPr>
            <a:cxnSpLocks/>
          </p:cNvCxnSpPr>
          <p:nvPr/>
        </p:nvCxnSpPr>
        <p:spPr>
          <a:xfrm>
            <a:off x="2300472" y="3131649"/>
            <a:ext cx="226099" cy="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>
            <a:extLst>
              <a:ext uri="{FF2B5EF4-FFF2-40B4-BE49-F238E27FC236}">
                <a16:creationId xmlns:a16="http://schemas.microsoft.com/office/drawing/2014/main" id="{AF4054BF-59AC-A586-10EF-3D33A18E3D4B}"/>
              </a:ext>
            </a:extLst>
          </p:cNvPr>
          <p:cNvCxnSpPr>
            <a:cxnSpLocks/>
          </p:cNvCxnSpPr>
          <p:nvPr/>
        </p:nvCxnSpPr>
        <p:spPr>
          <a:xfrm>
            <a:off x="2308859" y="3245949"/>
            <a:ext cx="226099" cy="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>
            <a:extLst>
              <a:ext uri="{FF2B5EF4-FFF2-40B4-BE49-F238E27FC236}">
                <a16:creationId xmlns:a16="http://schemas.microsoft.com/office/drawing/2014/main" id="{9684D667-3AB5-F560-020B-4F4E7F541D2D}"/>
              </a:ext>
            </a:extLst>
          </p:cNvPr>
          <p:cNvCxnSpPr>
            <a:cxnSpLocks/>
          </p:cNvCxnSpPr>
          <p:nvPr/>
        </p:nvCxnSpPr>
        <p:spPr>
          <a:xfrm>
            <a:off x="2248140" y="5843099"/>
            <a:ext cx="226099" cy="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>
            <a:extLst>
              <a:ext uri="{FF2B5EF4-FFF2-40B4-BE49-F238E27FC236}">
                <a16:creationId xmlns:a16="http://schemas.microsoft.com/office/drawing/2014/main" id="{BB408F44-FAE0-F86A-06D1-E28120CECB50}"/>
              </a:ext>
            </a:extLst>
          </p:cNvPr>
          <p:cNvCxnSpPr>
            <a:cxnSpLocks/>
          </p:cNvCxnSpPr>
          <p:nvPr/>
        </p:nvCxnSpPr>
        <p:spPr>
          <a:xfrm>
            <a:off x="2256527" y="5957399"/>
            <a:ext cx="226099" cy="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>
            <a:extLst>
              <a:ext uri="{FF2B5EF4-FFF2-40B4-BE49-F238E27FC236}">
                <a16:creationId xmlns:a16="http://schemas.microsoft.com/office/drawing/2014/main" id="{C6C5B866-7EF2-C69D-5ED8-BFD7BE7F63B0}"/>
              </a:ext>
            </a:extLst>
          </p:cNvPr>
          <p:cNvCxnSpPr>
            <a:cxnSpLocks/>
          </p:cNvCxnSpPr>
          <p:nvPr/>
        </p:nvCxnSpPr>
        <p:spPr>
          <a:xfrm flipH="1">
            <a:off x="3052026" y="3131649"/>
            <a:ext cx="332761" cy="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>
            <a:extLst>
              <a:ext uri="{FF2B5EF4-FFF2-40B4-BE49-F238E27FC236}">
                <a16:creationId xmlns:a16="http://schemas.microsoft.com/office/drawing/2014/main" id="{E6A5A642-52B3-C54E-4C7C-114DB7E8E0CF}"/>
              </a:ext>
            </a:extLst>
          </p:cNvPr>
          <p:cNvCxnSpPr>
            <a:cxnSpLocks/>
          </p:cNvCxnSpPr>
          <p:nvPr/>
        </p:nvCxnSpPr>
        <p:spPr>
          <a:xfrm flipH="1">
            <a:off x="3037090" y="5843099"/>
            <a:ext cx="285980" cy="0"/>
          </a:xfrm>
          <a:prstGeom prst="straightConnector1">
            <a:avLst/>
          </a:prstGeom>
          <a:ln w="19050">
            <a:solidFill>
              <a:schemeClr val="tx1"/>
            </a:solidFill>
            <a:prstDash val="sysDot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41283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34B5F66-0003-AA77-EAEB-C600AF9268D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A1ADBEB8-912B-094B-C650-A6A6F98D85B1}"/>
              </a:ext>
            </a:extLst>
          </p:cNvPr>
          <p:cNvGrpSpPr/>
          <p:nvPr/>
        </p:nvGrpSpPr>
        <p:grpSpPr>
          <a:xfrm>
            <a:off x="368312" y="805712"/>
            <a:ext cx="5647477" cy="2749567"/>
            <a:chOff x="368312" y="3779819"/>
            <a:chExt cx="5647477" cy="2749567"/>
          </a:xfrm>
        </p:grpSpPr>
        <p:pic>
          <p:nvPicPr>
            <p:cNvPr id="3" name="Picture 2" descr="A close-up of a dna strand&#10;&#10;Description automatically generated">
              <a:extLst>
                <a:ext uri="{FF2B5EF4-FFF2-40B4-BE49-F238E27FC236}">
                  <a16:creationId xmlns:a16="http://schemas.microsoft.com/office/drawing/2014/main" id="{65DD0F89-04FB-26ED-F13E-F784BB6DD28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2460" b="-1"/>
            <a:stretch/>
          </p:blipFill>
          <p:spPr>
            <a:xfrm>
              <a:off x="888492" y="4018584"/>
              <a:ext cx="2877312" cy="2405195"/>
            </a:xfrm>
            <a:prstGeom prst="rect">
              <a:avLst/>
            </a:prstGeom>
          </p:spPr>
        </p:pic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85EC5947-81ED-217F-FD01-5B1EF2293ED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312" y="3971051"/>
              <a:ext cx="514083" cy="2558335"/>
            </a:xfrm>
            <a:prstGeom prst="rect">
              <a:avLst/>
            </a:prstGeom>
          </p:spPr>
        </p:pic>
        <p:pic>
          <p:nvPicPr>
            <p:cNvPr id="5" name="Picture 4" descr="A close-up of a dna strand&#10;&#10;Description automatically generated">
              <a:extLst>
                <a:ext uri="{FF2B5EF4-FFF2-40B4-BE49-F238E27FC236}">
                  <a16:creationId xmlns:a16="http://schemas.microsoft.com/office/drawing/2014/main" id="{1EAD9B20-B6A5-5677-405E-D1F02E34D7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2820"/>
            <a:stretch/>
          </p:blipFill>
          <p:spPr>
            <a:xfrm>
              <a:off x="3765804" y="4019679"/>
              <a:ext cx="2185416" cy="2405194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A332D8B-DA10-9206-5136-2ED0C36103BA}"/>
                </a:ext>
              </a:extLst>
            </p:cNvPr>
            <p:cNvSpPr txBox="1"/>
            <p:nvPr/>
          </p:nvSpPr>
          <p:spPr>
            <a:xfrm>
              <a:off x="982764" y="3779819"/>
              <a:ext cx="5033025" cy="2862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>
                <a:lnSpc>
                  <a:spcPct val="90000"/>
                </a:lnSpc>
                <a:spcAft>
                  <a:spcPts val="600"/>
                </a:spcAft>
              </a:pPr>
              <a:r>
                <a:rPr lang="en-US" sz="1400" dirty="0"/>
                <a:t> 31  32  33  34 35 36  37 38 39  40            41  42  43  44 45  46 47</a:t>
              </a:r>
              <a:endParaRPr lang="en-SE" sz="1400" dirty="0" err="1"/>
            </a:p>
          </p:txBody>
        </p:sp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E1F3571A-1F3A-3816-FACC-E1181C61AEEE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0984" y="4052495"/>
            <a:ext cx="514083" cy="255833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60AA052-C14B-AA2D-D2AB-9B00760535F7}"/>
              </a:ext>
            </a:extLst>
          </p:cNvPr>
          <p:cNvSpPr txBox="1"/>
          <p:nvPr/>
        </p:nvSpPr>
        <p:spPr>
          <a:xfrm>
            <a:off x="982764" y="3779819"/>
            <a:ext cx="5611583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 31  32  33  34 35 36  37 38 39  40            41  42  43  44 45  46 47 48 49 50 </a:t>
            </a:r>
            <a:endParaRPr lang="en-SE" sz="1400" dirty="0" err="1"/>
          </a:p>
        </p:txBody>
      </p:sp>
      <p:pic>
        <p:nvPicPr>
          <p:cNvPr id="9" name="Picture 8" descr="A close-up of a dna&#10;&#10;AI-generated content may be incorrect.">
            <a:extLst>
              <a:ext uri="{FF2B5EF4-FFF2-40B4-BE49-F238E27FC236}">
                <a16:creationId xmlns:a16="http://schemas.microsoft.com/office/drawing/2014/main" id="{1D937229-9330-B78C-94B7-53748036F79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25067" y="4005642"/>
            <a:ext cx="2810256" cy="2523744"/>
          </a:xfrm>
          <a:prstGeom prst="rect">
            <a:avLst/>
          </a:prstGeom>
        </p:spPr>
      </p:pic>
      <p:pic>
        <p:nvPicPr>
          <p:cNvPr id="10" name="Picture 9" descr="A close-up of a dna&#10;&#10;AI-generated content may be incorrect.">
            <a:extLst>
              <a:ext uri="{FF2B5EF4-FFF2-40B4-BE49-F238E27FC236}">
                <a16:creationId xmlns:a16="http://schemas.microsoft.com/office/drawing/2014/main" id="{D3DE5F36-E0FA-521A-6196-584C525840B0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35323" y="3998978"/>
            <a:ext cx="2859024" cy="2465832"/>
          </a:xfrm>
          <a:prstGeom prst="rect">
            <a:avLst/>
          </a:prstGeom>
        </p:spPr>
      </p:pic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E16F9C0F-3CDD-ABF8-33E5-040D1BEA383C}"/>
              </a:ext>
            </a:extLst>
          </p:cNvPr>
          <p:cNvCxnSpPr>
            <a:cxnSpLocks/>
          </p:cNvCxnSpPr>
          <p:nvPr/>
        </p:nvCxnSpPr>
        <p:spPr>
          <a:xfrm>
            <a:off x="1149255" y="18098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B205853F-A5CD-049C-F8F6-30101E6BAB2F}"/>
              </a:ext>
            </a:extLst>
          </p:cNvPr>
          <p:cNvCxnSpPr>
            <a:cxnSpLocks/>
          </p:cNvCxnSpPr>
          <p:nvPr/>
        </p:nvCxnSpPr>
        <p:spPr>
          <a:xfrm>
            <a:off x="1377855" y="219652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E2F750CF-A96E-E82E-E39B-58BFE107DD20}"/>
              </a:ext>
            </a:extLst>
          </p:cNvPr>
          <p:cNvCxnSpPr>
            <a:cxnSpLocks/>
          </p:cNvCxnSpPr>
          <p:nvPr/>
        </p:nvCxnSpPr>
        <p:spPr>
          <a:xfrm>
            <a:off x="1631855" y="213120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A276FC22-2975-E5FD-3BFE-B41465E03D23}"/>
              </a:ext>
            </a:extLst>
          </p:cNvPr>
          <p:cNvCxnSpPr>
            <a:cxnSpLocks/>
          </p:cNvCxnSpPr>
          <p:nvPr/>
        </p:nvCxnSpPr>
        <p:spPr>
          <a:xfrm>
            <a:off x="1870439" y="189449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0A63346-C4D5-850E-5ED5-0B2B28958803}"/>
              </a:ext>
            </a:extLst>
          </p:cNvPr>
          <p:cNvCxnSpPr>
            <a:cxnSpLocks/>
          </p:cNvCxnSpPr>
          <p:nvPr/>
        </p:nvCxnSpPr>
        <p:spPr>
          <a:xfrm>
            <a:off x="2096937" y="186966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6541A45B-FE85-07C5-222B-69EAA63C26BC}"/>
              </a:ext>
            </a:extLst>
          </p:cNvPr>
          <p:cNvCxnSpPr>
            <a:cxnSpLocks/>
          </p:cNvCxnSpPr>
          <p:nvPr/>
        </p:nvCxnSpPr>
        <p:spPr>
          <a:xfrm>
            <a:off x="2341936" y="186966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CF0AE9C7-610A-176C-B585-54DB9E94E391}"/>
              </a:ext>
            </a:extLst>
          </p:cNvPr>
          <p:cNvCxnSpPr>
            <a:cxnSpLocks/>
          </p:cNvCxnSpPr>
          <p:nvPr/>
        </p:nvCxnSpPr>
        <p:spPr>
          <a:xfrm>
            <a:off x="2850991" y="222328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B1518C34-B422-CC15-EC8A-DE167F250610}"/>
              </a:ext>
            </a:extLst>
          </p:cNvPr>
          <p:cNvCxnSpPr>
            <a:cxnSpLocks/>
          </p:cNvCxnSpPr>
          <p:nvPr/>
        </p:nvCxnSpPr>
        <p:spPr>
          <a:xfrm>
            <a:off x="2646498" y="186966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CF63943B-11C5-294B-0B2F-C324D23AD145}"/>
              </a:ext>
            </a:extLst>
          </p:cNvPr>
          <p:cNvCxnSpPr>
            <a:cxnSpLocks/>
          </p:cNvCxnSpPr>
          <p:nvPr/>
        </p:nvCxnSpPr>
        <p:spPr>
          <a:xfrm>
            <a:off x="3065901" y="221801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3AE2959E-B11D-AF1E-091B-25F45886669B}"/>
              </a:ext>
            </a:extLst>
          </p:cNvPr>
          <p:cNvCxnSpPr>
            <a:cxnSpLocks/>
          </p:cNvCxnSpPr>
          <p:nvPr/>
        </p:nvCxnSpPr>
        <p:spPr>
          <a:xfrm>
            <a:off x="3294307" y="189449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CB204A91-FB9E-4A52-228F-81CF5B7A3C78}"/>
              </a:ext>
            </a:extLst>
          </p:cNvPr>
          <p:cNvCxnSpPr>
            <a:cxnSpLocks/>
          </p:cNvCxnSpPr>
          <p:nvPr/>
        </p:nvCxnSpPr>
        <p:spPr>
          <a:xfrm>
            <a:off x="3992302" y="18403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C13251B2-6D29-0565-9EF7-EBDB1F8745FD}"/>
              </a:ext>
            </a:extLst>
          </p:cNvPr>
          <p:cNvCxnSpPr>
            <a:cxnSpLocks/>
          </p:cNvCxnSpPr>
          <p:nvPr/>
        </p:nvCxnSpPr>
        <p:spPr>
          <a:xfrm>
            <a:off x="4263271" y="202453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53CFB01F-25A0-C64F-C100-4DD0E8686E7C}"/>
              </a:ext>
            </a:extLst>
          </p:cNvPr>
          <p:cNvCxnSpPr>
            <a:cxnSpLocks/>
          </p:cNvCxnSpPr>
          <p:nvPr/>
        </p:nvCxnSpPr>
        <p:spPr>
          <a:xfrm>
            <a:off x="4489769" y="201703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E923C5E-2FEC-C0E9-62BC-BC16F7A3F39F}"/>
              </a:ext>
            </a:extLst>
          </p:cNvPr>
          <p:cNvCxnSpPr>
            <a:cxnSpLocks/>
          </p:cNvCxnSpPr>
          <p:nvPr/>
        </p:nvCxnSpPr>
        <p:spPr>
          <a:xfrm>
            <a:off x="4733802" y="171780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45C16732-D5A4-6F94-BCC0-19AACA1774E7}"/>
              </a:ext>
            </a:extLst>
          </p:cNvPr>
          <p:cNvCxnSpPr>
            <a:cxnSpLocks/>
          </p:cNvCxnSpPr>
          <p:nvPr/>
        </p:nvCxnSpPr>
        <p:spPr>
          <a:xfrm>
            <a:off x="4984640" y="169969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F03F6749-84CF-807A-C372-114EAB293D62}"/>
              </a:ext>
            </a:extLst>
          </p:cNvPr>
          <p:cNvCxnSpPr>
            <a:cxnSpLocks/>
          </p:cNvCxnSpPr>
          <p:nvPr/>
        </p:nvCxnSpPr>
        <p:spPr>
          <a:xfrm>
            <a:off x="5200327" y="177759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615434D5-4179-20EA-E580-6D809CCF99D9}"/>
              </a:ext>
            </a:extLst>
          </p:cNvPr>
          <p:cNvCxnSpPr>
            <a:cxnSpLocks/>
          </p:cNvCxnSpPr>
          <p:nvPr/>
        </p:nvCxnSpPr>
        <p:spPr>
          <a:xfrm>
            <a:off x="5467930" y="175707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A4725383-91C9-2806-DD3C-C729B99790B5}"/>
              </a:ext>
            </a:extLst>
          </p:cNvPr>
          <p:cNvSpPr txBox="1"/>
          <p:nvPr/>
        </p:nvSpPr>
        <p:spPr>
          <a:xfrm>
            <a:off x="5648444" y="808700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DF324298-9F19-9B94-FC02-9E55381C9FBD}"/>
              </a:ext>
            </a:extLst>
          </p:cNvPr>
          <p:cNvSpPr txBox="1"/>
          <p:nvPr/>
        </p:nvSpPr>
        <p:spPr>
          <a:xfrm>
            <a:off x="6327927" y="3766263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A93EEA82-3810-B696-BA96-7A10DE6F28D5}"/>
              </a:ext>
            </a:extLst>
          </p:cNvPr>
          <p:cNvSpPr txBox="1"/>
          <p:nvPr/>
        </p:nvSpPr>
        <p:spPr>
          <a:xfrm>
            <a:off x="3531669" y="802724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B371F778-5048-6EA2-7B87-813026ADEC9A}"/>
              </a:ext>
            </a:extLst>
          </p:cNvPr>
          <p:cNvSpPr txBox="1"/>
          <p:nvPr/>
        </p:nvSpPr>
        <p:spPr>
          <a:xfrm>
            <a:off x="3468903" y="3781082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D43DD39B-27E8-34C5-2FF4-D23B14FC8240}"/>
              </a:ext>
            </a:extLst>
          </p:cNvPr>
          <p:cNvSpPr txBox="1"/>
          <p:nvPr/>
        </p:nvSpPr>
        <p:spPr>
          <a:xfrm>
            <a:off x="863801" y="795754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8185053-9EA2-38D3-8D64-644C4791DEB1}"/>
              </a:ext>
            </a:extLst>
          </p:cNvPr>
          <p:cNvSpPr txBox="1"/>
          <p:nvPr/>
        </p:nvSpPr>
        <p:spPr>
          <a:xfrm>
            <a:off x="3706079" y="808700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A67562A8-D5D2-F4F1-ABF5-B15D9714E6BD}"/>
              </a:ext>
            </a:extLst>
          </p:cNvPr>
          <p:cNvSpPr txBox="1"/>
          <p:nvPr/>
        </p:nvSpPr>
        <p:spPr>
          <a:xfrm>
            <a:off x="830903" y="3775822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6AA842A6-5D85-64A2-30D6-48869B1A74D1}"/>
              </a:ext>
            </a:extLst>
          </p:cNvPr>
          <p:cNvSpPr txBox="1"/>
          <p:nvPr/>
        </p:nvSpPr>
        <p:spPr>
          <a:xfrm>
            <a:off x="3689927" y="3776831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307163ED-89BB-5BB2-3108-353968B91304}"/>
              </a:ext>
            </a:extLst>
          </p:cNvPr>
          <p:cNvSpPr txBox="1"/>
          <p:nvPr/>
        </p:nvSpPr>
        <p:spPr>
          <a:xfrm>
            <a:off x="49450" y="111956"/>
            <a:ext cx="4324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P3Net Supplementary figure 3 part 2 of 4</a:t>
            </a:r>
          </a:p>
        </p:txBody>
      </p: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B1815C44-8E82-CAAD-EBD2-D10D987635F0}"/>
              </a:ext>
            </a:extLst>
          </p:cNvPr>
          <p:cNvCxnSpPr>
            <a:cxnSpLocks/>
          </p:cNvCxnSpPr>
          <p:nvPr/>
        </p:nvCxnSpPr>
        <p:spPr>
          <a:xfrm>
            <a:off x="1149255" y="48070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EE35020D-D02F-35A2-B1EE-E080431F8BBD}"/>
              </a:ext>
            </a:extLst>
          </p:cNvPr>
          <p:cNvCxnSpPr>
            <a:cxnSpLocks/>
          </p:cNvCxnSpPr>
          <p:nvPr/>
        </p:nvCxnSpPr>
        <p:spPr>
          <a:xfrm>
            <a:off x="1409694" y="526751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86C85D93-C535-024A-967A-AA96B581FB86}"/>
              </a:ext>
            </a:extLst>
          </p:cNvPr>
          <p:cNvCxnSpPr>
            <a:cxnSpLocks/>
          </p:cNvCxnSpPr>
          <p:nvPr/>
        </p:nvCxnSpPr>
        <p:spPr>
          <a:xfrm>
            <a:off x="1631854" y="516598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C5DF9E33-5366-DA88-326C-3784374A2331}"/>
              </a:ext>
            </a:extLst>
          </p:cNvPr>
          <p:cNvCxnSpPr>
            <a:cxnSpLocks/>
          </p:cNvCxnSpPr>
          <p:nvPr/>
        </p:nvCxnSpPr>
        <p:spPr>
          <a:xfrm>
            <a:off x="1870438" y="489915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4B4481D9-83DC-EC29-4A13-3D55B1313B47}"/>
              </a:ext>
            </a:extLst>
          </p:cNvPr>
          <p:cNvCxnSpPr>
            <a:cxnSpLocks/>
          </p:cNvCxnSpPr>
          <p:nvPr/>
        </p:nvCxnSpPr>
        <p:spPr>
          <a:xfrm>
            <a:off x="2096937" y="489499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7A1BD669-5EED-4840-81AA-8790533EA2B5}"/>
              </a:ext>
            </a:extLst>
          </p:cNvPr>
          <p:cNvCxnSpPr>
            <a:cxnSpLocks/>
          </p:cNvCxnSpPr>
          <p:nvPr/>
        </p:nvCxnSpPr>
        <p:spPr>
          <a:xfrm>
            <a:off x="2330195" y="480292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81D42857-03DB-0CF2-549F-1A4AADBB1CDA}"/>
              </a:ext>
            </a:extLst>
          </p:cNvPr>
          <p:cNvCxnSpPr>
            <a:cxnSpLocks/>
          </p:cNvCxnSpPr>
          <p:nvPr/>
        </p:nvCxnSpPr>
        <p:spPr>
          <a:xfrm>
            <a:off x="2541835" y="480511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62C8D051-9A22-BB03-EE25-D180CB0687D6}"/>
              </a:ext>
            </a:extLst>
          </p:cNvPr>
          <p:cNvCxnSpPr>
            <a:cxnSpLocks/>
          </p:cNvCxnSpPr>
          <p:nvPr/>
        </p:nvCxnSpPr>
        <p:spPr>
          <a:xfrm>
            <a:off x="2798659" y="521546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EB7C2893-1A0F-7777-33D7-0D7D68BFD205}"/>
              </a:ext>
            </a:extLst>
          </p:cNvPr>
          <p:cNvCxnSpPr>
            <a:cxnSpLocks/>
          </p:cNvCxnSpPr>
          <p:nvPr/>
        </p:nvCxnSpPr>
        <p:spPr>
          <a:xfrm>
            <a:off x="3041370" y="517543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AC64596B-4852-9E19-1A22-B0096754DF77}"/>
              </a:ext>
            </a:extLst>
          </p:cNvPr>
          <p:cNvCxnSpPr>
            <a:cxnSpLocks/>
          </p:cNvCxnSpPr>
          <p:nvPr/>
        </p:nvCxnSpPr>
        <p:spPr>
          <a:xfrm>
            <a:off x="3242401" y="488625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D2997615-9539-B121-D293-779BF0CC18DB}"/>
              </a:ext>
            </a:extLst>
          </p:cNvPr>
          <p:cNvCxnSpPr>
            <a:cxnSpLocks/>
          </p:cNvCxnSpPr>
          <p:nvPr/>
        </p:nvCxnSpPr>
        <p:spPr>
          <a:xfrm>
            <a:off x="3968581" y="481204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0BA522CC-7169-E27C-EA41-DE3712B72B7B}"/>
              </a:ext>
            </a:extLst>
          </p:cNvPr>
          <p:cNvCxnSpPr>
            <a:cxnSpLocks/>
          </p:cNvCxnSpPr>
          <p:nvPr/>
        </p:nvCxnSpPr>
        <p:spPr>
          <a:xfrm>
            <a:off x="4226043" y="506830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002B1879-D8B3-B8F7-113A-99AA2AFD37E6}"/>
              </a:ext>
            </a:extLst>
          </p:cNvPr>
          <p:cNvCxnSpPr>
            <a:cxnSpLocks/>
          </p:cNvCxnSpPr>
          <p:nvPr/>
        </p:nvCxnSpPr>
        <p:spPr>
          <a:xfrm>
            <a:off x="4437045" y="504960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B067702D-97E9-E9B7-D11D-82C9C98D99DE}"/>
              </a:ext>
            </a:extLst>
          </p:cNvPr>
          <p:cNvCxnSpPr>
            <a:cxnSpLocks/>
          </p:cNvCxnSpPr>
          <p:nvPr/>
        </p:nvCxnSpPr>
        <p:spPr>
          <a:xfrm>
            <a:off x="4676944" y="478742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B616A4ED-9C8A-3B27-301E-1C82E6424C77}"/>
              </a:ext>
            </a:extLst>
          </p:cNvPr>
          <p:cNvCxnSpPr>
            <a:cxnSpLocks/>
          </p:cNvCxnSpPr>
          <p:nvPr/>
        </p:nvCxnSpPr>
        <p:spPr>
          <a:xfrm>
            <a:off x="4916263" y="480497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5F05C9E6-91BD-93DB-F31C-424DD553FA0E}"/>
              </a:ext>
            </a:extLst>
          </p:cNvPr>
          <p:cNvCxnSpPr>
            <a:cxnSpLocks/>
          </p:cNvCxnSpPr>
          <p:nvPr/>
        </p:nvCxnSpPr>
        <p:spPr>
          <a:xfrm>
            <a:off x="5135085" y="486545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F44838C2-852B-73A4-5BBD-4BEF521E444C}"/>
              </a:ext>
            </a:extLst>
          </p:cNvPr>
          <p:cNvCxnSpPr>
            <a:cxnSpLocks/>
          </p:cNvCxnSpPr>
          <p:nvPr/>
        </p:nvCxnSpPr>
        <p:spPr>
          <a:xfrm>
            <a:off x="5399057" y="481798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4A9E43DA-84FD-586B-A04C-25F48CDBEB55}"/>
              </a:ext>
            </a:extLst>
          </p:cNvPr>
          <p:cNvCxnSpPr>
            <a:cxnSpLocks/>
          </p:cNvCxnSpPr>
          <p:nvPr/>
        </p:nvCxnSpPr>
        <p:spPr>
          <a:xfrm>
            <a:off x="5648444" y="557977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B6ED77A5-B090-8BAA-D08D-8B4C96B711D7}"/>
              </a:ext>
            </a:extLst>
          </p:cNvPr>
          <p:cNvCxnSpPr>
            <a:cxnSpLocks/>
          </p:cNvCxnSpPr>
          <p:nvPr/>
        </p:nvCxnSpPr>
        <p:spPr>
          <a:xfrm>
            <a:off x="5870432" y="558572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135621E1-3514-27A1-86D7-A90CD057ACC2}"/>
              </a:ext>
            </a:extLst>
          </p:cNvPr>
          <p:cNvCxnSpPr>
            <a:cxnSpLocks/>
          </p:cNvCxnSpPr>
          <p:nvPr/>
        </p:nvCxnSpPr>
        <p:spPr>
          <a:xfrm>
            <a:off x="6112065" y="51603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7696552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EC74E2F-BAAD-8D0D-2E9F-CE013E1F287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Group 8">
            <a:extLst>
              <a:ext uri="{FF2B5EF4-FFF2-40B4-BE49-F238E27FC236}">
                <a16:creationId xmlns:a16="http://schemas.microsoft.com/office/drawing/2014/main" id="{3A694D17-E1F4-B9AD-8722-21A1E8FB65B2}"/>
              </a:ext>
            </a:extLst>
          </p:cNvPr>
          <p:cNvGrpSpPr/>
          <p:nvPr/>
        </p:nvGrpSpPr>
        <p:grpSpPr>
          <a:xfrm>
            <a:off x="301078" y="769954"/>
            <a:ext cx="9211508" cy="2690523"/>
            <a:chOff x="301078" y="757766"/>
            <a:chExt cx="9211508" cy="2690523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17E5A067-C24E-38C6-8B44-BA5105337EFC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1078" y="930484"/>
              <a:ext cx="514083" cy="2517805"/>
            </a:xfrm>
            <a:prstGeom prst="rect">
              <a:avLst/>
            </a:prstGeom>
          </p:spPr>
        </p:pic>
        <p:pic>
          <p:nvPicPr>
            <p:cNvPr id="10" name="Picture 9" descr="A close-up of a dna&#10;&#10;Description automatically generated">
              <a:extLst>
                <a:ext uri="{FF2B5EF4-FFF2-40B4-BE49-F238E27FC236}">
                  <a16:creationId xmlns:a16="http://schemas.microsoft.com/office/drawing/2014/main" id="{7ABBDD86-46C2-426A-8549-24AF4CA74C6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681"/>
            <a:stretch/>
          </p:blipFill>
          <p:spPr>
            <a:xfrm>
              <a:off x="815161" y="972208"/>
              <a:ext cx="2883408" cy="2439348"/>
            </a:xfrm>
            <a:prstGeom prst="rect">
              <a:avLst/>
            </a:prstGeom>
          </p:spPr>
        </p:pic>
        <p:pic>
          <p:nvPicPr>
            <p:cNvPr id="13" name="Picture 12" descr="A close-up of a dna sequence&#10;&#10;Description automatically generated">
              <a:extLst>
                <a:ext uri="{FF2B5EF4-FFF2-40B4-BE49-F238E27FC236}">
                  <a16:creationId xmlns:a16="http://schemas.microsoft.com/office/drawing/2014/main" id="{5871037F-5763-5E8A-80F2-F42B61C42A0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3227"/>
            <a:stretch/>
          </p:blipFill>
          <p:spPr>
            <a:xfrm>
              <a:off x="3698569" y="972208"/>
              <a:ext cx="2834640" cy="2439348"/>
            </a:xfrm>
            <a:prstGeom prst="rect">
              <a:avLst/>
            </a:prstGeom>
          </p:spPr>
        </p:pic>
        <p:pic>
          <p:nvPicPr>
            <p:cNvPr id="15" name="Picture 14" descr="A close-up of a dna sequence&#10;&#10;Description automatically generated">
              <a:extLst>
                <a:ext uri="{FF2B5EF4-FFF2-40B4-BE49-F238E27FC236}">
                  <a16:creationId xmlns:a16="http://schemas.microsoft.com/office/drawing/2014/main" id="{CD3AEFF1-C09C-3EE3-DE0B-3CFEA8E26B9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b="1457"/>
            <a:stretch/>
          </p:blipFill>
          <p:spPr>
            <a:xfrm>
              <a:off x="6533209" y="927593"/>
              <a:ext cx="2849880" cy="2483963"/>
            </a:xfrm>
            <a:prstGeom prst="rect">
              <a:avLst/>
            </a:prstGeom>
          </p:spPr>
        </p:pic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F1D66CD-14C2-AF4B-9B0D-31D764B1FE1E}"/>
                </a:ext>
              </a:extLst>
            </p:cNvPr>
            <p:cNvSpPr txBox="1"/>
            <p:nvPr/>
          </p:nvSpPr>
          <p:spPr>
            <a:xfrm>
              <a:off x="932352" y="757766"/>
              <a:ext cx="8580234" cy="2862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>
                <a:lnSpc>
                  <a:spcPct val="90000"/>
                </a:lnSpc>
                <a:spcAft>
                  <a:spcPts val="600"/>
                </a:spcAft>
              </a:pPr>
              <a:r>
                <a:rPr lang="en-US" sz="1400" dirty="0"/>
                <a:t> 48  49  50  51 52 53 54 55 56 57              58  59 60  61  62 63 64 65  66 67              68  69 70  71 72 73 74 75 76  77</a:t>
              </a:r>
              <a:endParaRPr lang="en-SE" sz="1400" dirty="0" err="1"/>
            </a:p>
          </p:txBody>
        </p:sp>
      </p:grpSp>
      <p:grpSp>
        <p:nvGrpSpPr>
          <p:cNvPr id="6" name="Group 5">
            <a:extLst>
              <a:ext uri="{FF2B5EF4-FFF2-40B4-BE49-F238E27FC236}">
                <a16:creationId xmlns:a16="http://schemas.microsoft.com/office/drawing/2014/main" id="{DAEE9AD1-A9A1-E469-E2C3-095C2C182D09}"/>
              </a:ext>
            </a:extLst>
          </p:cNvPr>
          <p:cNvGrpSpPr/>
          <p:nvPr/>
        </p:nvGrpSpPr>
        <p:grpSpPr>
          <a:xfrm>
            <a:off x="1081008" y="3460477"/>
            <a:ext cx="9211508" cy="2804037"/>
            <a:chOff x="301078" y="3482496"/>
            <a:chExt cx="9211508" cy="2804037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5CD6420E-73BA-5D5D-6750-2C6F85845EE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01078" y="3768728"/>
              <a:ext cx="514083" cy="2517805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3291859-142F-8405-3832-62BFF7EECD53}"/>
                </a:ext>
              </a:extLst>
            </p:cNvPr>
            <p:cNvSpPr txBox="1"/>
            <p:nvPr/>
          </p:nvSpPr>
          <p:spPr>
            <a:xfrm>
              <a:off x="932352" y="3482496"/>
              <a:ext cx="8580234" cy="2862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>
                <a:lnSpc>
                  <a:spcPct val="90000"/>
                </a:lnSpc>
                <a:spcAft>
                  <a:spcPts val="600"/>
                </a:spcAft>
              </a:pPr>
              <a:r>
                <a:rPr lang="en-US" sz="1400" dirty="0"/>
                <a:t> 51 52  53 54 55 56  57 58  59 61              60  62 63 64 65  66 67 68  69 70               71 72 73 74 75 76  77 78 79  80</a:t>
              </a:r>
              <a:endParaRPr lang="en-SE" sz="1400" dirty="0" err="1"/>
            </a:p>
          </p:txBody>
        </p:sp>
        <p:pic>
          <p:nvPicPr>
            <p:cNvPr id="14" name="Picture 13" descr="A close-up of a dna&#10;&#10;AI-generated content may be incorrect.">
              <a:extLst>
                <a:ext uri="{FF2B5EF4-FFF2-40B4-BE49-F238E27FC236}">
                  <a16:creationId xmlns:a16="http://schemas.microsoft.com/office/drawing/2014/main" id="{396911DE-0124-DA32-5DA0-14D5DEFA968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15161" y="3741531"/>
              <a:ext cx="2868168" cy="2462784"/>
            </a:xfrm>
            <a:prstGeom prst="rect">
              <a:avLst/>
            </a:prstGeom>
          </p:spPr>
        </p:pic>
        <p:pic>
          <p:nvPicPr>
            <p:cNvPr id="17" name="Picture 16" descr="A close-up of a dna test&#10;&#10;AI-generated content may be incorrect.">
              <a:extLst>
                <a:ext uri="{FF2B5EF4-FFF2-40B4-BE49-F238E27FC236}">
                  <a16:creationId xmlns:a16="http://schemas.microsoft.com/office/drawing/2014/main" id="{4C05D29F-E109-56F5-4598-F2249CBDFD71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83329" y="3768728"/>
              <a:ext cx="2834640" cy="2450592"/>
            </a:xfrm>
            <a:prstGeom prst="rect">
              <a:avLst/>
            </a:prstGeom>
          </p:spPr>
        </p:pic>
        <p:pic>
          <p:nvPicPr>
            <p:cNvPr id="19" name="Picture 18" descr="A close-up of a dna sequence&#10;&#10;AI-generated content may be incorrect.">
              <a:extLst>
                <a:ext uri="{FF2B5EF4-FFF2-40B4-BE49-F238E27FC236}">
                  <a16:creationId xmlns:a16="http://schemas.microsoft.com/office/drawing/2014/main" id="{61CB13CB-28AE-11C1-2DE2-7CB42D2F8D12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17969" y="3776317"/>
              <a:ext cx="2849880" cy="2493264"/>
            </a:xfrm>
            <a:prstGeom prst="rect">
              <a:avLst/>
            </a:prstGeom>
          </p:spPr>
        </p:pic>
      </p:grp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2AC0770C-922C-0B51-3E36-172FDC4574DE}"/>
              </a:ext>
            </a:extLst>
          </p:cNvPr>
          <p:cNvCxnSpPr>
            <a:cxnSpLocks/>
          </p:cNvCxnSpPr>
          <p:nvPr/>
        </p:nvCxnSpPr>
        <p:spPr>
          <a:xfrm>
            <a:off x="1081008" y="250149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7D9EF8E1-E35F-81F6-F3EF-39CD7B8708EF}"/>
              </a:ext>
            </a:extLst>
          </p:cNvPr>
          <p:cNvCxnSpPr>
            <a:cxnSpLocks/>
          </p:cNvCxnSpPr>
          <p:nvPr/>
        </p:nvCxnSpPr>
        <p:spPr>
          <a:xfrm>
            <a:off x="1314742" y="250149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8BA8A0DD-4FDD-83C6-DF10-E27B81520C50}"/>
              </a:ext>
            </a:extLst>
          </p:cNvPr>
          <p:cNvCxnSpPr>
            <a:cxnSpLocks/>
          </p:cNvCxnSpPr>
          <p:nvPr/>
        </p:nvCxnSpPr>
        <p:spPr>
          <a:xfrm>
            <a:off x="1542759" y="199761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D640C4B6-7D6C-160C-314F-C74F5CDE08D3}"/>
              </a:ext>
            </a:extLst>
          </p:cNvPr>
          <p:cNvCxnSpPr>
            <a:cxnSpLocks/>
          </p:cNvCxnSpPr>
          <p:nvPr/>
        </p:nvCxnSpPr>
        <p:spPr>
          <a:xfrm>
            <a:off x="1773485" y="200525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83A0017D-BD08-3CFD-3AE6-2260B1F660DC}"/>
              </a:ext>
            </a:extLst>
          </p:cNvPr>
          <p:cNvCxnSpPr>
            <a:cxnSpLocks/>
          </p:cNvCxnSpPr>
          <p:nvPr/>
        </p:nvCxnSpPr>
        <p:spPr>
          <a:xfrm>
            <a:off x="2056842" y="207418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5C80355F-9415-28ED-375D-1F123AAFAB9A}"/>
              </a:ext>
            </a:extLst>
          </p:cNvPr>
          <p:cNvCxnSpPr>
            <a:cxnSpLocks/>
          </p:cNvCxnSpPr>
          <p:nvPr/>
        </p:nvCxnSpPr>
        <p:spPr>
          <a:xfrm>
            <a:off x="2247562" y="200525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38DC6FCB-9B95-35F4-E691-9C8D15B5A6D7}"/>
              </a:ext>
            </a:extLst>
          </p:cNvPr>
          <p:cNvCxnSpPr>
            <a:cxnSpLocks/>
          </p:cNvCxnSpPr>
          <p:nvPr/>
        </p:nvCxnSpPr>
        <p:spPr>
          <a:xfrm>
            <a:off x="2516001" y="192727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C73A577B-7734-ED2E-CAA9-BC945419D523}"/>
              </a:ext>
            </a:extLst>
          </p:cNvPr>
          <p:cNvCxnSpPr>
            <a:cxnSpLocks/>
          </p:cNvCxnSpPr>
          <p:nvPr/>
        </p:nvCxnSpPr>
        <p:spPr>
          <a:xfrm>
            <a:off x="2721639" y="183519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27EA8094-48AE-27CF-C7FA-B3C8537E5644}"/>
              </a:ext>
            </a:extLst>
          </p:cNvPr>
          <p:cNvCxnSpPr>
            <a:cxnSpLocks/>
          </p:cNvCxnSpPr>
          <p:nvPr/>
        </p:nvCxnSpPr>
        <p:spPr>
          <a:xfrm>
            <a:off x="2924512" y="163839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AD5B44EE-462D-5502-F3D8-1DFE2B3EE27A}"/>
              </a:ext>
            </a:extLst>
          </p:cNvPr>
          <p:cNvCxnSpPr>
            <a:cxnSpLocks/>
          </p:cNvCxnSpPr>
          <p:nvPr/>
        </p:nvCxnSpPr>
        <p:spPr>
          <a:xfrm>
            <a:off x="3206877" y="163839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7ACF0F1A-3BA7-C292-68A1-F2F32D4FFF0F}"/>
              </a:ext>
            </a:extLst>
          </p:cNvPr>
          <p:cNvCxnSpPr>
            <a:cxnSpLocks/>
          </p:cNvCxnSpPr>
          <p:nvPr/>
        </p:nvCxnSpPr>
        <p:spPr>
          <a:xfrm>
            <a:off x="3926586" y="212185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2F8F6704-6B4E-C396-4695-7E33C2C15730}"/>
              </a:ext>
            </a:extLst>
          </p:cNvPr>
          <p:cNvCxnSpPr>
            <a:cxnSpLocks/>
          </p:cNvCxnSpPr>
          <p:nvPr/>
        </p:nvCxnSpPr>
        <p:spPr>
          <a:xfrm>
            <a:off x="4199208" y="212185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88F707F5-011F-5433-7225-219F7A213437}"/>
              </a:ext>
            </a:extLst>
          </p:cNvPr>
          <p:cNvCxnSpPr>
            <a:cxnSpLocks/>
          </p:cNvCxnSpPr>
          <p:nvPr/>
        </p:nvCxnSpPr>
        <p:spPr>
          <a:xfrm>
            <a:off x="4440669" y="204973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>
            <a:extLst>
              <a:ext uri="{FF2B5EF4-FFF2-40B4-BE49-F238E27FC236}">
                <a16:creationId xmlns:a16="http://schemas.microsoft.com/office/drawing/2014/main" id="{076B7510-BA9B-9AD3-64B9-87A35889456A}"/>
              </a:ext>
            </a:extLst>
          </p:cNvPr>
          <p:cNvCxnSpPr>
            <a:cxnSpLocks/>
          </p:cNvCxnSpPr>
          <p:nvPr/>
        </p:nvCxnSpPr>
        <p:spPr>
          <a:xfrm>
            <a:off x="4690662" y="19131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Arrow Connector 31">
            <a:extLst>
              <a:ext uri="{FF2B5EF4-FFF2-40B4-BE49-F238E27FC236}">
                <a16:creationId xmlns:a16="http://schemas.microsoft.com/office/drawing/2014/main" id="{02CFCAAC-6451-BE6E-D4AB-D8264CB847FB}"/>
              </a:ext>
            </a:extLst>
          </p:cNvPr>
          <p:cNvCxnSpPr>
            <a:cxnSpLocks/>
          </p:cNvCxnSpPr>
          <p:nvPr/>
        </p:nvCxnSpPr>
        <p:spPr>
          <a:xfrm>
            <a:off x="4899828" y="197194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>
            <a:extLst>
              <a:ext uri="{FF2B5EF4-FFF2-40B4-BE49-F238E27FC236}">
                <a16:creationId xmlns:a16="http://schemas.microsoft.com/office/drawing/2014/main" id="{AFFB253D-2AA0-4074-EBF0-8111C21FE161}"/>
              </a:ext>
            </a:extLst>
          </p:cNvPr>
          <p:cNvCxnSpPr>
            <a:cxnSpLocks/>
          </p:cNvCxnSpPr>
          <p:nvPr/>
        </p:nvCxnSpPr>
        <p:spPr>
          <a:xfrm>
            <a:off x="5110063" y="19131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33">
            <a:extLst>
              <a:ext uri="{FF2B5EF4-FFF2-40B4-BE49-F238E27FC236}">
                <a16:creationId xmlns:a16="http://schemas.microsoft.com/office/drawing/2014/main" id="{C438BCA1-7BE6-65F6-AA19-017E6C5CA863}"/>
              </a:ext>
            </a:extLst>
          </p:cNvPr>
          <p:cNvCxnSpPr>
            <a:cxnSpLocks/>
          </p:cNvCxnSpPr>
          <p:nvPr/>
        </p:nvCxnSpPr>
        <p:spPr>
          <a:xfrm>
            <a:off x="5372866" y="171143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Arrow Connector 34">
            <a:extLst>
              <a:ext uri="{FF2B5EF4-FFF2-40B4-BE49-F238E27FC236}">
                <a16:creationId xmlns:a16="http://schemas.microsoft.com/office/drawing/2014/main" id="{538D5689-551B-9DB7-99E3-22F558F267BB}"/>
              </a:ext>
            </a:extLst>
          </p:cNvPr>
          <p:cNvCxnSpPr>
            <a:cxnSpLocks/>
          </p:cNvCxnSpPr>
          <p:nvPr/>
        </p:nvCxnSpPr>
        <p:spPr>
          <a:xfrm>
            <a:off x="5634114" y="168363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>
            <a:extLst>
              <a:ext uri="{FF2B5EF4-FFF2-40B4-BE49-F238E27FC236}">
                <a16:creationId xmlns:a16="http://schemas.microsoft.com/office/drawing/2014/main" id="{D8BB7339-7458-897F-3B5E-95399947B36D}"/>
              </a:ext>
            </a:extLst>
          </p:cNvPr>
          <p:cNvCxnSpPr>
            <a:cxnSpLocks/>
          </p:cNvCxnSpPr>
          <p:nvPr/>
        </p:nvCxnSpPr>
        <p:spPr>
          <a:xfrm>
            <a:off x="5839344" y="190553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29752171-B4F2-05F1-0F29-E17DC8B80B86}"/>
              </a:ext>
            </a:extLst>
          </p:cNvPr>
          <p:cNvCxnSpPr>
            <a:cxnSpLocks/>
          </p:cNvCxnSpPr>
          <p:nvPr/>
        </p:nvCxnSpPr>
        <p:spPr>
          <a:xfrm>
            <a:off x="6059415" y="192727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78F266F4-BC13-14B3-EC7C-3E28D343EEBC}"/>
              </a:ext>
            </a:extLst>
          </p:cNvPr>
          <p:cNvCxnSpPr>
            <a:cxnSpLocks/>
          </p:cNvCxnSpPr>
          <p:nvPr/>
        </p:nvCxnSpPr>
        <p:spPr>
          <a:xfrm>
            <a:off x="6797677" y="173232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30C96A95-7DD4-3ECC-CC21-DE714BDB61FB}"/>
              </a:ext>
            </a:extLst>
          </p:cNvPr>
          <p:cNvCxnSpPr>
            <a:cxnSpLocks/>
          </p:cNvCxnSpPr>
          <p:nvPr/>
        </p:nvCxnSpPr>
        <p:spPr>
          <a:xfrm>
            <a:off x="7027387" y="176199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9ADB31F9-7CC1-8D92-DC67-F236B062487F}"/>
              </a:ext>
            </a:extLst>
          </p:cNvPr>
          <p:cNvCxnSpPr>
            <a:cxnSpLocks/>
          </p:cNvCxnSpPr>
          <p:nvPr/>
        </p:nvCxnSpPr>
        <p:spPr>
          <a:xfrm>
            <a:off x="7252353" y="201934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9A53D0F9-D9EB-1532-81CF-1D4A008DC192}"/>
              </a:ext>
            </a:extLst>
          </p:cNvPr>
          <p:cNvCxnSpPr>
            <a:cxnSpLocks/>
          </p:cNvCxnSpPr>
          <p:nvPr/>
        </p:nvCxnSpPr>
        <p:spPr>
          <a:xfrm>
            <a:off x="7483470" y="197194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8F637394-662F-7829-E23E-53CF93108DE8}"/>
              </a:ext>
            </a:extLst>
          </p:cNvPr>
          <p:cNvCxnSpPr>
            <a:cxnSpLocks/>
          </p:cNvCxnSpPr>
          <p:nvPr/>
        </p:nvCxnSpPr>
        <p:spPr>
          <a:xfrm>
            <a:off x="7774890" y="169406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0535134F-2FBB-CD03-858A-28DCC312DA26}"/>
              </a:ext>
            </a:extLst>
          </p:cNvPr>
          <p:cNvCxnSpPr>
            <a:cxnSpLocks/>
          </p:cNvCxnSpPr>
          <p:nvPr/>
        </p:nvCxnSpPr>
        <p:spPr>
          <a:xfrm>
            <a:off x="7975528" y="166991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ED74B5A9-75A0-80BE-0EFB-566F07A0565A}"/>
              </a:ext>
            </a:extLst>
          </p:cNvPr>
          <p:cNvCxnSpPr>
            <a:cxnSpLocks/>
          </p:cNvCxnSpPr>
          <p:nvPr/>
        </p:nvCxnSpPr>
        <p:spPr>
          <a:xfrm>
            <a:off x="8197778" y="250646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0D7F9F02-7071-9331-6F98-46A0A58645E7}"/>
              </a:ext>
            </a:extLst>
          </p:cNvPr>
          <p:cNvCxnSpPr>
            <a:cxnSpLocks/>
          </p:cNvCxnSpPr>
          <p:nvPr/>
        </p:nvCxnSpPr>
        <p:spPr>
          <a:xfrm>
            <a:off x="8416423" y="250149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F4EED615-4DF4-CE82-272B-BC5A2CD256C8}"/>
              </a:ext>
            </a:extLst>
          </p:cNvPr>
          <p:cNvCxnSpPr>
            <a:cxnSpLocks/>
          </p:cNvCxnSpPr>
          <p:nvPr/>
        </p:nvCxnSpPr>
        <p:spPr>
          <a:xfrm>
            <a:off x="8706021" y="263690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B103254A-F8DD-567A-426E-A011D247BBC9}"/>
              </a:ext>
            </a:extLst>
          </p:cNvPr>
          <p:cNvCxnSpPr>
            <a:cxnSpLocks/>
          </p:cNvCxnSpPr>
          <p:nvPr/>
        </p:nvCxnSpPr>
        <p:spPr>
          <a:xfrm>
            <a:off x="8955117" y="263690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>
            <a:extLst>
              <a:ext uri="{FF2B5EF4-FFF2-40B4-BE49-F238E27FC236}">
                <a16:creationId xmlns:a16="http://schemas.microsoft.com/office/drawing/2014/main" id="{BC02575F-FA49-BA68-3361-79B3F180E418}"/>
              </a:ext>
            </a:extLst>
          </p:cNvPr>
          <p:cNvSpPr txBox="1"/>
          <p:nvPr/>
        </p:nvSpPr>
        <p:spPr>
          <a:xfrm>
            <a:off x="3380794" y="760933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D5AA3E9D-0C29-7A9D-25F6-7E08AD5D5840}"/>
              </a:ext>
            </a:extLst>
          </p:cNvPr>
          <p:cNvSpPr txBox="1"/>
          <p:nvPr/>
        </p:nvSpPr>
        <p:spPr>
          <a:xfrm>
            <a:off x="6231625" y="767236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5012085-DF63-022F-F4A3-9BCF783CB518}"/>
              </a:ext>
            </a:extLst>
          </p:cNvPr>
          <p:cNvSpPr txBox="1"/>
          <p:nvPr/>
        </p:nvSpPr>
        <p:spPr>
          <a:xfrm>
            <a:off x="9101429" y="760933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E1B4CAF1-1148-765A-FC98-352691BC1058}"/>
              </a:ext>
            </a:extLst>
          </p:cNvPr>
          <p:cNvSpPr txBox="1"/>
          <p:nvPr/>
        </p:nvSpPr>
        <p:spPr>
          <a:xfrm>
            <a:off x="4118329" y="3470871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36EA676D-7F0A-3763-1D0D-593DDA9BF7C9}"/>
              </a:ext>
            </a:extLst>
          </p:cNvPr>
          <p:cNvSpPr txBox="1"/>
          <p:nvPr/>
        </p:nvSpPr>
        <p:spPr>
          <a:xfrm>
            <a:off x="6998840" y="3458741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D9EB0DDA-F8C0-5493-4DEE-8574E3855EC7}"/>
              </a:ext>
            </a:extLst>
          </p:cNvPr>
          <p:cNvSpPr txBox="1"/>
          <p:nvPr/>
        </p:nvSpPr>
        <p:spPr>
          <a:xfrm>
            <a:off x="9866119" y="3465674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10B76EA-BFB9-40E0-4436-2D63A7083B97}"/>
              </a:ext>
            </a:extLst>
          </p:cNvPr>
          <p:cNvSpPr txBox="1"/>
          <p:nvPr/>
        </p:nvSpPr>
        <p:spPr>
          <a:xfrm>
            <a:off x="776312" y="760933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8D2B0A7-026B-79FA-29FE-02C1A4E51C70}"/>
              </a:ext>
            </a:extLst>
          </p:cNvPr>
          <p:cNvSpPr txBox="1"/>
          <p:nvPr/>
        </p:nvSpPr>
        <p:spPr>
          <a:xfrm>
            <a:off x="3642890" y="769954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676B6D28-A11D-ABD4-CE85-85E443AC1448}"/>
              </a:ext>
            </a:extLst>
          </p:cNvPr>
          <p:cNvSpPr txBox="1"/>
          <p:nvPr/>
        </p:nvSpPr>
        <p:spPr>
          <a:xfrm>
            <a:off x="6506297" y="738658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C54BB05-7AEB-CFF5-4C80-057E4E4362C8}"/>
              </a:ext>
            </a:extLst>
          </p:cNvPr>
          <p:cNvSpPr txBox="1"/>
          <p:nvPr/>
        </p:nvSpPr>
        <p:spPr>
          <a:xfrm>
            <a:off x="1539594" y="3461509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542A38D-BDFD-B195-EB3B-C7B55483FFE6}"/>
              </a:ext>
            </a:extLst>
          </p:cNvPr>
          <p:cNvSpPr txBox="1"/>
          <p:nvPr/>
        </p:nvSpPr>
        <p:spPr>
          <a:xfrm>
            <a:off x="4411173" y="3474209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FAE062C-F5E7-4B59-8CE8-5FB717ABD3DC}"/>
              </a:ext>
            </a:extLst>
          </p:cNvPr>
          <p:cNvSpPr txBox="1"/>
          <p:nvPr/>
        </p:nvSpPr>
        <p:spPr>
          <a:xfrm>
            <a:off x="7279341" y="3487674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8A5DE02-A346-E48E-473B-59FDE9C56828}"/>
              </a:ext>
            </a:extLst>
          </p:cNvPr>
          <p:cNvSpPr txBox="1"/>
          <p:nvPr/>
        </p:nvSpPr>
        <p:spPr>
          <a:xfrm>
            <a:off x="49450" y="111956"/>
            <a:ext cx="4324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P3Net Supplementary figure 3 part 3 of 4</a:t>
            </a:r>
          </a:p>
        </p:txBody>
      </p:sp>
      <p:cxnSp>
        <p:nvCxnSpPr>
          <p:cNvPr id="4" name="Straight Arrow Connector 3">
            <a:extLst>
              <a:ext uri="{FF2B5EF4-FFF2-40B4-BE49-F238E27FC236}">
                <a16:creationId xmlns:a16="http://schemas.microsoft.com/office/drawing/2014/main" id="{C23AE187-DABE-ADB4-19E2-013BE9E28134}"/>
              </a:ext>
            </a:extLst>
          </p:cNvPr>
          <p:cNvCxnSpPr>
            <a:cxnSpLocks/>
          </p:cNvCxnSpPr>
          <p:nvPr/>
        </p:nvCxnSpPr>
        <p:spPr>
          <a:xfrm>
            <a:off x="1825816" y="491306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DBFA31D5-3282-0E1E-37C1-7BFFA51CB5A1}"/>
              </a:ext>
            </a:extLst>
          </p:cNvPr>
          <p:cNvCxnSpPr>
            <a:cxnSpLocks/>
          </p:cNvCxnSpPr>
          <p:nvPr/>
        </p:nvCxnSpPr>
        <p:spPr>
          <a:xfrm>
            <a:off x="2059457" y="48240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F57D97EC-CA3C-B693-8558-B7B1E50CF082}"/>
              </a:ext>
            </a:extLst>
          </p:cNvPr>
          <p:cNvCxnSpPr>
            <a:cxnSpLocks/>
          </p:cNvCxnSpPr>
          <p:nvPr/>
        </p:nvCxnSpPr>
        <p:spPr>
          <a:xfrm>
            <a:off x="2305905" y="47986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C406DAB3-83C6-4FA0-4470-E3A3B752E901}"/>
              </a:ext>
            </a:extLst>
          </p:cNvPr>
          <p:cNvCxnSpPr>
            <a:cxnSpLocks/>
          </p:cNvCxnSpPr>
          <p:nvPr/>
        </p:nvCxnSpPr>
        <p:spPr>
          <a:xfrm>
            <a:off x="2573540" y="472064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Straight Arrow Connector 60">
            <a:extLst>
              <a:ext uri="{FF2B5EF4-FFF2-40B4-BE49-F238E27FC236}">
                <a16:creationId xmlns:a16="http://schemas.microsoft.com/office/drawing/2014/main" id="{FEF68BF7-5F6C-BB6B-C7B2-D28748222E6D}"/>
              </a:ext>
            </a:extLst>
          </p:cNvPr>
          <p:cNvCxnSpPr>
            <a:cxnSpLocks/>
          </p:cNvCxnSpPr>
          <p:nvPr/>
        </p:nvCxnSpPr>
        <p:spPr>
          <a:xfrm>
            <a:off x="2799970" y="471008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Straight Arrow Connector 61">
            <a:extLst>
              <a:ext uri="{FF2B5EF4-FFF2-40B4-BE49-F238E27FC236}">
                <a16:creationId xmlns:a16="http://schemas.microsoft.com/office/drawing/2014/main" id="{D6931973-F5AE-6C6D-B00D-4813A1C47D64}"/>
              </a:ext>
            </a:extLst>
          </p:cNvPr>
          <p:cNvCxnSpPr>
            <a:cxnSpLocks/>
          </p:cNvCxnSpPr>
          <p:nvPr/>
        </p:nvCxnSpPr>
        <p:spPr>
          <a:xfrm>
            <a:off x="3029175" y="451766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>
            <a:extLst>
              <a:ext uri="{FF2B5EF4-FFF2-40B4-BE49-F238E27FC236}">
                <a16:creationId xmlns:a16="http://schemas.microsoft.com/office/drawing/2014/main" id="{0C50CBA1-DBB2-1AA3-676C-B51D204610AC}"/>
              </a:ext>
            </a:extLst>
          </p:cNvPr>
          <p:cNvCxnSpPr>
            <a:cxnSpLocks/>
          </p:cNvCxnSpPr>
          <p:nvPr/>
        </p:nvCxnSpPr>
        <p:spPr>
          <a:xfrm>
            <a:off x="3274655" y="445738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>
            <a:extLst>
              <a:ext uri="{FF2B5EF4-FFF2-40B4-BE49-F238E27FC236}">
                <a16:creationId xmlns:a16="http://schemas.microsoft.com/office/drawing/2014/main" id="{3C775E87-5331-761E-D3D1-2C097656C620}"/>
              </a:ext>
            </a:extLst>
          </p:cNvPr>
          <p:cNvCxnSpPr>
            <a:cxnSpLocks/>
          </p:cNvCxnSpPr>
          <p:nvPr/>
        </p:nvCxnSpPr>
        <p:spPr>
          <a:xfrm>
            <a:off x="3489105" y="490479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Straight Arrow Connector 64">
            <a:extLst>
              <a:ext uri="{FF2B5EF4-FFF2-40B4-BE49-F238E27FC236}">
                <a16:creationId xmlns:a16="http://schemas.microsoft.com/office/drawing/2014/main" id="{3ABECC7B-60FD-8E33-2A88-B9745DA8FFCE}"/>
              </a:ext>
            </a:extLst>
          </p:cNvPr>
          <p:cNvCxnSpPr>
            <a:cxnSpLocks/>
          </p:cNvCxnSpPr>
          <p:nvPr/>
        </p:nvCxnSpPr>
        <p:spPr>
          <a:xfrm>
            <a:off x="3722746" y="497916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>
            <a:extLst>
              <a:ext uri="{FF2B5EF4-FFF2-40B4-BE49-F238E27FC236}">
                <a16:creationId xmlns:a16="http://schemas.microsoft.com/office/drawing/2014/main" id="{66AAED11-6E90-0EF3-5419-D70E3BABC659}"/>
              </a:ext>
            </a:extLst>
          </p:cNvPr>
          <p:cNvCxnSpPr>
            <a:cxnSpLocks/>
          </p:cNvCxnSpPr>
          <p:nvPr/>
        </p:nvCxnSpPr>
        <p:spPr>
          <a:xfrm>
            <a:off x="4728105" y="478721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>
            <a:extLst>
              <a:ext uri="{FF2B5EF4-FFF2-40B4-BE49-F238E27FC236}">
                <a16:creationId xmlns:a16="http://schemas.microsoft.com/office/drawing/2014/main" id="{CD9C7C1B-C661-6491-160C-4470398DFEAB}"/>
              </a:ext>
            </a:extLst>
          </p:cNvPr>
          <p:cNvCxnSpPr>
            <a:cxnSpLocks/>
          </p:cNvCxnSpPr>
          <p:nvPr/>
        </p:nvCxnSpPr>
        <p:spPr>
          <a:xfrm>
            <a:off x="3963277" y="478035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Straight Arrow Connector 67">
            <a:extLst>
              <a:ext uri="{FF2B5EF4-FFF2-40B4-BE49-F238E27FC236}">
                <a16:creationId xmlns:a16="http://schemas.microsoft.com/office/drawing/2014/main" id="{C892898A-5575-E26F-0603-CBFD3C0F9B34}"/>
              </a:ext>
            </a:extLst>
          </p:cNvPr>
          <p:cNvCxnSpPr>
            <a:cxnSpLocks/>
          </p:cNvCxnSpPr>
          <p:nvPr/>
        </p:nvCxnSpPr>
        <p:spPr>
          <a:xfrm>
            <a:off x="4964232" y="461919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Straight Arrow Connector 68">
            <a:extLst>
              <a:ext uri="{FF2B5EF4-FFF2-40B4-BE49-F238E27FC236}">
                <a16:creationId xmlns:a16="http://schemas.microsoft.com/office/drawing/2014/main" id="{8FA4288B-E4B4-39CA-D7DF-3C8B129922D0}"/>
              </a:ext>
            </a:extLst>
          </p:cNvPr>
          <p:cNvCxnSpPr>
            <a:cxnSpLocks/>
          </p:cNvCxnSpPr>
          <p:nvPr/>
        </p:nvCxnSpPr>
        <p:spPr>
          <a:xfrm>
            <a:off x="5176495" y="453649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0" name="Straight Arrow Connector 69">
            <a:extLst>
              <a:ext uri="{FF2B5EF4-FFF2-40B4-BE49-F238E27FC236}">
                <a16:creationId xmlns:a16="http://schemas.microsoft.com/office/drawing/2014/main" id="{6BEDF749-6B58-0C12-C15F-35C17429C0C6}"/>
              </a:ext>
            </a:extLst>
          </p:cNvPr>
          <p:cNvCxnSpPr>
            <a:cxnSpLocks/>
          </p:cNvCxnSpPr>
          <p:nvPr/>
        </p:nvCxnSpPr>
        <p:spPr>
          <a:xfrm>
            <a:off x="5432764" y="451766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1" name="Straight Arrow Connector 70">
            <a:extLst>
              <a:ext uri="{FF2B5EF4-FFF2-40B4-BE49-F238E27FC236}">
                <a16:creationId xmlns:a16="http://schemas.microsoft.com/office/drawing/2014/main" id="{BE33FF6F-E1BF-FC28-F628-714DAE179A87}"/>
              </a:ext>
            </a:extLst>
          </p:cNvPr>
          <p:cNvCxnSpPr>
            <a:cxnSpLocks/>
          </p:cNvCxnSpPr>
          <p:nvPr/>
        </p:nvCxnSpPr>
        <p:spPr>
          <a:xfrm>
            <a:off x="5652413" y="451766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Straight Arrow Connector 71">
            <a:extLst>
              <a:ext uri="{FF2B5EF4-FFF2-40B4-BE49-F238E27FC236}">
                <a16:creationId xmlns:a16="http://schemas.microsoft.com/office/drawing/2014/main" id="{3BA08637-337B-3917-4771-B5F61F7D693E}"/>
              </a:ext>
            </a:extLst>
          </p:cNvPr>
          <p:cNvCxnSpPr>
            <a:cxnSpLocks/>
          </p:cNvCxnSpPr>
          <p:nvPr/>
        </p:nvCxnSpPr>
        <p:spPr>
          <a:xfrm>
            <a:off x="5908339" y="468759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Arrow Connector 72">
            <a:extLst>
              <a:ext uri="{FF2B5EF4-FFF2-40B4-BE49-F238E27FC236}">
                <a16:creationId xmlns:a16="http://schemas.microsoft.com/office/drawing/2014/main" id="{8A369BF5-05F1-37F6-0D05-B985FFC6A376}"/>
              </a:ext>
            </a:extLst>
          </p:cNvPr>
          <p:cNvCxnSpPr>
            <a:cxnSpLocks/>
          </p:cNvCxnSpPr>
          <p:nvPr/>
        </p:nvCxnSpPr>
        <p:spPr>
          <a:xfrm>
            <a:off x="6121960" y="465844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>
            <a:extLst>
              <a:ext uri="{FF2B5EF4-FFF2-40B4-BE49-F238E27FC236}">
                <a16:creationId xmlns:a16="http://schemas.microsoft.com/office/drawing/2014/main" id="{08894F4C-9B88-8D2A-7EEF-F79A491F2807}"/>
              </a:ext>
            </a:extLst>
          </p:cNvPr>
          <p:cNvCxnSpPr>
            <a:cxnSpLocks/>
          </p:cNvCxnSpPr>
          <p:nvPr/>
        </p:nvCxnSpPr>
        <p:spPr>
          <a:xfrm>
            <a:off x="6370493" y="456261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>
            <a:extLst>
              <a:ext uri="{FF2B5EF4-FFF2-40B4-BE49-F238E27FC236}">
                <a16:creationId xmlns:a16="http://schemas.microsoft.com/office/drawing/2014/main" id="{3780740A-81F1-38D4-CF9C-0439118AE3C8}"/>
              </a:ext>
            </a:extLst>
          </p:cNvPr>
          <p:cNvCxnSpPr>
            <a:cxnSpLocks/>
          </p:cNvCxnSpPr>
          <p:nvPr/>
        </p:nvCxnSpPr>
        <p:spPr>
          <a:xfrm>
            <a:off x="6623242" y="455696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6" name="Straight Arrow Connector 75">
            <a:extLst>
              <a:ext uri="{FF2B5EF4-FFF2-40B4-BE49-F238E27FC236}">
                <a16:creationId xmlns:a16="http://schemas.microsoft.com/office/drawing/2014/main" id="{EBFE06B6-C6FB-E8C3-3E2D-2F3B255FC173}"/>
              </a:ext>
            </a:extLst>
          </p:cNvPr>
          <p:cNvCxnSpPr>
            <a:cxnSpLocks/>
          </p:cNvCxnSpPr>
          <p:nvPr/>
        </p:nvCxnSpPr>
        <p:spPr>
          <a:xfrm>
            <a:off x="6876058" y="482220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Straight Arrow Connector 76">
            <a:extLst>
              <a:ext uri="{FF2B5EF4-FFF2-40B4-BE49-F238E27FC236}">
                <a16:creationId xmlns:a16="http://schemas.microsoft.com/office/drawing/2014/main" id="{30DBD22C-4466-E765-2610-04B400E6782C}"/>
              </a:ext>
            </a:extLst>
          </p:cNvPr>
          <p:cNvCxnSpPr>
            <a:cxnSpLocks/>
          </p:cNvCxnSpPr>
          <p:nvPr/>
        </p:nvCxnSpPr>
        <p:spPr>
          <a:xfrm>
            <a:off x="7558120" y="474860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8" name="Straight Arrow Connector 77">
            <a:extLst>
              <a:ext uri="{FF2B5EF4-FFF2-40B4-BE49-F238E27FC236}">
                <a16:creationId xmlns:a16="http://schemas.microsoft.com/office/drawing/2014/main" id="{F26A999A-C930-D756-0952-CADBF38D577A}"/>
              </a:ext>
            </a:extLst>
          </p:cNvPr>
          <p:cNvCxnSpPr>
            <a:cxnSpLocks/>
          </p:cNvCxnSpPr>
          <p:nvPr/>
        </p:nvCxnSpPr>
        <p:spPr>
          <a:xfrm>
            <a:off x="7791120" y="451557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9" name="Straight Arrow Connector 78">
            <a:extLst>
              <a:ext uri="{FF2B5EF4-FFF2-40B4-BE49-F238E27FC236}">
                <a16:creationId xmlns:a16="http://schemas.microsoft.com/office/drawing/2014/main" id="{FFAC582A-624E-D9F7-9AF4-A5D424EFEF6B}"/>
              </a:ext>
            </a:extLst>
          </p:cNvPr>
          <p:cNvCxnSpPr>
            <a:cxnSpLocks/>
          </p:cNvCxnSpPr>
          <p:nvPr/>
        </p:nvCxnSpPr>
        <p:spPr>
          <a:xfrm>
            <a:off x="8027859" y="446489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0" name="Straight Arrow Connector 79">
            <a:extLst>
              <a:ext uri="{FF2B5EF4-FFF2-40B4-BE49-F238E27FC236}">
                <a16:creationId xmlns:a16="http://schemas.microsoft.com/office/drawing/2014/main" id="{324A6A44-5BCD-020C-716C-1C4C7AC506B5}"/>
              </a:ext>
            </a:extLst>
          </p:cNvPr>
          <p:cNvCxnSpPr>
            <a:cxnSpLocks/>
          </p:cNvCxnSpPr>
          <p:nvPr/>
        </p:nvCxnSpPr>
        <p:spPr>
          <a:xfrm>
            <a:off x="8264512" y="522485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Straight Arrow Connector 80">
            <a:extLst>
              <a:ext uri="{FF2B5EF4-FFF2-40B4-BE49-F238E27FC236}">
                <a16:creationId xmlns:a16="http://schemas.microsoft.com/office/drawing/2014/main" id="{03ABC49E-7FD3-2123-403E-92ED4551406F}"/>
              </a:ext>
            </a:extLst>
          </p:cNvPr>
          <p:cNvCxnSpPr>
            <a:cxnSpLocks/>
          </p:cNvCxnSpPr>
          <p:nvPr/>
        </p:nvCxnSpPr>
        <p:spPr>
          <a:xfrm>
            <a:off x="8522657" y="522365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>
            <a:extLst>
              <a:ext uri="{FF2B5EF4-FFF2-40B4-BE49-F238E27FC236}">
                <a16:creationId xmlns:a16="http://schemas.microsoft.com/office/drawing/2014/main" id="{DD798D08-3E98-2A04-CCE3-D9797D2B532F}"/>
              </a:ext>
            </a:extLst>
          </p:cNvPr>
          <p:cNvCxnSpPr>
            <a:cxnSpLocks/>
          </p:cNvCxnSpPr>
          <p:nvPr/>
        </p:nvCxnSpPr>
        <p:spPr>
          <a:xfrm>
            <a:off x="8767192" y="531071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>
            <a:extLst>
              <a:ext uri="{FF2B5EF4-FFF2-40B4-BE49-F238E27FC236}">
                <a16:creationId xmlns:a16="http://schemas.microsoft.com/office/drawing/2014/main" id="{F9036E11-89B6-9536-C511-B2768A801580}"/>
              </a:ext>
            </a:extLst>
          </p:cNvPr>
          <p:cNvCxnSpPr>
            <a:cxnSpLocks/>
          </p:cNvCxnSpPr>
          <p:nvPr/>
        </p:nvCxnSpPr>
        <p:spPr>
          <a:xfrm>
            <a:off x="8996766" y="53114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>
            <a:extLst>
              <a:ext uri="{FF2B5EF4-FFF2-40B4-BE49-F238E27FC236}">
                <a16:creationId xmlns:a16="http://schemas.microsoft.com/office/drawing/2014/main" id="{2A22E7C0-375C-9B8E-1BE7-5D942AA3FEC8}"/>
              </a:ext>
            </a:extLst>
          </p:cNvPr>
          <p:cNvCxnSpPr>
            <a:cxnSpLocks/>
          </p:cNvCxnSpPr>
          <p:nvPr/>
        </p:nvCxnSpPr>
        <p:spPr>
          <a:xfrm>
            <a:off x="9234639" y="488708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>
            <a:extLst>
              <a:ext uri="{FF2B5EF4-FFF2-40B4-BE49-F238E27FC236}">
                <a16:creationId xmlns:a16="http://schemas.microsoft.com/office/drawing/2014/main" id="{9E637CCF-6DCC-E651-1655-DE535B20AA58}"/>
              </a:ext>
            </a:extLst>
          </p:cNvPr>
          <p:cNvCxnSpPr>
            <a:cxnSpLocks/>
          </p:cNvCxnSpPr>
          <p:nvPr/>
        </p:nvCxnSpPr>
        <p:spPr>
          <a:xfrm>
            <a:off x="9475170" y="4904798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>
            <a:extLst>
              <a:ext uri="{FF2B5EF4-FFF2-40B4-BE49-F238E27FC236}">
                <a16:creationId xmlns:a16="http://schemas.microsoft.com/office/drawing/2014/main" id="{BB4F7D5F-8A51-24A7-67D7-4AB8FAB39DEF}"/>
              </a:ext>
            </a:extLst>
          </p:cNvPr>
          <p:cNvCxnSpPr>
            <a:cxnSpLocks/>
          </p:cNvCxnSpPr>
          <p:nvPr/>
        </p:nvCxnSpPr>
        <p:spPr>
          <a:xfrm>
            <a:off x="9671891" y="465844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7643320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E77E8AB-714A-4551-5F1C-0C33B9CC013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83CCD63F-CBE9-51DD-A38D-CDDEAB7BDEB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1078" y="880364"/>
            <a:ext cx="514083" cy="2517805"/>
          </a:xfrm>
          <a:prstGeom prst="rect">
            <a:avLst/>
          </a:prstGeom>
        </p:spPr>
      </p:pic>
      <p:pic>
        <p:nvPicPr>
          <p:cNvPr id="3" name="Picture 2" descr="A close-up of a dna&#10;&#10;Description automatically generated">
            <a:extLst>
              <a:ext uri="{FF2B5EF4-FFF2-40B4-BE49-F238E27FC236}">
                <a16:creationId xmlns:a16="http://schemas.microsoft.com/office/drawing/2014/main" id="{8CA1C87E-883E-BA70-23C3-E44D7AEFFD0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15161" y="923114"/>
            <a:ext cx="2883408" cy="2432304"/>
          </a:xfrm>
          <a:prstGeom prst="rect">
            <a:avLst/>
          </a:prstGeom>
        </p:spPr>
      </p:pic>
      <p:pic>
        <p:nvPicPr>
          <p:cNvPr id="4" name="Picture 3" descr="A close-up of a dna&#10;&#10;Description automatically generated">
            <a:extLst>
              <a:ext uri="{FF2B5EF4-FFF2-40B4-BE49-F238E27FC236}">
                <a16:creationId xmlns:a16="http://schemas.microsoft.com/office/drawing/2014/main" id="{1C7181D0-E715-269B-E490-C8A786FE1CB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966"/>
          <a:stretch/>
        </p:blipFill>
        <p:spPr>
          <a:xfrm>
            <a:off x="3698569" y="898730"/>
            <a:ext cx="2919984" cy="243230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2DF8740-5BCA-3605-06CA-F6F08F1F560C}"/>
              </a:ext>
            </a:extLst>
          </p:cNvPr>
          <p:cNvSpPr txBox="1"/>
          <p:nvPr/>
        </p:nvSpPr>
        <p:spPr>
          <a:xfrm>
            <a:off x="982764" y="712863"/>
            <a:ext cx="8580234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 78 79  80 81 82 83  84 85 86 87               88  89 90 91 92  93 94 95  96 97</a:t>
            </a:r>
            <a:endParaRPr lang="en-SE" sz="1400" dirty="0" err="1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FDB3200E-225F-B7ED-2A72-3DC0DFCAD34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90152" y="3764351"/>
            <a:ext cx="514083" cy="2517805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2DC99FE-EC9A-A798-3C5B-FFC2D23DE4EE}"/>
              </a:ext>
            </a:extLst>
          </p:cNvPr>
          <p:cNvSpPr txBox="1"/>
          <p:nvPr/>
        </p:nvSpPr>
        <p:spPr>
          <a:xfrm>
            <a:off x="1762694" y="3526967"/>
            <a:ext cx="8580234" cy="2862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 81 82 83 84 85 86 87 88  89 90               91 92  93 94 95  96 97</a:t>
            </a:r>
            <a:endParaRPr lang="en-SE" sz="1400" dirty="0" err="1"/>
          </a:p>
        </p:txBody>
      </p:sp>
      <p:pic>
        <p:nvPicPr>
          <p:cNvPr id="8" name="Picture 7" descr="A close-up of a dna&#10;&#10;AI-generated content may be incorrect.">
            <a:extLst>
              <a:ext uri="{FF2B5EF4-FFF2-40B4-BE49-F238E27FC236}">
                <a16:creationId xmlns:a16="http://schemas.microsoft.com/office/drawing/2014/main" id="{C5124BF0-0DC7-D3FE-41B4-2BFD77C4850B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04235" y="3781168"/>
            <a:ext cx="2859024" cy="2478024"/>
          </a:xfrm>
          <a:prstGeom prst="rect">
            <a:avLst/>
          </a:prstGeom>
        </p:spPr>
      </p:pic>
      <p:pic>
        <p:nvPicPr>
          <p:cNvPr id="9" name="Picture 8" descr="A close-up of a dna sequence&#10;&#10;AI-generated content may be incorrect.">
            <a:extLst>
              <a:ext uri="{FF2B5EF4-FFF2-40B4-BE49-F238E27FC236}">
                <a16:creationId xmlns:a16="http://schemas.microsoft.com/office/drawing/2014/main" id="{48AE9BFA-CFB9-3DA2-5E26-AC562BE53B2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259" y="3781168"/>
            <a:ext cx="2221992" cy="2447544"/>
          </a:xfrm>
          <a:prstGeom prst="rect">
            <a:avLst/>
          </a:prstGeom>
        </p:spPr>
      </p:pic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FD771B6B-1C11-B51F-A5B7-A8E3AC6E7A7B}"/>
              </a:ext>
            </a:extLst>
          </p:cNvPr>
          <p:cNvCxnSpPr>
            <a:cxnSpLocks/>
          </p:cNvCxnSpPr>
          <p:nvPr/>
        </p:nvCxnSpPr>
        <p:spPr>
          <a:xfrm>
            <a:off x="1090152" y="211488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8BB05114-C841-9930-1CAF-000228EEF478}"/>
              </a:ext>
            </a:extLst>
          </p:cNvPr>
          <p:cNvCxnSpPr>
            <a:cxnSpLocks/>
          </p:cNvCxnSpPr>
          <p:nvPr/>
        </p:nvCxnSpPr>
        <p:spPr>
          <a:xfrm>
            <a:off x="1329244" y="215752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623BF8F5-594B-163F-2F73-3DDCD1199DB5}"/>
              </a:ext>
            </a:extLst>
          </p:cNvPr>
          <p:cNvCxnSpPr>
            <a:cxnSpLocks/>
          </p:cNvCxnSpPr>
          <p:nvPr/>
        </p:nvCxnSpPr>
        <p:spPr>
          <a:xfrm>
            <a:off x="1604235" y="190103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>
            <a:extLst>
              <a:ext uri="{FF2B5EF4-FFF2-40B4-BE49-F238E27FC236}">
                <a16:creationId xmlns:a16="http://schemas.microsoft.com/office/drawing/2014/main" id="{BDEA9E9F-4020-7F6B-01E8-5C37B7AD78E7}"/>
              </a:ext>
            </a:extLst>
          </p:cNvPr>
          <p:cNvCxnSpPr>
            <a:cxnSpLocks/>
          </p:cNvCxnSpPr>
          <p:nvPr/>
        </p:nvCxnSpPr>
        <p:spPr>
          <a:xfrm>
            <a:off x="1842828" y="203359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Arrow Connector 13">
            <a:extLst>
              <a:ext uri="{FF2B5EF4-FFF2-40B4-BE49-F238E27FC236}">
                <a16:creationId xmlns:a16="http://schemas.microsoft.com/office/drawing/2014/main" id="{D94EB99F-84C5-DEF6-0EDB-83B4412F4756}"/>
              </a:ext>
            </a:extLst>
          </p:cNvPr>
          <p:cNvCxnSpPr>
            <a:cxnSpLocks/>
          </p:cNvCxnSpPr>
          <p:nvPr/>
        </p:nvCxnSpPr>
        <p:spPr>
          <a:xfrm>
            <a:off x="2042385" y="166575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3A4F1B28-B731-0678-4FCA-F1CDA6F3D8D4}"/>
              </a:ext>
            </a:extLst>
          </p:cNvPr>
          <p:cNvCxnSpPr>
            <a:cxnSpLocks/>
          </p:cNvCxnSpPr>
          <p:nvPr/>
        </p:nvCxnSpPr>
        <p:spPr>
          <a:xfrm>
            <a:off x="2291230" y="165210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EC3E2187-1BA7-36E1-6F7F-C715A4B96603}"/>
              </a:ext>
            </a:extLst>
          </p:cNvPr>
          <p:cNvCxnSpPr>
            <a:cxnSpLocks/>
          </p:cNvCxnSpPr>
          <p:nvPr/>
        </p:nvCxnSpPr>
        <p:spPr>
          <a:xfrm>
            <a:off x="2532105" y="198680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45572EF1-14B2-E60E-A55A-4F5D2A20F529}"/>
              </a:ext>
            </a:extLst>
          </p:cNvPr>
          <p:cNvCxnSpPr>
            <a:cxnSpLocks/>
          </p:cNvCxnSpPr>
          <p:nvPr/>
        </p:nvCxnSpPr>
        <p:spPr>
          <a:xfrm>
            <a:off x="2752500" y="2000893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C8CB15AF-D79B-BF0A-E6AE-64386112A7AF}"/>
              </a:ext>
            </a:extLst>
          </p:cNvPr>
          <p:cNvCxnSpPr>
            <a:cxnSpLocks/>
          </p:cNvCxnSpPr>
          <p:nvPr/>
        </p:nvCxnSpPr>
        <p:spPr>
          <a:xfrm>
            <a:off x="2975160" y="148623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Straight Arrow Connector 18">
            <a:extLst>
              <a:ext uri="{FF2B5EF4-FFF2-40B4-BE49-F238E27FC236}">
                <a16:creationId xmlns:a16="http://schemas.microsoft.com/office/drawing/2014/main" id="{2C2A32B4-D5C4-01E2-8224-C4DB91B8CA30}"/>
              </a:ext>
            </a:extLst>
          </p:cNvPr>
          <p:cNvCxnSpPr>
            <a:cxnSpLocks/>
          </p:cNvCxnSpPr>
          <p:nvPr/>
        </p:nvCxnSpPr>
        <p:spPr>
          <a:xfrm>
            <a:off x="3208849" y="148160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>
            <a:extLst>
              <a:ext uri="{FF2B5EF4-FFF2-40B4-BE49-F238E27FC236}">
                <a16:creationId xmlns:a16="http://schemas.microsoft.com/office/drawing/2014/main" id="{7516048E-35B8-AFB4-6C6D-EE8114EE568B}"/>
              </a:ext>
            </a:extLst>
          </p:cNvPr>
          <p:cNvCxnSpPr>
            <a:cxnSpLocks/>
          </p:cNvCxnSpPr>
          <p:nvPr/>
        </p:nvCxnSpPr>
        <p:spPr>
          <a:xfrm>
            <a:off x="3968563" y="146795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>
            <a:extLst>
              <a:ext uri="{FF2B5EF4-FFF2-40B4-BE49-F238E27FC236}">
                <a16:creationId xmlns:a16="http://schemas.microsoft.com/office/drawing/2014/main" id="{2903C79A-5DA6-EAF7-613A-0550B3BAF1AA}"/>
              </a:ext>
            </a:extLst>
          </p:cNvPr>
          <p:cNvCxnSpPr>
            <a:cxnSpLocks/>
          </p:cNvCxnSpPr>
          <p:nvPr/>
        </p:nvCxnSpPr>
        <p:spPr>
          <a:xfrm>
            <a:off x="4225504" y="146795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Arrow Connector 21">
            <a:extLst>
              <a:ext uri="{FF2B5EF4-FFF2-40B4-BE49-F238E27FC236}">
                <a16:creationId xmlns:a16="http://schemas.microsoft.com/office/drawing/2014/main" id="{F35C862D-4AF4-9C38-9907-675CE8AC2212}"/>
              </a:ext>
            </a:extLst>
          </p:cNvPr>
          <p:cNvCxnSpPr>
            <a:cxnSpLocks/>
          </p:cNvCxnSpPr>
          <p:nvPr/>
        </p:nvCxnSpPr>
        <p:spPr>
          <a:xfrm>
            <a:off x="4431912" y="204422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>
            <a:extLst>
              <a:ext uri="{FF2B5EF4-FFF2-40B4-BE49-F238E27FC236}">
                <a16:creationId xmlns:a16="http://schemas.microsoft.com/office/drawing/2014/main" id="{C6D2EFF1-8EF2-5206-5EB2-487EA617A373}"/>
              </a:ext>
            </a:extLst>
          </p:cNvPr>
          <p:cNvCxnSpPr>
            <a:cxnSpLocks/>
          </p:cNvCxnSpPr>
          <p:nvPr/>
        </p:nvCxnSpPr>
        <p:spPr>
          <a:xfrm>
            <a:off x="4695906" y="203787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>
            <a:extLst>
              <a:ext uri="{FF2B5EF4-FFF2-40B4-BE49-F238E27FC236}">
                <a16:creationId xmlns:a16="http://schemas.microsoft.com/office/drawing/2014/main" id="{02218CD1-BB08-DC2D-6877-C5A48BF5F48B}"/>
              </a:ext>
            </a:extLst>
          </p:cNvPr>
          <p:cNvCxnSpPr>
            <a:cxnSpLocks/>
          </p:cNvCxnSpPr>
          <p:nvPr/>
        </p:nvCxnSpPr>
        <p:spPr>
          <a:xfrm>
            <a:off x="4896582" y="176845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>
            <a:extLst>
              <a:ext uri="{FF2B5EF4-FFF2-40B4-BE49-F238E27FC236}">
                <a16:creationId xmlns:a16="http://schemas.microsoft.com/office/drawing/2014/main" id="{65EA94A7-A68F-640E-68F6-13A2B97CA061}"/>
              </a:ext>
            </a:extLst>
          </p:cNvPr>
          <p:cNvCxnSpPr>
            <a:cxnSpLocks/>
          </p:cNvCxnSpPr>
          <p:nvPr/>
        </p:nvCxnSpPr>
        <p:spPr>
          <a:xfrm>
            <a:off x="5158561" y="176845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7DC479C8-8BEB-FCEF-3B6B-8391213CB764}"/>
              </a:ext>
            </a:extLst>
          </p:cNvPr>
          <p:cNvCxnSpPr>
            <a:cxnSpLocks/>
          </p:cNvCxnSpPr>
          <p:nvPr/>
        </p:nvCxnSpPr>
        <p:spPr>
          <a:xfrm>
            <a:off x="5397315" y="2495949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54B44143-F408-3738-F321-D113FD2F8596}"/>
              </a:ext>
            </a:extLst>
          </p:cNvPr>
          <p:cNvCxnSpPr>
            <a:cxnSpLocks/>
          </p:cNvCxnSpPr>
          <p:nvPr/>
        </p:nvCxnSpPr>
        <p:spPr>
          <a:xfrm>
            <a:off x="5635908" y="226641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E53E401D-8E8C-331A-6BD5-838B294DF42B}"/>
              </a:ext>
            </a:extLst>
          </p:cNvPr>
          <p:cNvCxnSpPr>
            <a:cxnSpLocks/>
          </p:cNvCxnSpPr>
          <p:nvPr/>
        </p:nvCxnSpPr>
        <p:spPr>
          <a:xfrm>
            <a:off x="5858568" y="156044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>
            <a:extLst>
              <a:ext uri="{FF2B5EF4-FFF2-40B4-BE49-F238E27FC236}">
                <a16:creationId xmlns:a16="http://schemas.microsoft.com/office/drawing/2014/main" id="{7C677928-2E48-5035-CD47-3C58DF9E5DF4}"/>
              </a:ext>
            </a:extLst>
          </p:cNvPr>
          <p:cNvCxnSpPr>
            <a:cxnSpLocks/>
          </p:cNvCxnSpPr>
          <p:nvPr/>
        </p:nvCxnSpPr>
        <p:spPr>
          <a:xfrm>
            <a:off x="6093518" y="155143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>
            <a:extLst>
              <a:ext uri="{FF2B5EF4-FFF2-40B4-BE49-F238E27FC236}">
                <a16:creationId xmlns:a16="http://schemas.microsoft.com/office/drawing/2014/main" id="{5FA5A69D-B1D7-2FA5-99BF-2B6A32C8325E}"/>
              </a:ext>
            </a:extLst>
          </p:cNvPr>
          <p:cNvSpPr txBox="1"/>
          <p:nvPr/>
        </p:nvSpPr>
        <p:spPr>
          <a:xfrm>
            <a:off x="3412959" y="710565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2C0E6E30-0ECB-05C8-956C-E474CE6F158B}"/>
              </a:ext>
            </a:extLst>
          </p:cNvPr>
          <p:cNvSpPr txBox="1"/>
          <p:nvPr/>
        </p:nvSpPr>
        <p:spPr>
          <a:xfrm>
            <a:off x="6296367" y="703523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70AB3D72-EC3A-D06C-D0D4-09419D457DE7}"/>
              </a:ext>
            </a:extLst>
          </p:cNvPr>
          <p:cNvSpPr txBox="1"/>
          <p:nvPr/>
        </p:nvSpPr>
        <p:spPr>
          <a:xfrm>
            <a:off x="4144625" y="3526967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F3A2DAA-E69F-E767-FD00-1382F0D3EABC}"/>
              </a:ext>
            </a:extLst>
          </p:cNvPr>
          <p:cNvSpPr txBox="1"/>
          <p:nvPr/>
        </p:nvSpPr>
        <p:spPr>
          <a:xfrm>
            <a:off x="6296367" y="3526967"/>
            <a:ext cx="266420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S</a:t>
            </a:r>
            <a:endParaRPr lang="en-SE" sz="1400" dirty="0" err="1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2B67DEA-8E73-C65E-78DB-39BA9D3C7C7A}"/>
              </a:ext>
            </a:extLst>
          </p:cNvPr>
          <p:cNvSpPr txBox="1"/>
          <p:nvPr/>
        </p:nvSpPr>
        <p:spPr>
          <a:xfrm>
            <a:off x="788212" y="710565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229EDD76-327B-F4C0-D53C-0B1D9522CC22}"/>
              </a:ext>
            </a:extLst>
          </p:cNvPr>
          <p:cNvSpPr txBox="1"/>
          <p:nvPr/>
        </p:nvSpPr>
        <p:spPr>
          <a:xfrm>
            <a:off x="3664289" y="710565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5141C4E5-B86D-457C-76E1-29E43F3A1D57}"/>
              </a:ext>
            </a:extLst>
          </p:cNvPr>
          <p:cNvSpPr txBox="1"/>
          <p:nvPr/>
        </p:nvSpPr>
        <p:spPr>
          <a:xfrm>
            <a:off x="1553880" y="3543135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3A45F7E-D365-1B58-7693-AE3FB57E09D1}"/>
              </a:ext>
            </a:extLst>
          </p:cNvPr>
          <p:cNvSpPr txBox="1"/>
          <p:nvPr/>
        </p:nvSpPr>
        <p:spPr>
          <a:xfrm>
            <a:off x="4411045" y="3538449"/>
            <a:ext cx="338554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l">
              <a:lnSpc>
                <a:spcPct val="90000"/>
              </a:lnSpc>
              <a:spcAft>
                <a:spcPts val="600"/>
              </a:spcAft>
            </a:pPr>
            <a:r>
              <a:rPr lang="en-US" sz="1400" dirty="0"/>
              <a:t>M</a:t>
            </a:r>
            <a:endParaRPr lang="en-SE" sz="1400" dirty="0" err="1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D4E30DB-4B06-F0D8-F874-52F8C05EC24E}"/>
              </a:ext>
            </a:extLst>
          </p:cNvPr>
          <p:cNvSpPr txBox="1"/>
          <p:nvPr/>
        </p:nvSpPr>
        <p:spPr>
          <a:xfrm>
            <a:off x="49450" y="111956"/>
            <a:ext cx="43246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RP3Net Supplementary figure 3 part 4 of 4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CCC1DD5F-E722-4955-8EBB-3B7655391CDD}"/>
              </a:ext>
            </a:extLst>
          </p:cNvPr>
          <p:cNvCxnSpPr>
            <a:cxnSpLocks/>
          </p:cNvCxnSpPr>
          <p:nvPr/>
        </p:nvCxnSpPr>
        <p:spPr>
          <a:xfrm>
            <a:off x="1842828" y="493603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>
            <a:extLst>
              <a:ext uri="{FF2B5EF4-FFF2-40B4-BE49-F238E27FC236}">
                <a16:creationId xmlns:a16="http://schemas.microsoft.com/office/drawing/2014/main" id="{66E780A6-280C-EE23-36C6-FF52A49B155E}"/>
              </a:ext>
            </a:extLst>
          </p:cNvPr>
          <p:cNvCxnSpPr>
            <a:cxnSpLocks/>
          </p:cNvCxnSpPr>
          <p:nvPr/>
        </p:nvCxnSpPr>
        <p:spPr>
          <a:xfrm>
            <a:off x="2094716" y="455503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Arrow Connector 40">
            <a:extLst>
              <a:ext uri="{FF2B5EF4-FFF2-40B4-BE49-F238E27FC236}">
                <a16:creationId xmlns:a16="http://schemas.microsoft.com/office/drawing/2014/main" id="{03FEDEE1-5FC8-EBA7-0FE5-7F56DA152124}"/>
              </a:ext>
            </a:extLst>
          </p:cNvPr>
          <p:cNvCxnSpPr>
            <a:cxnSpLocks/>
          </p:cNvCxnSpPr>
          <p:nvPr/>
        </p:nvCxnSpPr>
        <p:spPr>
          <a:xfrm>
            <a:off x="2343561" y="455503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Arrow Connector 41">
            <a:extLst>
              <a:ext uri="{FF2B5EF4-FFF2-40B4-BE49-F238E27FC236}">
                <a16:creationId xmlns:a16="http://schemas.microsoft.com/office/drawing/2014/main" id="{6BF8145F-A042-8892-E128-DF7812BFF208}"/>
              </a:ext>
            </a:extLst>
          </p:cNvPr>
          <p:cNvCxnSpPr>
            <a:cxnSpLocks/>
          </p:cNvCxnSpPr>
          <p:nvPr/>
        </p:nvCxnSpPr>
        <p:spPr>
          <a:xfrm>
            <a:off x="2550341" y="484396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>
            <a:extLst>
              <a:ext uri="{FF2B5EF4-FFF2-40B4-BE49-F238E27FC236}">
                <a16:creationId xmlns:a16="http://schemas.microsoft.com/office/drawing/2014/main" id="{7DD78D2A-A9CB-0970-42C3-59CE51596A23}"/>
              </a:ext>
            </a:extLst>
          </p:cNvPr>
          <p:cNvCxnSpPr>
            <a:cxnSpLocks/>
          </p:cNvCxnSpPr>
          <p:nvPr/>
        </p:nvCxnSpPr>
        <p:spPr>
          <a:xfrm>
            <a:off x="2841265" y="485204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5D39A911-F4A5-B89B-CF6C-00E2FBAE784A}"/>
              </a:ext>
            </a:extLst>
          </p:cNvPr>
          <p:cNvCxnSpPr>
            <a:cxnSpLocks/>
          </p:cNvCxnSpPr>
          <p:nvPr/>
        </p:nvCxnSpPr>
        <p:spPr>
          <a:xfrm>
            <a:off x="3016903" y="437902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15869859-BA16-F814-AE2D-2C7AB0D9FAB6}"/>
              </a:ext>
            </a:extLst>
          </p:cNvPr>
          <p:cNvCxnSpPr>
            <a:cxnSpLocks/>
          </p:cNvCxnSpPr>
          <p:nvPr/>
        </p:nvCxnSpPr>
        <p:spPr>
          <a:xfrm>
            <a:off x="3265748" y="437088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>
            <a:extLst>
              <a:ext uri="{FF2B5EF4-FFF2-40B4-BE49-F238E27FC236}">
                <a16:creationId xmlns:a16="http://schemas.microsoft.com/office/drawing/2014/main" id="{C188B769-FD75-A990-02C0-4DECA6D7D19A}"/>
              </a:ext>
            </a:extLst>
          </p:cNvPr>
          <p:cNvCxnSpPr>
            <a:cxnSpLocks/>
          </p:cNvCxnSpPr>
          <p:nvPr/>
        </p:nvCxnSpPr>
        <p:spPr>
          <a:xfrm>
            <a:off x="3510995" y="4355710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>
            <a:extLst>
              <a:ext uri="{FF2B5EF4-FFF2-40B4-BE49-F238E27FC236}">
                <a16:creationId xmlns:a16="http://schemas.microsoft.com/office/drawing/2014/main" id="{5F98A461-57CB-4FDF-407D-5000768A1BA6}"/>
              </a:ext>
            </a:extLst>
          </p:cNvPr>
          <p:cNvCxnSpPr>
            <a:cxnSpLocks/>
          </p:cNvCxnSpPr>
          <p:nvPr/>
        </p:nvCxnSpPr>
        <p:spPr>
          <a:xfrm>
            <a:off x="3759840" y="432604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37FDB0FA-067D-EBE5-D97E-AFDB37967826}"/>
              </a:ext>
            </a:extLst>
          </p:cNvPr>
          <p:cNvCxnSpPr>
            <a:cxnSpLocks/>
          </p:cNvCxnSpPr>
          <p:nvPr/>
        </p:nvCxnSpPr>
        <p:spPr>
          <a:xfrm>
            <a:off x="3962526" y="484396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48">
            <a:extLst>
              <a:ext uri="{FF2B5EF4-FFF2-40B4-BE49-F238E27FC236}">
                <a16:creationId xmlns:a16="http://schemas.microsoft.com/office/drawing/2014/main" id="{CCE2459C-5AB1-0EFC-F39F-425019F6E3A7}"/>
              </a:ext>
            </a:extLst>
          </p:cNvPr>
          <p:cNvCxnSpPr>
            <a:cxnSpLocks/>
          </p:cNvCxnSpPr>
          <p:nvPr/>
        </p:nvCxnSpPr>
        <p:spPr>
          <a:xfrm>
            <a:off x="4700711" y="491445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B3D5D8C3-F6B4-61E4-D16D-A37483C8587D}"/>
              </a:ext>
            </a:extLst>
          </p:cNvPr>
          <p:cNvCxnSpPr>
            <a:cxnSpLocks/>
          </p:cNvCxnSpPr>
          <p:nvPr/>
        </p:nvCxnSpPr>
        <p:spPr>
          <a:xfrm>
            <a:off x="4941018" y="4650931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Straight Arrow Connector 50">
            <a:extLst>
              <a:ext uri="{FF2B5EF4-FFF2-40B4-BE49-F238E27FC236}">
                <a16:creationId xmlns:a16="http://schemas.microsoft.com/office/drawing/2014/main" id="{2E2F6752-7493-F29B-C971-5E6ED6D23391}"/>
              </a:ext>
            </a:extLst>
          </p:cNvPr>
          <p:cNvCxnSpPr>
            <a:cxnSpLocks/>
          </p:cNvCxnSpPr>
          <p:nvPr/>
        </p:nvCxnSpPr>
        <p:spPr>
          <a:xfrm>
            <a:off x="5178380" y="4563174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EC5BFDB2-1C1A-F56C-76E6-7E7773512F48}"/>
              </a:ext>
            </a:extLst>
          </p:cNvPr>
          <p:cNvCxnSpPr>
            <a:cxnSpLocks/>
          </p:cNvCxnSpPr>
          <p:nvPr/>
        </p:nvCxnSpPr>
        <p:spPr>
          <a:xfrm>
            <a:off x="5417260" y="5348786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56E94ED7-2A50-2794-5BDF-5E4A873A4C63}"/>
              </a:ext>
            </a:extLst>
          </p:cNvPr>
          <p:cNvCxnSpPr>
            <a:cxnSpLocks/>
          </p:cNvCxnSpPr>
          <p:nvPr/>
        </p:nvCxnSpPr>
        <p:spPr>
          <a:xfrm>
            <a:off x="5664766" y="5081642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Straight Arrow Connector 53">
            <a:extLst>
              <a:ext uri="{FF2B5EF4-FFF2-40B4-BE49-F238E27FC236}">
                <a16:creationId xmlns:a16="http://schemas.microsoft.com/office/drawing/2014/main" id="{F7A62C2B-EF80-CC53-760D-C935E85B05BC}"/>
              </a:ext>
            </a:extLst>
          </p:cNvPr>
          <p:cNvCxnSpPr>
            <a:cxnSpLocks/>
          </p:cNvCxnSpPr>
          <p:nvPr/>
        </p:nvCxnSpPr>
        <p:spPr>
          <a:xfrm>
            <a:off x="5893501" y="4435085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Straight Arrow Connector 54">
            <a:extLst>
              <a:ext uri="{FF2B5EF4-FFF2-40B4-BE49-F238E27FC236}">
                <a16:creationId xmlns:a16="http://schemas.microsoft.com/office/drawing/2014/main" id="{2F98A610-58E4-6B1D-A78B-3E06D20E2ABC}"/>
              </a:ext>
            </a:extLst>
          </p:cNvPr>
          <p:cNvCxnSpPr>
            <a:cxnSpLocks/>
          </p:cNvCxnSpPr>
          <p:nvPr/>
        </p:nvCxnSpPr>
        <p:spPr>
          <a:xfrm>
            <a:off x="6145849" y="4401157"/>
            <a:ext cx="104663" cy="18415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71125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87</TotalTime>
  <Words>274</Words>
  <Application>Microsoft Macintosh PowerPoint</Application>
  <PresentationFormat>Widescreen</PresentationFormat>
  <Paragraphs>52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olmberg Schiavone, Lovisa</dc:creator>
  <cp:lastModifiedBy>Evgeny Tankhilevich</cp:lastModifiedBy>
  <cp:revision>3</cp:revision>
  <dcterms:created xsi:type="dcterms:W3CDTF">2025-09-24T09:34:35Z</dcterms:created>
  <dcterms:modified xsi:type="dcterms:W3CDTF">2025-09-29T16:28:20Z</dcterms:modified>
</cp:coreProperties>
</file>